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95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4694"/>
  </p:normalViewPr>
  <p:slideViewPr>
    <p:cSldViewPr snapToGrid="0" snapToObjects="1" showGuides="1">
      <p:cViewPr varScale="1">
        <p:scale>
          <a:sx n="128" d="100"/>
          <a:sy n="128" d="100"/>
        </p:scale>
        <p:origin x="480" y="17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dania/Desktop/documenti/progetti/DENIS%20Immunization/prove%20microbiota/2019_10_09_bcg/rarefaction_curve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dania/Desktop/documenti/progetti/DENIS%20Immunization/prove%20microbiota/Denis%20DANIA%20da%20portatile%203-11-19/rarefaction_curves%20senza%2035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dania/Desktop/documenti/progetti/DENIS%20Immunization/prove%20microbiota/Denis%20DANIA%20da%20portatile%203-11-19/rarefaction_curves%20senza%2035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3.7772876587062423E-2"/>
          <c:y val="0"/>
          <c:w val="0.8909855249450731"/>
          <c:h val="0.47178159258775543"/>
        </c:manualLayout>
      </c:layout>
      <c:lineChart>
        <c:grouping val="standard"/>
        <c:varyColors val="0"/>
        <c:ser>
          <c:idx val="0"/>
          <c:order val="0"/>
          <c:tx>
            <c:strRef>
              <c:f>Observed_OTUs!$B$2</c:f>
              <c:strCache>
                <c:ptCount val="1"/>
                <c:pt idx="0">
                  <c:v>1C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numRef>
              <c:f>Observed_OTUs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Observed_OTUs!$C$2:$L$2</c:f>
              <c:numCache>
                <c:formatCode>General</c:formatCode>
                <c:ptCount val="10"/>
                <c:pt idx="0">
                  <c:v>1</c:v>
                </c:pt>
                <c:pt idx="1">
                  <c:v>482.8</c:v>
                </c:pt>
                <c:pt idx="2">
                  <c:v>550.1</c:v>
                </c:pt>
                <c:pt idx="3">
                  <c:v>584.4</c:v>
                </c:pt>
                <c:pt idx="4">
                  <c:v>596.70000000000005</c:v>
                </c:pt>
                <c:pt idx="5">
                  <c:v>605.70000000000005</c:v>
                </c:pt>
                <c:pt idx="6">
                  <c:v>610.1</c:v>
                </c:pt>
                <c:pt idx="7">
                  <c:v>615.70000000000005</c:v>
                </c:pt>
                <c:pt idx="8">
                  <c:v>617.4</c:v>
                </c:pt>
                <c:pt idx="9">
                  <c:v>617.7000000000000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20B-494C-9E08-C9F146842F75}"/>
            </c:ext>
          </c:extLst>
        </c:ser>
        <c:ser>
          <c:idx val="1"/>
          <c:order val="1"/>
          <c:tx>
            <c:strRef>
              <c:f>Observed_OTUs!$B$3</c:f>
              <c:strCache>
                <c:ptCount val="1"/>
                <c:pt idx="0">
                  <c:v>2C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numRef>
              <c:f>Observed_OTUs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Observed_OTUs!$C$3:$L$3</c:f>
              <c:numCache>
                <c:formatCode>General</c:formatCode>
                <c:ptCount val="10"/>
                <c:pt idx="0">
                  <c:v>1</c:v>
                </c:pt>
                <c:pt idx="1">
                  <c:v>520.9</c:v>
                </c:pt>
                <c:pt idx="2">
                  <c:v>610.5</c:v>
                </c:pt>
                <c:pt idx="3">
                  <c:v>655.7</c:v>
                </c:pt>
                <c:pt idx="4">
                  <c:v>680</c:v>
                </c:pt>
                <c:pt idx="5">
                  <c:v>697.1</c:v>
                </c:pt>
                <c:pt idx="6">
                  <c:v>706.2</c:v>
                </c:pt>
                <c:pt idx="7">
                  <c:v>714.5</c:v>
                </c:pt>
                <c:pt idx="8">
                  <c:v>716.9</c:v>
                </c:pt>
                <c:pt idx="9">
                  <c:v>721.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F20B-494C-9E08-C9F146842F75}"/>
            </c:ext>
          </c:extLst>
        </c:ser>
        <c:ser>
          <c:idx val="2"/>
          <c:order val="2"/>
          <c:tx>
            <c:strRef>
              <c:f>Observed_OTUs!$B$4</c:f>
              <c:strCache>
                <c:ptCount val="1"/>
                <c:pt idx="0">
                  <c:v>3C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cat>
            <c:numRef>
              <c:f>Observed_OTUs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Observed_OTUs!$C$4:$L$4</c:f>
              <c:numCache>
                <c:formatCode>General</c:formatCode>
                <c:ptCount val="10"/>
                <c:pt idx="0">
                  <c:v>1</c:v>
                </c:pt>
                <c:pt idx="1">
                  <c:v>286.7</c:v>
                </c:pt>
                <c:pt idx="2">
                  <c:v>320.3</c:v>
                </c:pt>
                <c:pt idx="3">
                  <c:v>334.2</c:v>
                </c:pt>
                <c:pt idx="4">
                  <c:v>340.4</c:v>
                </c:pt>
                <c:pt idx="5">
                  <c:v>345.2</c:v>
                </c:pt>
                <c:pt idx="6">
                  <c:v>348.7</c:v>
                </c:pt>
                <c:pt idx="7">
                  <c:v>349.5</c:v>
                </c:pt>
                <c:pt idx="8">
                  <c:v>352.7</c:v>
                </c:pt>
                <c:pt idx="9">
                  <c:v>354.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F20B-494C-9E08-C9F146842F75}"/>
            </c:ext>
          </c:extLst>
        </c:ser>
        <c:ser>
          <c:idx val="3"/>
          <c:order val="3"/>
          <c:tx>
            <c:strRef>
              <c:f>Observed_OTUs!$B$5</c:f>
              <c:strCache>
                <c:ptCount val="1"/>
                <c:pt idx="0">
                  <c:v>4C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cat>
            <c:numRef>
              <c:f>Observed_OTUs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Observed_OTUs!$C$5:$L$5</c:f>
              <c:numCache>
                <c:formatCode>General</c:formatCode>
                <c:ptCount val="10"/>
                <c:pt idx="0">
                  <c:v>1</c:v>
                </c:pt>
                <c:pt idx="1">
                  <c:v>262.2</c:v>
                </c:pt>
                <c:pt idx="2">
                  <c:v>296.3</c:v>
                </c:pt>
                <c:pt idx="3">
                  <c:v>309.10000000000002</c:v>
                </c:pt>
                <c:pt idx="4">
                  <c:v>317.2</c:v>
                </c:pt>
                <c:pt idx="5">
                  <c:v>320.60000000000002</c:v>
                </c:pt>
                <c:pt idx="6">
                  <c:v>322.89999999999998</c:v>
                </c:pt>
                <c:pt idx="7">
                  <c:v>323.8</c:v>
                </c:pt>
                <c:pt idx="8">
                  <c:v>326.3</c:v>
                </c:pt>
                <c:pt idx="9">
                  <c:v>326.39999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F20B-494C-9E08-C9F146842F75}"/>
            </c:ext>
          </c:extLst>
        </c:ser>
        <c:ser>
          <c:idx val="4"/>
          <c:order val="4"/>
          <c:tx>
            <c:strRef>
              <c:f>Observed_OTUs!$B$6</c:f>
              <c:strCache>
                <c:ptCount val="1"/>
                <c:pt idx="0">
                  <c:v>5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none"/>
          </c:marker>
          <c:cat>
            <c:numRef>
              <c:f>Observed_OTUs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Observed_OTUs!$C$6:$L$6</c:f>
              <c:numCache>
                <c:formatCode>General</c:formatCode>
                <c:ptCount val="10"/>
                <c:pt idx="0">
                  <c:v>1</c:v>
                </c:pt>
                <c:pt idx="1">
                  <c:v>307.8</c:v>
                </c:pt>
                <c:pt idx="2">
                  <c:v>346.7</c:v>
                </c:pt>
                <c:pt idx="3">
                  <c:v>357.1</c:v>
                </c:pt>
                <c:pt idx="4">
                  <c:v>362.7</c:v>
                </c:pt>
                <c:pt idx="5">
                  <c:v>363.7</c:v>
                </c:pt>
                <c:pt idx="6">
                  <c:v>364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F20B-494C-9E08-C9F146842F75}"/>
            </c:ext>
          </c:extLst>
        </c:ser>
        <c:ser>
          <c:idx val="5"/>
          <c:order val="5"/>
          <c:tx>
            <c:strRef>
              <c:f>Observed_OTUs!$B$7</c:f>
              <c:strCache>
                <c:ptCount val="1"/>
                <c:pt idx="0">
                  <c:v>6</c:v>
                </c:pt>
              </c:strCache>
            </c:strRef>
          </c:tx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none"/>
          </c:marker>
          <c:cat>
            <c:numRef>
              <c:f>Observed_OTUs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Observed_OTUs!$C$7:$L$7</c:f>
              <c:numCache>
                <c:formatCode>General</c:formatCode>
                <c:ptCount val="10"/>
                <c:pt idx="0">
                  <c:v>1</c:v>
                </c:pt>
                <c:pt idx="1">
                  <c:v>319.2</c:v>
                </c:pt>
                <c:pt idx="2">
                  <c:v>359.7</c:v>
                </c:pt>
                <c:pt idx="3">
                  <c:v>374.1</c:v>
                </c:pt>
                <c:pt idx="4">
                  <c:v>381.5</c:v>
                </c:pt>
                <c:pt idx="5">
                  <c:v>388.6</c:v>
                </c:pt>
                <c:pt idx="6">
                  <c:v>390.5</c:v>
                </c:pt>
                <c:pt idx="7">
                  <c:v>391.9</c:v>
                </c:pt>
                <c:pt idx="8">
                  <c:v>39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F20B-494C-9E08-C9F146842F75}"/>
            </c:ext>
          </c:extLst>
        </c:ser>
        <c:ser>
          <c:idx val="6"/>
          <c:order val="6"/>
          <c:tx>
            <c:strRef>
              <c:f>Observed_OTUs!$B$8</c:f>
              <c:strCache>
                <c:ptCount val="1"/>
                <c:pt idx="0">
                  <c:v>7</c:v>
                </c:pt>
              </c:strCache>
            </c:strRef>
          </c:tx>
          <c:spPr>
            <a:ln w="28575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Observed_OTUs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Observed_OTUs!$C$8:$L$8</c:f>
              <c:numCache>
                <c:formatCode>General</c:formatCode>
                <c:ptCount val="10"/>
                <c:pt idx="0">
                  <c:v>1</c:v>
                </c:pt>
                <c:pt idx="1">
                  <c:v>333.4</c:v>
                </c:pt>
                <c:pt idx="2">
                  <c:v>387.2</c:v>
                </c:pt>
                <c:pt idx="3">
                  <c:v>403.4</c:v>
                </c:pt>
                <c:pt idx="4">
                  <c:v>413.8</c:v>
                </c:pt>
                <c:pt idx="5">
                  <c:v>419.6</c:v>
                </c:pt>
                <c:pt idx="6">
                  <c:v>421</c:v>
                </c:pt>
                <c:pt idx="7">
                  <c:v>423.3</c:v>
                </c:pt>
                <c:pt idx="8">
                  <c:v>424.2</c:v>
                </c:pt>
                <c:pt idx="9">
                  <c:v>425.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F20B-494C-9E08-C9F146842F75}"/>
            </c:ext>
          </c:extLst>
        </c:ser>
        <c:ser>
          <c:idx val="7"/>
          <c:order val="7"/>
          <c:tx>
            <c:strRef>
              <c:f>Observed_OTUs!$B$9</c:f>
              <c:strCache>
                <c:ptCount val="1"/>
                <c:pt idx="0">
                  <c:v>8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Observed_OTUs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Observed_OTUs!$C$9:$L$9</c:f>
              <c:numCache>
                <c:formatCode>General</c:formatCode>
                <c:ptCount val="10"/>
                <c:pt idx="0">
                  <c:v>1</c:v>
                </c:pt>
                <c:pt idx="1">
                  <c:v>288</c:v>
                </c:pt>
                <c:pt idx="2">
                  <c:v>312.7</c:v>
                </c:pt>
                <c:pt idx="3">
                  <c:v>322.2</c:v>
                </c:pt>
                <c:pt idx="4">
                  <c:v>326.7</c:v>
                </c:pt>
                <c:pt idx="5">
                  <c:v>328.2</c:v>
                </c:pt>
                <c:pt idx="6">
                  <c:v>32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F20B-494C-9E08-C9F146842F75}"/>
            </c:ext>
          </c:extLst>
        </c:ser>
        <c:ser>
          <c:idx val="8"/>
          <c:order val="8"/>
          <c:tx>
            <c:strRef>
              <c:f>Observed_OTUs!$B$10</c:f>
              <c:strCache>
                <c:ptCount val="1"/>
                <c:pt idx="0">
                  <c:v>9</c:v>
                </c:pt>
              </c:strCache>
            </c:strRef>
          </c:tx>
          <c:spPr>
            <a:ln w="28575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Observed_OTUs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Observed_OTUs!$C$10:$L$10</c:f>
              <c:numCache>
                <c:formatCode>General</c:formatCode>
                <c:ptCount val="10"/>
                <c:pt idx="0">
                  <c:v>1</c:v>
                </c:pt>
                <c:pt idx="1">
                  <c:v>353.6</c:v>
                </c:pt>
                <c:pt idx="2">
                  <c:v>390</c:v>
                </c:pt>
                <c:pt idx="3">
                  <c:v>405.9</c:v>
                </c:pt>
                <c:pt idx="4">
                  <c:v>410.8</c:v>
                </c:pt>
                <c:pt idx="5">
                  <c:v>414.4</c:v>
                </c:pt>
                <c:pt idx="6">
                  <c:v>416.3</c:v>
                </c:pt>
                <c:pt idx="7">
                  <c:v>416.8</c:v>
                </c:pt>
                <c:pt idx="8">
                  <c:v>41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F20B-494C-9E08-C9F146842F75}"/>
            </c:ext>
          </c:extLst>
        </c:ser>
        <c:ser>
          <c:idx val="9"/>
          <c:order val="9"/>
          <c:tx>
            <c:strRef>
              <c:f>Observed_OTUs!$B$11</c:f>
              <c:strCache>
                <c:ptCount val="1"/>
                <c:pt idx="0">
                  <c:v>10</c:v>
                </c:pt>
              </c:strCache>
            </c:strRef>
          </c:tx>
          <c:spPr>
            <a:ln w="28575" cap="rnd">
              <a:solidFill>
                <a:schemeClr val="accent4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Observed_OTUs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Observed_OTUs!$C$11:$L$11</c:f>
              <c:numCache>
                <c:formatCode>General</c:formatCode>
                <c:ptCount val="10"/>
                <c:pt idx="0">
                  <c:v>1</c:v>
                </c:pt>
                <c:pt idx="1">
                  <c:v>370.4</c:v>
                </c:pt>
                <c:pt idx="2">
                  <c:v>418</c:v>
                </c:pt>
                <c:pt idx="3">
                  <c:v>433.5</c:v>
                </c:pt>
                <c:pt idx="4">
                  <c:v>446.4</c:v>
                </c:pt>
                <c:pt idx="5">
                  <c:v>450.1</c:v>
                </c:pt>
                <c:pt idx="6">
                  <c:v>451.8</c:v>
                </c:pt>
                <c:pt idx="7">
                  <c:v>453.8</c:v>
                </c:pt>
                <c:pt idx="8">
                  <c:v>455.2</c:v>
                </c:pt>
                <c:pt idx="9">
                  <c:v>455.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F20B-494C-9E08-C9F146842F75}"/>
            </c:ext>
          </c:extLst>
        </c:ser>
        <c:ser>
          <c:idx val="10"/>
          <c:order val="10"/>
          <c:tx>
            <c:strRef>
              <c:f>Observed_OTUs!$B$12</c:f>
              <c:strCache>
                <c:ptCount val="1"/>
                <c:pt idx="0">
                  <c:v>11</c:v>
                </c:pt>
              </c:strCache>
            </c:strRef>
          </c:tx>
          <c:spPr>
            <a:ln w="28575" cap="rnd">
              <a:solidFill>
                <a:schemeClr val="accent5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Observed_OTUs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Observed_OTUs!$C$12:$L$12</c:f>
              <c:numCache>
                <c:formatCode>General</c:formatCode>
                <c:ptCount val="10"/>
                <c:pt idx="0">
                  <c:v>1</c:v>
                </c:pt>
                <c:pt idx="1">
                  <c:v>296.89999999999998</c:v>
                </c:pt>
                <c:pt idx="2">
                  <c:v>325.39999999999998</c:v>
                </c:pt>
                <c:pt idx="3">
                  <c:v>335.7</c:v>
                </c:pt>
                <c:pt idx="4">
                  <c:v>342.2</c:v>
                </c:pt>
                <c:pt idx="5">
                  <c:v>345</c:v>
                </c:pt>
                <c:pt idx="6">
                  <c:v>346.8</c:v>
                </c:pt>
                <c:pt idx="7">
                  <c:v>348.6</c:v>
                </c:pt>
                <c:pt idx="8">
                  <c:v>350.5</c:v>
                </c:pt>
                <c:pt idx="9">
                  <c:v>350.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A-F20B-494C-9E08-C9F146842F75}"/>
            </c:ext>
          </c:extLst>
        </c:ser>
        <c:ser>
          <c:idx val="11"/>
          <c:order val="11"/>
          <c:tx>
            <c:strRef>
              <c:f>Observed_OTUs!$B$13</c:f>
              <c:strCache>
                <c:ptCount val="1"/>
                <c:pt idx="0">
                  <c:v>12</c:v>
                </c:pt>
              </c:strCache>
            </c:strRef>
          </c:tx>
          <c:spPr>
            <a:ln w="28575" cap="rnd">
              <a:solidFill>
                <a:schemeClr val="accent6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Observed_OTUs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Observed_OTUs!$C$13:$L$13</c:f>
              <c:numCache>
                <c:formatCode>General</c:formatCode>
                <c:ptCount val="10"/>
                <c:pt idx="0">
                  <c:v>1</c:v>
                </c:pt>
                <c:pt idx="1">
                  <c:v>403.9</c:v>
                </c:pt>
                <c:pt idx="2">
                  <c:v>461.8</c:v>
                </c:pt>
                <c:pt idx="3">
                  <c:v>477.4</c:v>
                </c:pt>
                <c:pt idx="4">
                  <c:v>484.3</c:v>
                </c:pt>
                <c:pt idx="5">
                  <c:v>487</c:v>
                </c:pt>
                <c:pt idx="6">
                  <c:v>488.5</c:v>
                </c:pt>
                <c:pt idx="7">
                  <c:v>48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B-F20B-494C-9E08-C9F146842F75}"/>
            </c:ext>
          </c:extLst>
        </c:ser>
        <c:ser>
          <c:idx val="12"/>
          <c:order val="12"/>
          <c:tx>
            <c:strRef>
              <c:f>Observed_OTUs!$B$14</c:f>
              <c:strCache>
                <c:ptCount val="1"/>
                <c:pt idx="0">
                  <c:v>13</c:v>
                </c:pt>
              </c:strCache>
            </c:strRef>
          </c:tx>
          <c:spPr>
            <a:ln w="28575" cap="rnd">
              <a:solidFill>
                <a:schemeClr val="accent1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Observed_OTUs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Observed_OTUs!$C$14:$L$14</c:f>
              <c:numCache>
                <c:formatCode>General</c:formatCode>
                <c:ptCount val="10"/>
                <c:pt idx="0">
                  <c:v>1</c:v>
                </c:pt>
                <c:pt idx="1">
                  <c:v>378.7</c:v>
                </c:pt>
                <c:pt idx="2">
                  <c:v>425.9</c:v>
                </c:pt>
                <c:pt idx="3">
                  <c:v>444.8</c:v>
                </c:pt>
                <c:pt idx="4">
                  <c:v>451.9</c:v>
                </c:pt>
                <c:pt idx="5">
                  <c:v>457.6</c:v>
                </c:pt>
                <c:pt idx="6">
                  <c:v>459.4</c:v>
                </c:pt>
                <c:pt idx="7">
                  <c:v>460.9</c:v>
                </c:pt>
                <c:pt idx="8">
                  <c:v>46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C-F20B-494C-9E08-C9F146842F75}"/>
            </c:ext>
          </c:extLst>
        </c:ser>
        <c:ser>
          <c:idx val="13"/>
          <c:order val="13"/>
          <c:tx>
            <c:strRef>
              <c:f>Observed_OTUs!$B$15</c:f>
              <c:strCache>
                <c:ptCount val="1"/>
                <c:pt idx="0">
                  <c:v>14</c:v>
                </c:pt>
              </c:strCache>
            </c:strRef>
          </c:tx>
          <c:spPr>
            <a:ln w="28575" cap="rnd">
              <a:solidFill>
                <a:schemeClr val="accent2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Observed_OTUs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Observed_OTUs!$C$15:$L$15</c:f>
              <c:numCache>
                <c:formatCode>General</c:formatCode>
                <c:ptCount val="10"/>
                <c:pt idx="0">
                  <c:v>1</c:v>
                </c:pt>
                <c:pt idx="1">
                  <c:v>334.1</c:v>
                </c:pt>
                <c:pt idx="2">
                  <c:v>382.1</c:v>
                </c:pt>
                <c:pt idx="3">
                  <c:v>399.5</c:v>
                </c:pt>
                <c:pt idx="4">
                  <c:v>406.3</c:v>
                </c:pt>
                <c:pt idx="5">
                  <c:v>409.6</c:v>
                </c:pt>
                <c:pt idx="6">
                  <c:v>411.6</c:v>
                </c:pt>
                <c:pt idx="7">
                  <c:v>412.2</c:v>
                </c:pt>
                <c:pt idx="8">
                  <c:v>41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D-F20B-494C-9E08-C9F146842F75}"/>
            </c:ext>
          </c:extLst>
        </c:ser>
        <c:ser>
          <c:idx val="14"/>
          <c:order val="14"/>
          <c:tx>
            <c:strRef>
              <c:f>Observed_OTUs!$B$16</c:f>
              <c:strCache>
                <c:ptCount val="1"/>
                <c:pt idx="0">
                  <c:v>15</c:v>
                </c:pt>
              </c:strCache>
            </c:strRef>
          </c:tx>
          <c:spPr>
            <a:ln w="28575" cap="rnd">
              <a:solidFill>
                <a:schemeClr val="accent3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Observed_OTUs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Observed_OTUs!$C$16:$L$16</c:f>
              <c:numCache>
                <c:formatCode>General</c:formatCode>
                <c:ptCount val="10"/>
                <c:pt idx="0">
                  <c:v>1</c:v>
                </c:pt>
                <c:pt idx="1">
                  <c:v>376.9</c:v>
                </c:pt>
                <c:pt idx="2">
                  <c:v>424.4</c:v>
                </c:pt>
                <c:pt idx="3">
                  <c:v>443.3</c:v>
                </c:pt>
                <c:pt idx="4">
                  <c:v>454.9</c:v>
                </c:pt>
                <c:pt idx="5">
                  <c:v>458.4</c:v>
                </c:pt>
                <c:pt idx="6">
                  <c:v>461.5</c:v>
                </c:pt>
                <c:pt idx="7">
                  <c:v>463.7</c:v>
                </c:pt>
                <c:pt idx="8">
                  <c:v>464.3</c:v>
                </c:pt>
                <c:pt idx="9">
                  <c:v>464.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E-F20B-494C-9E08-C9F146842F75}"/>
            </c:ext>
          </c:extLst>
        </c:ser>
        <c:ser>
          <c:idx val="15"/>
          <c:order val="15"/>
          <c:tx>
            <c:strRef>
              <c:f>Observed_OTUs!$B$17</c:f>
              <c:strCache>
                <c:ptCount val="1"/>
                <c:pt idx="0">
                  <c:v>16</c:v>
                </c:pt>
              </c:strCache>
            </c:strRef>
          </c:tx>
          <c:spPr>
            <a:ln w="28575" cap="rnd">
              <a:solidFill>
                <a:schemeClr val="accent4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Observed_OTUs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Observed_OTUs!$C$17:$L$17</c:f>
              <c:numCache>
                <c:formatCode>General</c:formatCode>
                <c:ptCount val="10"/>
                <c:pt idx="0">
                  <c:v>1</c:v>
                </c:pt>
                <c:pt idx="1">
                  <c:v>282.5</c:v>
                </c:pt>
                <c:pt idx="2">
                  <c:v>314.5</c:v>
                </c:pt>
                <c:pt idx="3">
                  <c:v>327.9</c:v>
                </c:pt>
                <c:pt idx="4">
                  <c:v>335</c:v>
                </c:pt>
                <c:pt idx="5">
                  <c:v>341.3</c:v>
                </c:pt>
                <c:pt idx="6">
                  <c:v>343.7</c:v>
                </c:pt>
                <c:pt idx="7">
                  <c:v>344.6</c:v>
                </c:pt>
                <c:pt idx="8">
                  <c:v>346.4</c:v>
                </c:pt>
                <c:pt idx="9">
                  <c:v>34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F-F20B-494C-9E08-C9F146842F75}"/>
            </c:ext>
          </c:extLst>
        </c:ser>
        <c:ser>
          <c:idx val="16"/>
          <c:order val="16"/>
          <c:tx>
            <c:strRef>
              <c:f>Observed_OTUs!$B$18</c:f>
              <c:strCache>
                <c:ptCount val="1"/>
                <c:pt idx="0">
                  <c:v>17</c:v>
                </c:pt>
              </c:strCache>
            </c:strRef>
          </c:tx>
          <c:spPr>
            <a:ln w="28575" cap="rnd">
              <a:solidFill>
                <a:schemeClr val="accent5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Observed_OTUs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Observed_OTUs!$C$18:$L$18</c:f>
              <c:numCache>
                <c:formatCode>General</c:formatCode>
                <c:ptCount val="10"/>
                <c:pt idx="0">
                  <c:v>1</c:v>
                </c:pt>
                <c:pt idx="1">
                  <c:v>306.5</c:v>
                </c:pt>
                <c:pt idx="2">
                  <c:v>342.7</c:v>
                </c:pt>
                <c:pt idx="3">
                  <c:v>353</c:v>
                </c:pt>
                <c:pt idx="4">
                  <c:v>358.9</c:v>
                </c:pt>
                <c:pt idx="5">
                  <c:v>360.7</c:v>
                </c:pt>
                <c:pt idx="6">
                  <c:v>362.4</c:v>
                </c:pt>
                <c:pt idx="7">
                  <c:v>363.2</c:v>
                </c:pt>
                <c:pt idx="8">
                  <c:v>364.1</c:v>
                </c:pt>
                <c:pt idx="9">
                  <c:v>364.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0-F20B-494C-9E08-C9F146842F75}"/>
            </c:ext>
          </c:extLst>
        </c:ser>
        <c:ser>
          <c:idx val="17"/>
          <c:order val="17"/>
          <c:tx>
            <c:strRef>
              <c:f>Observed_OTUs!$B$19</c:f>
              <c:strCache>
                <c:ptCount val="1"/>
                <c:pt idx="0">
                  <c:v>18</c:v>
                </c:pt>
              </c:strCache>
            </c:strRef>
          </c:tx>
          <c:spPr>
            <a:ln w="28575" cap="rnd">
              <a:solidFill>
                <a:schemeClr val="accent6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Observed_OTUs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Observed_OTUs!$C$19:$L$19</c:f>
              <c:numCache>
                <c:formatCode>General</c:formatCode>
                <c:ptCount val="10"/>
                <c:pt idx="0">
                  <c:v>1</c:v>
                </c:pt>
                <c:pt idx="1">
                  <c:v>357.2</c:v>
                </c:pt>
                <c:pt idx="2">
                  <c:v>405.5</c:v>
                </c:pt>
                <c:pt idx="3">
                  <c:v>422.6</c:v>
                </c:pt>
                <c:pt idx="4">
                  <c:v>432</c:v>
                </c:pt>
                <c:pt idx="5">
                  <c:v>434.3</c:v>
                </c:pt>
                <c:pt idx="6">
                  <c:v>438.9</c:v>
                </c:pt>
                <c:pt idx="7">
                  <c:v>440.8</c:v>
                </c:pt>
                <c:pt idx="8">
                  <c:v>441.4</c:v>
                </c:pt>
                <c:pt idx="9">
                  <c:v>441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1-F20B-494C-9E08-C9F146842F75}"/>
            </c:ext>
          </c:extLst>
        </c:ser>
        <c:ser>
          <c:idx val="18"/>
          <c:order val="18"/>
          <c:tx>
            <c:strRef>
              <c:f>Observed_OTUs!$B$20</c:f>
              <c:strCache>
                <c:ptCount val="1"/>
                <c:pt idx="0">
                  <c:v>19</c:v>
                </c:pt>
              </c:strCache>
            </c:strRef>
          </c:tx>
          <c:spPr>
            <a:ln w="28575" cap="rnd">
              <a:solidFill>
                <a:schemeClr val="accent1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Observed_OTUs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Observed_OTUs!$C$20:$L$20</c:f>
              <c:numCache>
                <c:formatCode>General</c:formatCode>
                <c:ptCount val="10"/>
                <c:pt idx="0">
                  <c:v>1</c:v>
                </c:pt>
                <c:pt idx="1">
                  <c:v>369</c:v>
                </c:pt>
                <c:pt idx="2">
                  <c:v>419.6</c:v>
                </c:pt>
                <c:pt idx="3">
                  <c:v>438.5</c:v>
                </c:pt>
                <c:pt idx="4">
                  <c:v>448.8</c:v>
                </c:pt>
                <c:pt idx="5">
                  <c:v>452.8</c:v>
                </c:pt>
                <c:pt idx="6">
                  <c:v>456</c:v>
                </c:pt>
                <c:pt idx="7">
                  <c:v>457</c:v>
                </c:pt>
                <c:pt idx="8">
                  <c:v>457.9</c:v>
                </c:pt>
                <c:pt idx="9">
                  <c:v>45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2-F20B-494C-9E08-C9F146842F75}"/>
            </c:ext>
          </c:extLst>
        </c:ser>
        <c:ser>
          <c:idx val="19"/>
          <c:order val="19"/>
          <c:tx>
            <c:strRef>
              <c:f>Observed_OTUs!$B$21</c:f>
              <c:strCache>
                <c:ptCount val="1"/>
                <c:pt idx="0">
                  <c:v>20</c:v>
                </c:pt>
              </c:strCache>
            </c:strRef>
          </c:tx>
          <c:spPr>
            <a:ln w="28575" cap="rnd">
              <a:solidFill>
                <a:schemeClr val="accent2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Observed_OTUs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Observed_OTUs!$C$21:$L$21</c:f>
              <c:numCache>
                <c:formatCode>General</c:formatCode>
                <c:ptCount val="10"/>
                <c:pt idx="0">
                  <c:v>1</c:v>
                </c:pt>
                <c:pt idx="1">
                  <c:v>325.3</c:v>
                </c:pt>
                <c:pt idx="2">
                  <c:v>363.2</c:v>
                </c:pt>
                <c:pt idx="3">
                  <c:v>375.3</c:v>
                </c:pt>
                <c:pt idx="4">
                  <c:v>383.1</c:v>
                </c:pt>
                <c:pt idx="5">
                  <c:v>386.2</c:v>
                </c:pt>
                <c:pt idx="6">
                  <c:v>389</c:v>
                </c:pt>
                <c:pt idx="7">
                  <c:v>391.4</c:v>
                </c:pt>
                <c:pt idx="8">
                  <c:v>393.3</c:v>
                </c:pt>
                <c:pt idx="9">
                  <c:v>394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3-F20B-494C-9E08-C9F146842F75}"/>
            </c:ext>
          </c:extLst>
        </c:ser>
        <c:ser>
          <c:idx val="20"/>
          <c:order val="20"/>
          <c:tx>
            <c:strRef>
              <c:f>Observed_OTUs!$B$22</c:f>
              <c:strCache>
                <c:ptCount val="1"/>
                <c:pt idx="0">
                  <c:v>21</c:v>
                </c:pt>
              </c:strCache>
            </c:strRef>
          </c:tx>
          <c:spPr>
            <a:ln w="28575" cap="rnd">
              <a:solidFill>
                <a:schemeClr val="accent3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Observed_OTUs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Observed_OTUs!$C$22:$L$22</c:f>
              <c:numCache>
                <c:formatCode>General</c:formatCode>
                <c:ptCount val="10"/>
                <c:pt idx="0">
                  <c:v>1</c:v>
                </c:pt>
                <c:pt idx="1">
                  <c:v>372.4</c:v>
                </c:pt>
                <c:pt idx="2">
                  <c:v>421.9</c:v>
                </c:pt>
                <c:pt idx="3">
                  <c:v>440.6</c:v>
                </c:pt>
                <c:pt idx="4">
                  <c:v>447</c:v>
                </c:pt>
                <c:pt idx="5">
                  <c:v>453.2</c:v>
                </c:pt>
                <c:pt idx="6">
                  <c:v>455.1</c:v>
                </c:pt>
                <c:pt idx="7">
                  <c:v>456.2</c:v>
                </c:pt>
                <c:pt idx="8">
                  <c:v>457.4</c:v>
                </c:pt>
                <c:pt idx="9">
                  <c:v>458.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4-F20B-494C-9E08-C9F146842F75}"/>
            </c:ext>
          </c:extLst>
        </c:ser>
        <c:ser>
          <c:idx val="21"/>
          <c:order val="21"/>
          <c:tx>
            <c:strRef>
              <c:f>Observed_OTUs!$B$23</c:f>
              <c:strCache>
                <c:ptCount val="1"/>
                <c:pt idx="0">
                  <c:v>22</c:v>
                </c:pt>
              </c:strCache>
            </c:strRef>
          </c:tx>
          <c:spPr>
            <a:ln w="28575" cap="rnd">
              <a:solidFill>
                <a:schemeClr val="accent4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Observed_OTUs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Observed_OTUs!$C$23:$L$23</c:f>
              <c:numCache>
                <c:formatCode>General</c:formatCode>
                <c:ptCount val="10"/>
                <c:pt idx="0">
                  <c:v>1</c:v>
                </c:pt>
                <c:pt idx="1">
                  <c:v>310.10000000000002</c:v>
                </c:pt>
                <c:pt idx="2">
                  <c:v>347.3</c:v>
                </c:pt>
                <c:pt idx="3">
                  <c:v>362.6</c:v>
                </c:pt>
                <c:pt idx="4">
                  <c:v>371.2</c:v>
                </c:pt>
                <c:pt idx="5">
                  <c:v>373.6</c:v>
                </c:pt>
                <c:pt idx="6">
                  <c:v>376.8</c:v>
                </c:pt>
                <c:pt idx="7">
                  <c:v>378.3</c:v>
                </c:pt>
                <c:pt idx="8">
                  <c:v>379</c:v>
                </c:pt>
                <c:pt idx="9">
                  <c:v>37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5-F20B-494C-9E08-C9F146842F75}"/>
            </c:ext>
          </c:extLst>
        </c:ser>
        <c:ser>
          <c:idx val="22"/>
          <c:order val="22"/>
          <c:tx>
            <c:strRef>
              <c:f>Observed_OTUs!$B$24</c:f>
              <c:strCache>
                <c:ptCount val="1"/>
                <c:pt idx="0">
                  <c:v>23</c:v>
                </c:pt>
              </c:strCache>
            </c:strRef>
          </c:tx>
          <c:spPr>
            <a:ln w="28575" cap="rnd">
              <a:solidFill>
                <a:schemeClr val="accent5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Observed_OTUs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Observed_OTUs!$C$24:$L$24</c:f>
              <c:numCache>
                <c:formatCode>General</c:formatCode>
                <c:ptCount val="10"/>
                <c:pt idx="0">
                  <c:v>1</c:v>
                </c:pt>
                <c:pt idx="1">
                  <c:v>328.3</c:v>
                </c:pt>
                <c:pt idx="2">
                  <c:v>356.7</c:v>
                </c:pt>
                <c:pt idx="3">
                  <c:v>366.2</c:v>
                </c:pt>
                <c:pt idx="4">
                  <c:v>371.5</c:v>
                </c:pt>
                <c:pt idx="5">
                  <c:v>374.6</c:v>
                </c:pt>
                <c:pt idx="6">
                  <c:v>376.4</c:v>
                </c:pt>
                <c:pt idx="7">
                  <c:v>378.2</c:v>
                </c:pt>
                <c:pt idx="8">
                  <c:v>378.7</c:v>
                </c:pt>
                <c:pt idx="9">
                  <c:v>378.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6-F20B-494C-9E08-C9F146842F75}"/>
            </c:ext>
          </c:extLst>
        </c:ser>
        <c:ser>
          <c:idx val="23"/>
          <c:order val="23"/>
          <c:tx>
            <c:strRef>
              <c:f>Observed_OTUs!$B$25</c:f>
              <c:strCache>
                <c:ptCount val="1"/>
                <c:pt idx="0">
                  <c:v>24</c:v>
                </c:pt>
              </c:strCache>
            </c:strRef>
          </c:tx>
          <c:spPr>
            <a:ln w="28575" cap="rnd">
              <a:solidFill>
                <a:schemeClr val="accent6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Observed_OTUs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Observed_OTUs!$C$25:$L$25</c:f>
              <c:numCache>
                <c:formatCode>General</c:formatCode>
                <c:ptCount val="10"/>
                <c:pt idx="0">
                  <c:v>1</c:v>
                </c:pt>
                <c:pt idx="1">
                  <c:v>390.5</c:v>
                </c:pt>
                <c:pt idx="2">
                  <c:v>435.8</c:v>
                </c:pt>
                <c:pt idx="3">
                  <c:v>453.8</c:v>
                </c:pt>
                <c:pt idx="4">
                  <c:v>461.3</c:v>
                </c:pt>
                <c:pt idx="5">
                  <c:v>464.4</c:v>
                </c:pt>
                <c:pt idx="6">
                  <c:v>466.7</c:v>
                </c:pt>
                <c:pt idx="7">
                  <c:v>467.1</c:v>
                </c:pt>
                <c:pt idx="8">
                  <c:v>467.7</c:v>
                </c:pt>
                <c:pt idx="9">
                  <c:v>46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7-F20B-494C-9E08-C9F146842F75}"/>
            </c:ext>
          </c:extLst>
        </c:ser>
        <c:ser>
          <c:idx val="24"/>
          <c:order val="24"/>
          <c:tx>
            <c:strRef>
              <c:f>Observed_OTUs!$B$26</c:f>
              <c:strCache>
                <c:ptCount val="1"/>
                <c:pt idx="0">
                  <c:v>25</c:v>
                </c:pt>
              </c:strCache>
            </c:strRef>
          </c:tx>
          <c:spPr>
            <a:ln w="28575" cap="rnd">
              <a:solidFill>
                <a:schemeClr val="accent1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Observed_OTUs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Observed_OTUs!$C$26:$L$26</c:f>
              <c:numCache>
                <c:formatCode>General</c:formatCode>
                <c:ptCount val="10"/>
                <c:pt idx="0">
                  <c:v>1</c:v>
                </c:pt>
                <c:pt idx="1">
                  <c:v>376.7</c:v>
                </c:pt>
                <c:pt idx="2">
                  <c:v>416.1</c:v>
                </c:pt>
                <c:pt idx="3">
                  <c:v>432.1</c:v>
                </c:pt>
                <c:pt idx="4">
                  <c:v>439.3</c:v>
                </c:pt>
                <c:pt idx="5">
                  <c:v>441.4</c:v>
                </c:pt>
                <c:pt idx="6">
                  <c:v>444.3</c:v>
                </c:pt>
                <c:pt idx="7">
                  <c:v>446.1</c:v>
                </c:pt>
                <c:pt idx="8">
                  <c:v>446.6</c:v>
                </c:pt>
                <c:pt idx="9">
                  <c:v>446.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8-F20B-494C-9E08-C9F146842F75}"/>
            </c:ext>
          </c:extLst>
        </c:ser>
        <c:ser>
          <c:idx val="25"/>
          <c:order val="25"/>
          <c:tx>
            <c:strRef>
              <c:f>Observed_OTUs!$B$27</c:f>
              <c:strCache>
                <c:ptCount val="1"/>
                <c:pt idx="0">
                  <c:v>26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Observed_OTUs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Observed_OTUs!$C$27:$L$27</c:f>
              <c:numCache>
                <c:formatCode>General</c:formatCode>
                <c:ptCount val="10"/>
                <c:pt idx="0">
                  <c:v>1</c:v>
                </c:pt>
                <c:pt idx="1">
                  <c:v>390.3</c:v>
                </c:pt>
                <c:pt idx="2">
                  <c:v>439.2</c:v>
                </c:pt>
                <c:pt idx="3">
                  <c:v>456.7</c:v>
                </c:pt>
                <c:pt idx="4">
                  <c:v>466.7</c:v>
                </c:pt>
                <c:pt idx="5">
                  <c:v>472.1</c:v>
                </c:pt>
                <c:pt idx="6">
                  <c:v>473</c:v>
                </c:pt>
                <c:pt idx="7">
                  <c:v>474.3</c:v>
                </c:pt>
                <c:pt idx="8">
                  <c:v>475.7</c:v>
                </c:pt>
                <c:pt idx="9">
                  <c:v>47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9-F20B-494C-9E08-C9F146842F75}"/>
            </c:ext>
          </c:extLst>
        </c:ser>
        <c:ser>
          <c:idx val="26"/>
          <c:order val="26"/>
          <c:tx>
            <c:strRef>
              <c:f>Observed_OTUs!$B$28</c:f>
              <c:strCache>
                <c:ptCount val="1"/>
                <c:pt idx="0">
                  <c:v>27</c:v>
                </c:pt>
              </c:strCache>
            </c:strRef>
          </c:tx>
          <c:spPr>
            <a:ln w="28575" cap="rnd">
              <a:solidFill>
                <a:schemeClr val="accent3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Observed_OTUs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Observed_OTUs!$C$28:$L$28</c:f>
              <c:numCache>
                <c:formatCode>General</c:formatCode>
                <c:ptCount val="10"/>
                <c:pt idx="0">
                  <c:v>1</c:v>
                </c:pt>
                <c:pt idx="1">
                  <c:v>330.6</c:v>
                </c:pt>
                <c:pt idx="2">
                  <c:v>377.2</c:v>
                </c:pt>
                <c:pt idx="3">
                  <c:v>395.2</c:v>
                </c:pt>
                <c:pt idx="4">
                  <c:v>401.5</c:v>
                </c:pt>
                <c:pt idx="5">
                  <c:v>408.8</c:v>
                </c:pt>
                <c:pt idx="6">
                  <c:v>412.7</c:v>
                </c:pt>
                <c:pt idx="7">
                  <c:v>413.4</c:v>
                </c:pt>
                <c:pt idx="8">
                  <c:v>414.4</c:v>
                </c:pt>
                <c:pt idx="9">
                  <c:v>415.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A-F20B-494C-9E08-C9F146842F75}"/>
            </c:ext>
          </c:extLst>
        </c:ser>
        <c:ser>
          <c:idx val="27"/>
          <c:order val="27"/>
          <c:tx>
            <c:strRef>
              <c:f>Observed_OTUs!$B$29</c:f>
              <c:strCache>
                <c:ptCount val="1"/>
                <c:pt idx="0">
                  <c:v>28</c:v>
                </c:pt>
              </c:strCache>
            </c:strRef>
          </c:tx>
          <c:spPr>
            <a:ln w="28575" cap="rnd">
              <a:solidFill>
                <a:schemeClr val="accent4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Observed_OTUs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Observed_OTUs!$C$29:$L$29</c:f>
              <c:numCache>
                <c:formatCode>General</c:formatCode>
                <c:ptCount val="10"/>
                <c:pt idx="0">
                  <c:v>1</c:v>
                </c:pt>
                <c:pt idx="1">
                  <c:v>348</c:v>
                </c:pt>
                <c:pt idx="2">
                  <c:v>384.4</c:v>
                </c:pt>
                <c:pt idx="3">
                  <c:v>396</c:v>
                </c:pt>
                <c:pt idx="4">
                  <c:v>405.7</c:v>
                </c:pt>
                <c:pt idx="5">
                  <c:v>408.9</c:v>
                </c:pt>
                <c:pt idx="6">
                  <c:v>412</c:v>
                </c:pt>
                <c:pt idx="7">
                  <c:v>413.3</c:v>
                </c:pt>
                <c:pt idx="8">
                  <c:v>414.5</c:v>
                </c:pt>
                <c:pt idx="9">
                  <c:v>41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B-F20B-494C-9E08-C9F146842F75}"/>
            </c:ext>
          </c:extLst>
        </c:ser>
        <c:ser>
          <c:idx val="28"/>
          <c:order val="28"/>
          <c:tx>
            <c:strRef>
              <c:f>Observed_OTUs!$B$30</c:f>
              <c:strCache>
                <c:ptCount val="1"/>
                <c:pt idx="0">
                  <c:v>29</c:v>
                </c:pt>
              </c:strCache>
            </c:strRef>
          </c:tx>
          <c:spPr>
            <a:ln w="28575" cap="rnd">
              <a:solidFill>
                <a:schemeClr val="accent5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Observed_OTUs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Observed_OTUs!$C$30:$L$30</c:f>
              <c:numCache>
                <c:formatCode>General</c:formatCode>
                <c:ptCount val="10"/>
                <c:pt idx="0">
                  <c:v>1</c:v>
                </c:pt>
                <c:pt idx="1">
                  <c:v>391.8</c:v>
                </c:pt>
                <c:pt idx="2">
                  <c:v>446.5</c:v>
                </c:pt>
                <c:pt idx="3">
                  <c:v>470.3</c:v>
                </c:pt>
                <c:pt idx="4">
                  <c:v>482.7</c:v>
                </c:pt>
                <c:pt idx="5">
                  <c:v>483.8</c:v>
                </c:pt>
                <c:pt idx="6">
                  <c:v>488.8</c:v>
                </c:pt>
                <c:pt idx="7">
                  <c:v>490.8</c:v>
                </c:pt>
                <c:pt idx="8">
                  <c:v>492.2</c:v>
                </c:pt>
                <c:pt idx="9">
                  <c:v>492.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C-F20B-494C-9E08-C9F146842F75}"/>
            </c:ext>
          </c:extLst>
        </c:ser>
        <c:ser>
          <c:idx val="29"/>
          <c:order val="29"/>
          <c:tx>
            <c:strRef>
              <c:f>Observed_OTUs!$B$31</c:f>
              <c:strCache>
                <c:ptCount val="1"/>
                <c:pt idx="0">
                  <c:v>30</c:v>
                </c:pt>
              </c:strCache>
            </c:strRef>
          </c:tx>
          <c:spPr>
            <a:ln w="28575" cap="rnd">
              <a:solidFill>
                <a:schemeClr val="accent6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Observed_OTUs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Observed_OTUs!$C$31:$L$31</c:f>
              <c:numCache>
                <c:formatCode>General</c:formatCode>
                <c:ptCount val="10"/>
                <c:pt idx="0">
                  <c:v>1</c:v>
                </c:pt>
                <c:pt idx="1">
                  <c:v>312.89999999999998</c:v>
                </c:pt>
                <c:pt idx="2">
                  <c:v>345.1</c:v>
                </c:pt>
                <c:pt idx="3">
                  <c:v>352.3</c:v>
                </c:pt>
                <c:pt idx="4">
                  <c:v>355.8</c:v>
                </c:pt>
                <c:pt idx="5">
                  <c:v>356.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D-F20B-494C-9E08-C9F146842F75}"/>
            </c:ext>
          </c:extLst>
        </c:ser>
        <c:ser>
          <c:idx val="30"/>
          <c:order val="30"/>
          <c:tx>
            <c:strRef>
              <c:f>Observed_OTUs!$B$32</c:f>
              <c:strCache>
                <c:ptCount val="1"/>
                <c:pt idx="0">
                  <c:v>31</c:v>
                </c:pt>
              </c:strCache>
            </c:strRef>
          </c:tx>
          <c:spPr>
            <a:ln w="28575" cap="rnd">
              <a:solidFill>
                <a:schemeClr val="accent1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Observed_OTUs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Observed_OTUs!$C$32:$L$32</c:f>
              <c:numCache>
                <c:formatCode>General</c:formatCode>
                <c:ptCount val="10"/>
                <c:pt idx="0">
                  <c:v>1</c:v>
                </c:pt>
                <c:pt idx="1">
                  <c:v>333.3</c:v>
                </c:pt>
                <c:pt idx="2">
                  <c:v>371.7</c:v>
                </c:pt>
                <c:pt idx="3">
                  <c:v>387.8</c:v>
                </c:pt>
                <c:pt idx="4">
                  <c:v>394.5</c:v>
                </c:pt>
                <c:pt idx="5">
                  <c:v>398</c:v>
                </c:pt>
                <c:pt idx="6">
                  <c:v>400.9</c:v>
                </c:pt>
                <c:pt idx="7">
                  <c:v>402.8</c:v>
                </c:pt>
                <c:pt idx="8">
                  <c:v>4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E-F20B-494C-9E08-C9F146842F75}"/>
            </c:ext>
          </c:extLst>
        </c:ser>
        <c:ser>
          <c:idx val="31"/>
          <c:order val="31"/>
          <c:tx>
            <c:strRef>
              <c:f>Observed_OTUs!$B$33</c:f>
              <c:strCache>
                <c:ptCount val="1"/>
                <c:pt idx="0">
                  <c:v>32</c:v>
                </c:pt>
              </c:strCache>
            </c:strRef>
          </c:tx>
          <c:spPr>
            <a:ln w="28575" cap="rnd">
              <a:solidFill>
                <a:schemeClr val="accent2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Observed_OTUs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Observed_OTUs!$C$33:$L$33</c:f>
              <c:numCache>
                <c:formatCode>General</c:formatCode>
                <c:ptCount val="10"/>
                <c:pt idx="0">
                  <c:v>1</c:v>
                </c:pt>
                <c:pt idx="1">
                  <c:v>330.6</c:v>
                </c:pt>
                <c:pt idx="2">
                  <c:v>364.5</c:v>
                </c:pt>
                <c:pt idx="3">
                  <c:v>375.6</c:v>
                </c:pt>
                <c:pt idx="4">
                  <c:v>383</c:v>
                </c:pt>
                <c:pt idx="5">
                  <c:v>386</c:v>
                </c:pt>
                <c:pt idx="6">
                  <c:v>389.3</c:v>
                </c:pt>
                <c:pt idx="7">
                  <c:v>389.8</c:v>
                </c:pt>
                <c:pt idx="8">
                  <c:v>39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F-F20B-494C-9E08-C9F146842F75}"/>
            </c:ext>
          </c:extLst>
        </c:ser>
        <c:ser>
          <c:idx val="32"/>
          <c:order val="32"/>
          <c:tx>
            <c:strRef>
              <c:f>Observed_OTUs!$B$34</c:f>
              <c:strCache>
                <c:ptCount val="1"/>
                <c:pt idx="0">
                  <c:v>33</c:v>
                </c:pt>
              </c:strCache>
            </c:strRef>
          </c:tx>
          <c:spPr>
            <a:ln w="28575" cap="rnd">
              <a:solidFill>
                <a:schemeClr val="accent3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Observed_OTUs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Observed_OTUs!$C$34:$L$34</c:f>
              <c:numCache>
                <c:formatCode>General</c:formatCode>
                <c:ptCount val="10"/>
                <c:pt idx="0">
                  <c:v>1</c:v>
                </c:pt>
                <c:pt idx="1">
                  <c:v>333.8</c:v>
                </c:pt>
                <c:pt idx="2">
                  <c:v>362.6</c:v>
                </c:pt>
                <c:pt idx="3">
                  <c:v>373.3</c:v>
                </c:pt>
                <c:pt idx="4">
                  <c:v>378.3</c:v>
                </c:pt>
                <c:pt idx="5">
                  <c:v>380.4</c:v>
                </c:pt>
                <c:pt idx="6">
                  <c:v>381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0-F20B-494C-9E08-C9F146842F75}"/>
            </c:ext>
          </c:extLst>
        </c:ser>
        <c:ser>
          <c:idx val="33"/>
          <c:order val="33"/>
          <c:tx>
            <c:strRef>
              <c:f>Observed_OTUs!$B$35</c:f>
              <c:strCache>
                <c:ptCount val="1"/>
                <c:pt idx="0">
                  <c:v>34</c:v>
                </c:pt>
              </c:strCache>
            </c:strRef>
          </c:tx>
          <c:spPr>
            <a:ln w="28575" cap="rnd">
              <a:solidFill>
                <a:schemeClr val="accent4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Observed_OTUs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Observed_OTUs!$C$35:$L$35</c:f>
              <c:numCache>
                <c:formatCode>General</c:formatCode>
                <c:ptCount val="10"/>
                <c:pt idx="0">
                  <c:v>1</c:v>
                </c:pt>
                <c:pt idx="1">
                  <c:v>372.3</c:v>
                </c:pt>
                <c:pt idx="2">
                  <c:v>415</c:v>
                </c:pt>
                <c:pt idx="3">
                  <c:v>432.5</c:v>
                </c:pt>
                <c:pt idx="4">
                  <c:v>440.8</c:v>
                </c:pt>
                <c:pt idx="5">
                  <c:v>444.5</c:v>
                </c:pt>
                <c:pt idx="6">
                  <c:v>447.4</c:v>
                </c:pt>
                <c:pt idx="7">
                  <c:v>447.6</c:v>
                </c:pt>
                <c:pt idx="8">
                  <c:v>448.9</c:v>
                </c:pt>
                <c:pt idx="9">
                  <c:v>44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1-F20B-494C-9E08-C9F146842F7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739273392"/>
        <c:axId val="1555056208"/>
      </c:lineChart>
      <c:catAx>
        <c:axId val="17392733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it-IT"/>
          </a:p>
        </c:txPr>
        <c:crossAx val="1555056208"/>
        <c:crosses val="autoZero"/>
        <c:auto val="1"/>
        <c:lblAlgn val="ctr"/>
        <c:lblOffset val="100"/>
        <c:noMultiLvlLbl val="0"/>
      </c:catAx>
      <c:valAx>
        <c:axId val="1555056208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extTo"/>
        <c:crossAx val="173927339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5.3196426392578711E-2"/>
          <c:y val="0.68369864433581151"/>
          <c:w val="0.85344475385576712"/>
          <c:h val="0.1560056357447957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it-IT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it-IT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4.3851342060001366E-2"/>
          <c:y val="2.6157675854391611E-2"/>
          <c:w val="0.93788592856986641"/>
          <c:h val="0.54879977365559052"/>
        </c:manualLayout>
      </c:layout>
      <c:lineChart>
        <c:grouping val="standard"/>
        <c:varyColors val="0"/>
        <c:ser>
          <c:idx val="0"/>
          <c:order val="0"/>
          <c:tx>
            <c:strRef>
              <c:f>Shannon!$B$2</c:f>
              <c:strCache>
                <c:ptCount val="1"/>
                <c:pt idx="0">
                  <c:v>1C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numRef>
              <c:f>Shannon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Shannon!$C$2:$L$2</c:f>
              <c:numCache>
                <c:formatCode>General</c:formatCode>
                <c:ptCount val="10"/>
                <c:pt idx="0">
                  <c:v>0</c:v>
                </c:pt>
                <c:pt idx="1">
                  <c:v>7.7967700000000004</c:v>
                </c:pt>
                <c:pt idx="2">
                  <c:v>7.8630999999999993</c:v>
                </c:pt>
                <c:pt idx="3">
                  <c:v>7.9018800000000002</c:v>
                </c:pt>
                <c:pt idx="4">
                  <c:v>7.9033800000000003</c:v>
                </c:pt>
                <c:pt idx="5">
                  <c:v>7.9177499999999998</c:v>
                </c:pt>
                <c:pt idx="6">
                  <c:v>7.9170199999999991</c:v>
                </c:pt>
                <c:pt idx="7">
                  <c:v>7.9263700000000004</c:v>
                </c:pt>
                <c:pt idx="8">
                  <c:v>7.9272799999999997</c:v>
                </c:pt>
                <c:pt idx="9">
                  <c:v>7.92645999999999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492-2D41-9075-880D7E964563}"/>
            </c:ext>
          </c:extLst>
        </c:ser>
        <c:ser>
          <c:idx val="1"/>
          <c:order val="1"/>
          <c:tx>
            <c:strRef>
              <c:f>Shannon!$B$3</c:f>
              <c:strCache>
                <c:ptCount val="1"/>
                <c:pt idx="0">
                  <c:v>2C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numRef>
              <c:f>Shannon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Shannon!$C$3:$L$3</c:f>
              <c:numCache>
                <c:formatCode>General</c:formatCode>
                <c:ptCount val="10"/>
                <c:pt idx="0">
                  <c:v>0</c:v>
                </c:pt>
                <c:pt idx="1">
                  <c:v>7.8625899999999991</c:v>
                </c:pt>
                <c:pt idx="2">
                  <c:v>7.91425</c:v>
                </c:pt>
                <c:pt idx="3">
                  <c:v>7.9458299999999999</c:v>
                </c:pt>
                <c:pt idx="4">
                  <c:v>7.9748900000000003</c:v>
                </c:pt>
                <c:pt idx="5">
                  <c:v>7.97058</c:v>
                </c:pt>
                <c:pt idx="6">
                  <c:v>7.9796800000000001</c:v>
                </c:pt>
                <c:pt idx="7">
                  <c:v>7.9808000000000003</c:v>
                </c:pt>
                <c:pt idx="8">
                  <c:v>7.9837100000000003</c:v>
                </c:pt>
                <c:pt idx="9">
                  <c:v>7.98951999999999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C492-2D41-9075-880D7E964563}"/>
            </c:ext>
          </c:extLst>
        </c:ser>
        <c:ser>
          <c:idx val="2"/>
          <c:order val="2"/>
          <c:tx>
            <c:strRef>
              <c:f>Shannon!$B$4</c:f>
              <c:strCache>
                <c:ptCount val="1"/>
                <c:pt idx="0">
                  <c:v>3C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cat>
            <c:numRef>
              <c:f>Shannon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Shannon!$C$4:$L$4</c:f>
              <c:numCache>
                <c:formatCode>General</c:formatCode>
                <c:ptCount val="10"/>
                <c:pt idx="0">
                  <c:v>0</c:v>
                </c:pt>
                <c:pt idx="1">
                  <c:v>6.6657999999999991</c:v>
                </c:pt>
                <c:pt idx="2">
                  <c:v>6.7100499999999998</c:v>
                </c:pt>
                <c:pt idx="3">
                  <c:v>6.7370000000000001</c:v>
                </c:pt>
                <c:pt idx="4">
                  <c:v>6.7319500000000003</c:v>
                </c:pt>
                <c:pt idx="5">
                  <c:v>6.7380800000000001</c:v>
                </c:pt>
                <c:pt idx="6">
                  <c:v>6.7496</c:v>
                </c:pt>
                <c:pt idx="7">
                  <c:v>6.73895</c:v>
                </c:pt>
                <c:pt idx="8">
                  <c:v>6.7429699999999997</c:v>
                </c:pt>
                <c:pt idx="9">
                  <c:v>6.74296999999999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C492-2D41-9075-880D7E964563}"/>
            </c:ext>
          </c:extLst>
        </c:ser>
        <c:ser>
          <c:idx val="3"/>
          <c:order val="3"/>
          <c:tx>
            <c:strRef>
              <c:f>Shannon!$B$5</c:f>
              <c:strCache>
                <c:ptCount val="1"/>
                <c:pt idx="0">
                  <c:v>4C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cat>
            <c:numRef>
              <c:f>Shannon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Shannon!$C$5:$L$5</c:f>
              <c:numCache>
                <c:formatCode>General</c:formatCode>
                <c:ptCount val="10"/>
                <c:pt idx="0">
                  <c:v>0</c:v>
                </c:pt>
                <c:pt idx="1">
                  <c:v>6.6247999999999987</c:v>
                </c:pt>
                <c:pt idx="2">
                  <c:v>6.6593</c:v>
                </c:pt>
                <c:pt idx="3">
                  <c:v>6.675889999999999</c:v>
                </c:pt>
                <c:pt idx="4">
                  <c:v>6.6865600000000001</c:v>
                </c:pt>
                <c:pt idx="5">
                  <c:v>6.6910400000000001</c:v>
                </c:pt>
                <c:pt idx="6">
                  <c:v>6.6952099999999994</c:v>
                </c:pt>
                <c:pt idx="7">
                  <c:v>6.7017899999999999</c:v>
                </c:pt>
                <c:pt idx="8">
                  <c:v>6.692899999999999</c:v>
                </c:pt>
                <c:pt idx="9">
                  <c:v>6.698119999999999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C492-2D41-9075-880D7E964563}"/>
            </c:ext>
          </c:extLst>
        </c:ser>
        <c:ser>
          <c:idx val="4"/>
          <c:order val="4"/>
          <c:tx>
            <c:strRef>
              <c:f>Shannon!$B$6</c:f>
              <c:strCache>
                <c:ptCount val="1"/>
                <c:pt idx="0">
                  <c:v>5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none"/>
          </c:marker>
          <c:cat>
            <c:numRef>
              <c:f>Shannon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Shannon!$C$6:$L$6</c:f>
              <c:numCache>
                <c:formatCode>General</c:formatCode>
                <c:ptCount val="10"/>
                <c:pt idx="0">
                  <c:v>0</c:v>
                </c:pt>
                <c:pt idx="1">
                  <c:v>7.01349</c:v>
                </c:pt>
                <c:pt idx="2">
                  <c:v>7.0506500000000001</c:v>
                </c:pt>
                <c:pt idx="3">
                  <c:v>7.0691299999999986</c:v>
                </c:pt>
                <c:pt idx="4">
                  <c:v>7.0717999999999996</c:v>
                </c:pt>
                <c:pt idx="5">
                  <c:v>7.07287</c:v>
                </c:pt>
                <c:pt idx="6">
                  <c:v>7.07608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C492-2D41-9075-880D7E964563}"/>
            </c:ext>
          </c:extLst>
        </c:ser>
        <c:ser>
          <c:idx val="5"/>
          <c:order val="5"/>
          <c:tx>
            <c:strRef>
              <c:f>Shannon!$B$7</c:f>
              <c:strCache>
                <c:ptCount val="1"/>
                <c:pt idx="0">
                  <c:v>6</c:v>
                </c:pt>
              </c:strCache>
            </c:strRef>
          </c:tx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none"/>
          </c:marker>
          <c:cat>
            <c:numRef>
              <c:f>Shannon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Shannon!$C$7:$L$7</c:f>
              <c:numCache>
                <c:formatCode>General</c:formatCode>
                <c:ptCount val="10"/>
                <c:pt idx="0">
                  <c:v>0</c:v>
                </c:pt>
                <c:pt idx="1">
                  <c:v>6.7547600000000001</c:v>
                </c:pt>
                <c:pt idx="2">
                  <c:v>6.8107299999999986</c:v>
                </c:pt>
                <c:pt idx="3">
                  <c:v>6.834719999999999</c:v>
                </c:pt>
                <c:pt idx="4">
                  <c:v>6.823199999999999</c:v>
                </c:pt>
                <c:pt idx="5">
                  <c:v>6.8433400000000004</c:v>
                </c:pt>
                <c:pt idx="6">
                  <c:v>6.8374699999999997</c:v>
                </c:pt>
                <c:pt idx="7">
                  <c:v>6.8396299999999997</c:v>
                </c:pt>
                <c:pt idx="8">
                  <c:v>6.844079999999999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C492-2D41-9075-880D7E964563}"/>
            </c:ext>
          </c:extLst>
        </c:ser>
        <c:ser>
          <c:idx val="6"/>
          <c:order val="6"/>
          <c:tx>
            <c:strRef>
              <c:f>Shannon!$B$8</c:f>
              <c:strCache>
                <c:ptCount val="1"/>
                <c:pt idx="0">
                  <c:v>7</c:v>
                </c:pt>
              </c:strCache>
            </c:strRef>
          </c:tx>
          <c:spPr>
            <a:ln w="28575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Shannon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Shannon!$C$8:$L$8</c:f>
              <c:numCache>
                <c:formatCode>General</c:formatCode>
                <c:ptCount val="10"/>
                <c:pt idx="0">
                  <c:v>0</c:v>
                </c:pt>
                <c:pt idx="1">
                  <c:v>6.93466</c:v>
                </c:pt>
                <c:pt idx="2">
                  <c:v>7.0217999999999998</c:v>
                </c:pt>
                <c:pt idx="3">
                  <c:v>7.010089999999999</c:v>
                </c:pt>
                <c:pt idx="4">
                  <c:v>7.0274799999999988</c:v>
                </c:pt>
                <c:pt idx="5">
                  <c:v>7.0398800000000001</c:v>
                </c:pt>
                <c:pt idx="6">
                  <c:v>7.0331400000000004</c:v>
                </c:pt>
                <c:pt idx="7">
                  <c:v>7.0338700000000003</c:v>
                </c:pt>
                <c:pt idx="8">
                  <c:v>7.0394500000000004</c:v>
                </c:pt>
                <c:pt idx="9">
                  <c:v>7.03585999999999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C492-2D41-9075-880D7E964563}"/>
            </c:ext>
          </c:extLst>
        </c:ser>
        <c:ser>
          <c:idx val="7"/>
          <c:order val="7"/>
          <c:tx>
            <c:strRef>
              <c:f>Shannon!$B$9</c:f>
              <c:strCache>
                <c:ptCount val="1"/>
                <c:pt idx="0">
                  <c:v>8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Shannon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Shannon!$C$9:$L$9</c:f>
              <c:numCache>
                <c:formatCode>General</c:formatCode>
                <c:ptCount val="10"/>
                <c:pt idx="0">
                  <c:v>0</c:v>
                </c:pt>
                <c:pt idx="1">
                  <c:v>6.4381700000000004</c:v>
                </c:pt>
                <c:pt idx="2">
                  <c:v>6.4874099999999997</c:v>
                </c:pt>
                <c:pt idx="3">
                  <c:v>6.4955799999999986</c:v>
                </c:pt>
                <c:pt idx="4">
                  <c:v>6.51654</c:v>
                </c:pt>
                <c:pt idx="5">
                  <c:v>6.518889999999999</c:v>
                </c:pt>
                <c:pt idx="6">
                  <c:v>6.52047000000000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C492-2D41-9075-880D7E964563}"/>
            </c:ext>
          </c:extLst>
        </c:ser>
        <c:ser>
          <c:idx val="8"/>
          <c:order val="8"/>
          <c:tx>
            <c:strRef>
              <c:f>Shannon!$B$10</c:f>
              <c:strCache>
                <c:ptCount val="1"/>
                <c:pt idx="0">
                  <c:v>9</c:v>
                </c:pt>
              </c:strCache>
            </c:strRef>
          </c:tx>
          <c:spPr>
            <a:ln w="28575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Shannon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Shannon!$C$10:$L$10</c:f>
              <c:numCache>
                <c:formatCode>General</c:formatCode>
                <c:ptCount val="10"/>
                <c:pt idx="0">
                  <c:v>0</c:v>
                </c:pt>
                <c:pt idx="1">
                  <c:v>7.3233600000000001</c:v>
                </c:pt>
                <c:pt idx="2">
                  <c:v>7.3698999999999986</c:v>
                </c:pt>
                <c:pt idx="3">
                  <c:v>7.3807999999999998</c:v>
                </c:pt>
                <c:pt idx="4">
                  <c:v>7.3921399999999986</c:v>
                </c:pt>
                <c:pt idx="5">
                  <c:v>7.3956600000000003</c:v>
                </c:pt>
                <c:pt idx="6">
                  <c:v>7.3994499999999999</c:v>
                </c:pt>
                <c:pt idx="7">
                  <c:v>7.4026699999999996</c:v>
                </c:pt>
                <c:pt idx="8">
                  <c:v>7.4036499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C492-2D41-9075-880D7E964563}"/>
            </c:ext>
          </c:extLst>
        </c:ser>
        <c:ser>
          <c:idx val="9"/>
          <c:order val="9"/>
          <c:tx>
            <c:strRef>
              <c:f>Shannon!$B$11</c:f>
              <c:strCache>
                <c:ptCount val="1"/>
                <c:pt idx="0">
                  <c:v>10</c:v>
                </c:pt>
              </c:strCache>
            </c:strRef>
          </c:tx>
          <c:spPr>
            <a:ln w="28575" cap="rnd">
              <a:solidFill>
                <a:schemeClr val="accent4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Shannon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Shannon!$C$11:$L$11</c:f>
              <c:numCache>
                <c:formatCode>General</c:formatCode>
                <c:ptCount val="10"/>
                <c:pt idx="0">
                  <c:v>0</c:v>
                </c:pt>
                <c:pt idx="1">
                  <c:v>7.3209799999999987</c:v>
                </c:pt>
                <c:pt idx="2">
                  <c:v>7.3810399999999996</c:v>
                </c:pt>
                <c:pt idx="3">
                  <c:v>7.3872</c:v>
                </c:pt>
                <c:pt idx="4">
                  <c:v>7.4041299999999994</c:v>
                </c:pt>
                <c:pt idx="5">
                  <c:v>7.4157000000000002</c:v>
                </c:pt>
                <c:pt idx="6">
                  <c:v>7.4120600000000003</c:v>
                </c:pt>
                <c:pt idx="7">
                  <c:v>7.4184200000000002</c:v>
                </c:pt>
                <c:pt idx="8">
                  <c:v>7.4211099999999997</c:v>
                </c:pt>
                <c:pt idx="9">
                  <c:v>7.422819999999998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C492-2D41-9075-880D7E964563}"/>
            </c:ext>
          </c:extLst>
        </c:ser>
        <c:ser>
          <c:idx val="10"/>
          <c:order val="10"/>
          <c:tx>
            <c:strRef>
              <c:f>Shannon!$B$12</c:f>
              <c:strCache>
                <c:ptCount val="1"/>
                <c:pt idx="0">
                  <c:v>11</c:v>
                </c:pt>
              </c:strCache>
            </c:strRef>
          </c:tx>
          <c:spPr>
            <a:ln w="28575" cap="rnd">
              <a:solidFill>
                <a:schemeClr val="accent5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Shannon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Shannon!$C$12:$L$12</c:f>
              <c:numCache>
                <c:formatCode>General</c:formatCode>
                <c:ptCount val="10"/>
                <c:pt idx="0">
                  <c:v>0</c:v>
                </c:pt>
                <c:pt idx="1">
                  <c:v>7.0711000000000004</c:v>
                </c:pt>
                <c:pt idx="2">
                  <c:v>7.0972299999999997</c:v>
                </c:pt>
                <c:pt idx="3">
                  <c:v>7.107219999999999</c:v>
                </c:pt>
                <c:pt idx="4">
                  <c:v>7.1152799999999994</c:v>
                </c:pt>
                <c:pt idx="5">
                  <c:v>7.1160600000000001</c:v>
                </c:pt>
                <c:pt idx="6">
                  <c:v>7.1232299999999986</c:v>
                </c:pt>
                <c:pt idx="7">
                  <c:v>7.1251799999999994</c:v>
                </c:pt>
                <c:pt idx="8">
                  <c:v>7.128849999999999</c:v>
                </c:pt>
                <c:pt idx="9">
                  <c:v>7.12877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A-C492-2D41-9075-880D7E964563}"/>
            </c:ext>
          </c:extLst>
        </c:ser>
        <c:ser>
          <c:idx val="11"/>
          <c:order val="11"/>
          <c:tx>
            <c:strRef>
              <c:f>Shannon!$B$13</c:f>
              <c:strCache>
                <c:ptCount val="1"/>
                <c:pt idx="0">
                  <c:v>12</c:v>
                </c:pt>
              </c:strCache>
            </c:strRef>
          </c:tx>
          <c:spPr>
            <a:ln w="28575" cap="rnd">
              <a:solidFill>
                <a:schemeClr val="accent6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Shannon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Shannon!$C$13:$L$13</c:f>
              <c:numCache>
                <c:formatCode>General</c:formatCode>
                <c:ptCount val="10"/>
                <c:pt idx="0">
                  <c:v>0</c:v>
                </c:pt>
                <c:pt idx="1">
                  <c:v>7.4366899999999996</c:v>
                </c:pt>
                <c:pt idx="2">
                  <c:v>7.5004</c:v>
                </c:pt>
                <c:pt idx="3">
                  <c:v>7.5211799999999993</c:v>
                </c:pt>
                <c:pt idx="4">
                  <c:v>7.5355299999999996</c:v>
                </c:pt>
                <c:pt idx="5">
                  <c:v>7.5354999999999999</c:v>
                </c:pt>
                <c:pt idx="6">
                  <c:v>7.5404099999999996</c:v>
                </c:pt>
                <c:pt idx="7">
                  <c:v>7.54227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B-C492-2D41-9075-880D7E964563}"/>
            </c:ext>
          </c:extLst>
        </c:ser>
        <c:ser>
          <c:idx val="12"/>
          <c:order val="12"/>
          <c:tx>
            <c:strRef>
              <c:f>Shannon!$B$14</c:f>
              <c:strCache>
                <c:ptCount val="1"/>
                <c:pt idx="0">
                  <c:v>13</c:v>
                </c:pt>
              </c:strCache>
            </c:strRef>
          </c:tx>
          <c:spPr>
            <a:ln w="28575" cap="rnd">
              <a:solidFill>
                <a:schemeClr val="accent1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Shannon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Shannon!$C$14:$L$14</c:f>
              <c:numCache>
                <c:formatCode>General</c:formatCode>
                <c:ptCount val="10"/>
                <c:pt idx="0">
                  <c:v>0</c:v>
                </c:pt>
                <c:pt idx="1">
                  <c:v>7.1526099999999992</c:v>
                </c:pt>
                <c:pt idx="2">
                  <c:v>7.2062400000000002</c:v>
                </c:pt>
                <c:pt idx="3">
                  <c:v>7.23935</c:v>
                </c:pt>
                <c:pt idx="4">
                  <c:v>7.2502000000000004</c:v>
                </c:pt>
                <c:pt idx="5">
                  <c:v>7.2461799999999998</c:v>
                </c:pt>
                <c:pt idx="6">
                  <c:v>7.2563199999999997</c:v>
                </c:pt>
                <c:pt idx="7">
                  <c:v>7.25115</c:v>
                </c:pt>
                <c:pt idx="8">
                  <c:v>7.25380999999999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C-C492-2D41-9075-880D7E964563}"/>
            </c:ext>
          </c:extLst>
        </c:ser>
        <c:ser>
          <c:idx val="13"/>
          <c:order val="13"/>
          <c:tx>
            <c:strRef>
              <c:f>Shannon!$B$15</c:f>
              <c:strCache>
                <c:ptCount val="1"/>
                <c:pt idx="0">
                  <c:v>14</c:v>
                </c:pt>
              </c:strCache>
            </c:strRef>
          </c:tx>
          <c:spPr>
            <a:ln w="28575" cap="rnd">
              <a:solidFill>
                <a:schemeClr val="accent2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Shannon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Shannon!$C$15:$L$15</c:f>
              <c:numCache>
                <c:formatCode>General</c:formatCode>
                <c:ptCount val="10"/>
                <c:pt idx="0">
                  <c:v>0</c:v>
                </c:pt>
                <c:pt idx="1">
                  <c:v>6.6903999999999986</c:v>
                </c:pt>
                <c:pt idx="2">
                  <c:v>6.7442599999999997</c:v>
                </c:pt>
                <c:pt idx="3">
                  <c:v>6.7586599999999999</c:v>
                </c:pt>
                <c:pt idx="4">
                  <c:v>6.7636900000000004</c:v>
                </c:pt>
                <c:pt idx="5">
                  <c:v>6.7716900000000004</c:v>
                </c:pt>
                <c:pt idx="6">
                  <c:v>6.7711899999999998</c:v>
                </c:pt>
                <c:pt idx="7">
                  <c:v>6.7753300000000003</c:v>
                </c:pt>
                <c:pt idx="8">
                  <c:v>6.77847000000000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D-C492-2D41-9075-880D7E964563}"/>
            </c:ext>
          </c:extLst>
        </c:ser>
        <c:ser>
          <c:idx val="14"/>
          <c:order val="14"/>
          <c:tx>
            <c:strRef>
              <c:f>Shannon!$B$16</c:f>
              <c:strCache>
                <c:ptCount val="1"/>
                <c:pt idx="0">
                  <c:v>15</c:v>
                </c:pt>
              </c:strCache>
            </c:strRef>
          </c:tx>
          <c:spPr>
            <a:ln w="28575" cap="rnd">
              <a:solidFill>
                <a:schemeClr val="accent3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Shannon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Shannon!$C$16:$L$16</c:f>
              <c:numCache>
                <c:formatCode>General</c:formatCode>
                <c:ptCount val="10"/>
                <c:pt idx="0">
                  <c:v>0</c:v>
                </c:pt>
                <c:pt idx="1">
                  <c:v>7.3404400000000001</c:v>
                </c:pt>
                <c:pt idx="2">
                  <c:v>7.3806900000000004</c:v>
                </c:pt>
                <c:pt idx="3">
                  <c:v>7.4137899999999997</c:v>
                </c:pt>
                <c:pt idx="4">
                  <c:v>7.4231499999999997</c:v>
                </c:pt>
                <c:pt idx="5">
                  <c:v>7.42638</c:v>
                </c:pt>
                <c:pt idx="6">
                  <c:v>7.4310200000000002</c:v>
                </c:pt>
                <c:pt idx="7">
                  <c:v>7.4298900000000003</c:v>
                </c:pt>
                <c:pt idx="8">
                  <c:v>7.4385000000000003</c:v>
                </c:pt>
                <c:pt idx="9">
                  <c:v>7.43750999999999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E-C492-2D41-9075-880D7E964563}"/>
            </c:ext>
          </c:extLst>
        </c:ser>
        <c:ser>
          <c:idx val="15"/>
          <c:order val="15"/>
          <c:tx>
            <c:strRef>
              <c:f>Shannon!$B$17</c:f>
              <c:strCache>
                <c:ptCount val="1"/>
                <c:pt idx="0">
                  <c:v>16</c:v>
                </c:pt>
              </c:strCache>
            </c:strRef>
          </c:tx>
          <c:spPr>
            <a:ln w="28575" cap="rnd">
              <a:solidFill>
                <a:schemeClr val="accent4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Shannon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Shannon!$C$17:$L$17</c:f>
              <c:numCache>
                <c:formatCode>General</c:formatCode>
                <c:ptCount val="10"/>
                <c:pt idx="0">
                  <c:v>0</c:v>
                </c:pt>
                <c:pt idx="1">
                  <c:v>5.9327199999999998</c:v>
                </c:pt>
                <c:pt idx="2">
                  <c:v>5.9515000000000002</c:v>
                </c:pt>
                <c:pt idx="3">
                  <c:v>5.9847299999999999</c:v>
                </c:pt>
                <c:pt idx="4">
                  <c:v>5.9930599999999998</c:v>
                </c:pt>
                <c:pt idx="5">
                  <c:v>6.00162</c:v>
                </c:pt>
                <c:pt idx="6">
                  <c:v>6.0064599999999997</c:v>
                </c:pt>
                <c:pt idx="7">
                  <c:v>6.0022500000000001</c:v>
                </c:pt>
                <c:pt idx="8">
                  <c:v>6.0126499999999998</c:v>
                </c:pt>
                <c:pt idx="9">
                  <c:v>6.00187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F-C492-2D41-9075-880D7E964563}"/>
            </c:ext>
          </c:extLst>
        </c:ser>
        <c:ser>
          <c:idx val="16"/>
          <c:order val="16"/>
          <c:tx>
            <c:strRef>
              <c:f>Shannon!$B$18</c:f>
              <c:strCache>
                <c:ptCount val="1"/>
                <c:pt idx="0">
                  <c:v>17</c:v>
                </c:pt>
              </c:strCache>
            </c:strRef>
          </c:tx>
          <c:spPr>
            <a:ln w="28575" cap="rnd">
              <a:solidFill>
                <a:schemeClr val="accent5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Shannon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Shannon!$C$18:$L$18</c:f>
              <c:numCache>
                <c:formatCode>General</c:formatCode>
                <c:ptCount val="10"/>
                <c:pt idx="0">
                  <c:v>0</c:v>
                </c:pt>
                <c:pt idx="1">
                  <c:v>6.3275399999999982</c:v>
                </c:pt>
                <c:pt idx="2">
                  <c:v>6.37174</c:v>
                </c:pt>
                <c:pt idx="3">
                  <c:v>6.3761799999999997</c:v>
                </c:pt>
                <c:pt idx="4">
                  <c:v>6.3845799999999988</c:v>
                </c:pt>
                <c:pt idx="5">
                  <c:v>6.3994900000000001</c:v>
                </c:pt>
                <c:pt idx="6">
                  <c:v>6.3867200000000004</c:v>
                </c:pt>
                <c:pt idx="7">
                  <c:v>6.3970199999999986</c:v>
                </c:pt>
                <c:pt idx="8">
                  <c:v>6.392199999999999</c:v>
                </c:pt>
                <c:pt idx="9">
                  <c:v>6.394509999999998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0-C492-2D41-9075-880D7E964563}"/>
            </c:ext>
          </c:extLst>
        </c:ser>
        <c:ser>
          <c:idx val="17"/>
          <c:order val="17"/>
          <c:tx>
            <c:strRef>
              <c:f>Shannon!$B$19</c:f>
              <c:strCache>
                <c:ptCount val="1"/>
                <c:pt idx="0">
                  <c:v>18</c:v>
                </c:pt>
              </c:strCache>
            </c:strRef>
          </c:tx>
          <c:spPr>
            <a:ln w="28575" cap="rnd">
              <a:solidFill>
                <a:schemeClr val="accent6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Shannon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Shannon!$C$19:$L$19</c:f>
              <c:numCache>
                <c:formatCode>General</c:formatCode>
                <c:ptCount val="10"/>
                <c:pt idx="0">
                  <c:v>0</c:v>
                </c:pt>
                <c:pt idx="1">
                  <c:v>7.3534299999999986</c:v>
                </c:pt>
                <c:pt idx="2">
                  <c:v>7.42476</c:v>
                </c:pt>
                <c:pt idx="3">
                  <c:v>7.4365600000000001</c:v>
                </c:pt>
                <c:pt idx="4">
                  <c:v>7.4429999999999996</c:v>
                </c:pt>
                <c:pt idx="5">
                  <c:v>7.4478900000000001</c:v>
                </c:pt>
                <c:pt idx="6">
                  <c:v>7.4479299999999986</c:v>
                </c:pt>
                <c:pt idx="7">
                  <c:v>7.4567800000000002</c:v>
                </c:pt>
                <c:pt idx="8">
                  <c:v>7.4561900000000003</c:v>
                </c:pt>
                <c:pt idx="9">
                  <c:v>7.45680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1-C492-2D41-9075-880D7E964563}"/>
            </c:ext>
          </c:extLst>
        </c:ser>
        <c:ser>
          <c:idx val="18"/>
          <c:order val="18"/>
          <c:tx>
            <c:strRef>
              <c:f>Shannon!$B$20</c:f>
              <c:strCache>
                <c:ptCount val="1"/>
                <c:pt idx="0">
                  <c:v>19</c:v>
                </c:pt>
              </c:strCache>
            </c:strRef>
          </c:tx>
          <c:spPr>
            <a:ln w="28575" cap="rnd">
              <a:solidFill>
                <a:schemeClr val="accent1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Shannon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Shannon!$C$20:$L$20</c:f>
              <c:numCache>
                <c:formatCode>General</c:formatCode>
                <c:ptCount val="10"/>
                <c:pt idx="0">
                  <c:v>0</c:v>
                </c:pt>
                <c:pt idx="1">
                  <c:v>7.38171</c:v>
                </c:pt>
                <c:pt idx="2">
                  <c:v>7.4281600000000001</c:v>
                </c:pt>
                <c:pt idx="3">
                  <c:v>7.4479499999999996</c:v>
                </c:pt>
                <c:pt idx="4">
                  <c:v>7.46685</c:v>
                </c:pt>
                <c:pt idx="5">
                  <c:v>7.4690200000000004</c:v>
                </c:pt>
                <c:pt idx="6">
                  <c:v>7.4667199999999996</c:v>
                </c:pt>
                <c:pt idx="7">
                  <c:v>7.47288</c:v>
                </c:pt>
                <c:pt idx="8">
                  <c:v>7.47506</c:v>
                </c:pt>
                <c:pt idx="9">
                  <c:v>7.477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2-C492-2D41-9075-880D7E964563}"/>
            </c:ext>
          </c:extLst>
        </c:ser>
        <c:ser>
          <c:idx val="19"/>
          <c:order val="19"/>
          <c:tx>
            <c:strRef>
              <c:f>Shannon!$B$21</c:f>
              <c:strCache>
                <c:ptCount val="1"/>
                <c:pt idx="0">
                  <c:v>20</c:v>
                </c:pt>
              </c:strCache>
            </c:strRef>
          </c:tx>
          <c:spPr>
            <a:ln w="28575" cap="rnd">
              <a:solidFill>
                <a:schemeClr val="accent2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Shannon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Shannon!$C$21:$L$21</c:f>
              <c:numCache>
                <c:formatCode>General</c:formatCode>
                <c:ptCount val="10"/>
                <c:pt idx="0">
                  <c:v>0</c:v>
                </c:pt>
                <c:pt idx="1">
                  <c:v>6.0340400000000001</c:v>
                </c:pt>
                <c:pt idx="2">
                  <c:v>6.0925599999999989</c:v>
                </c:pt>
                <c:pt idx="3">
                  <c:v>6.1019199999999989</c:v>
                </c:pt>
                <c:pt idx="4">
                  <c:v>6.1338999999999997</c:v>
                </c:pt>
                <c:pt idx="5">
                  <c:v>6.1160500000000004</c:v>
                </c:pt>
                <c:pt idx="6">
                  <c:v>6.1105199999999993</c:v>
                </c:pt>
                <c:pt idx="7">
                  <c:v>6.125729999999999</c:v>
                </c:pt>
                <c:pt idx="8">
                  <c:v>6.1235999999999988</c:v>
                </c:pt>
                <c:pt idx="9">
                  <c:v>6.121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3-C492-2D41-9075-880D7E964563}"/>
            </c:ext>
          </c:extLst>
        </c:ser>
        <c:ser>
          <c:idx val="20"/>
          <c:order val="20"/>
          <c:tx>
            <c:strRef>
              <c:f>Shannon!$B$22</c:f>
              <c:strCache>
                <c:ptCount val="1"/>
                <c:pt idx="0">
                  <c:v>21</c:v>
                </c:pt>
              </c:strCache>
            </c:strRef>
          </c:tx>
          <c:spPr>
            <a:ln w="28575" cap="rnd">
              <a:solidFill>
                <a:schemeClr val="accent3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Shannon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Shannon!$C$22:$L$22</c:f>
              <c:numCache>
                <c:formatCode>General</c:formatCode>
                <c:ptCount val="10"/>
                <c:pt idx="0">
                  <c:v>0</c:v>
                </c:pt>
                <c:pt idx="1">
                  <c:v>6.6611499999999992</c:v>
                </c:pt>
                <c:pt idx="2">
                  <c:v>6.7243299999999993</c:v>
                </c:pt>
                <c:pt idx="3">
                  <c:v>6.7484799999999998</c:v>
                </c:pt>
                <c:pt idx="4">
                  <c:v>6.762319999999999</c:v>
                </c:pt>
                <c:pt idx="5">
                  <c:v>6.7682200000000003</c:v>
                </c:pt>
                <c:pt idx="6">
                  <c:v>6.764079999999999</c:v>
                </c:pt>
                <c:pt idx="7">
                  <c:v>6.7675999999999989</c:v>
                </c:pt>
                <c:pt idx="8">
                  <c:v>6.7648799999999989</c:v>
                </c:pt>
                <c:pt idx="9">
                  <c:v>6.7698900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4-C492-2D41-9075-880D7E964563}"/>
            </c:ext>
          </c:extLst>
        </c:ser>
        <c:ser>
          <c:idx val="21"/>
          <c:order val="21"/>
          <c:tx>
            <c:strRef>
              <c:f>Shannon!$B$23</c:f>
              <c:strCache>
                <c:ptCount val="1"/>
                <c:pt idx="0">
                  <c:v>22</c:v>
                </c:pt>
              </c:strCache>
            </c:strRef>
          </c:tx>
          <c:spPr>
            <a:ln w="28575" cap="rnd">
              <a:solidFill>
                <a:schemeClr val="accent4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Shannon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Shannon!$C$23:$L$23</c:f>
              <c:numCache>
                <c:formatCode>General</c:formatCode>
                <c:ptCount val="10"/>
                <c:pt idx="0">
                  <c:v>0</c:v>
                </c:pt>
                <c:pt idx="1">
                  <c:v>6.4053100000000001</c:v>
                </c:pt>
                <c:pt idx="2">
                  <c:v>6.4282000000000004</c:v>
                </c:pt>
                <c:pt idx="3">
                  <c:v>6.4752700000000001</c:v>
                </c:pt>
                <c:pt idx="4">
                  <c:v>6.4701199999999996</c:v>
                </c:pt>
                <c:pt idx="5">
                  <c:v>6.4688699999999999</c:v>
                </c:pt>
                <c:pt idx="6">
                  <c:v>6.4811199999999998</c:v>
                </c:pt>
                <c:pt idx="7">
                  <c:v>6.4769300000000003</c:v>
                </c:pt>
                <c:pt idx="8">
                  <c:v>6.4771599999999996</c:v>
                </c:pt>
                <c:pt idx="9">
                  <c:v>6.4790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5-C492-2D41-9075-880D7E964563}"/>
            </c:ext>
          </c:extLst>
        </c:ser>
        <c:ser>
          <c:idx val="22"/>
          <c:order val="22"/>
          <c:tx>
            <c:strRef>
              <c:f>Shannon!$B$24</c:f>
              <c:strCache>
                <c:ptCount val="1"/>
                <c:pt idx="0">
                  <c:v>23</c:v>
                </c:pt>
              </c:strCache>
            </c:strRef>
          </c:tx>
          <c:spPr>
            <a:ln w="28575" cap="rnd">
              <a:solidFill>
                <a:schemeClr val="accent5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Shannon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Shannon!$C$24:$L$24</c:f>
              <c:numCache>
                <c:formatCode>General</c:formatCode>
                <c:ptCount val="10"/>
                <c:pt idx="0">
                  <c:v>0</c:v>
                </c:pt>
                <c:pt idx="1">
                  <c:v>7.2675599999999987</c:v>
                </c:pt>
                <c:pt idx="2">
                  <c:v>7.3120599999999989</c:v>
                </c:pt>
                <c:pt idx="3">
                  <c:v>7.3235799999999989</c:v>
                </c:pt>
                <c:pt idx="4">
                  <c:v>7.3248799999999976</c:v>
                </c:pt>
                <c:pt idx="5">
                  <c:v>7.3408699999999998</c:v>
                </c:pt>
                <c:pt idx="6">
                  <c:v>7.3450699999999998</c:v>
                </c:pt>
                <c:pt idx="7">
                  <c:v>7.3448299999999991</c:v>
                </c:pt>
                <c:pt idx="8">
                  <c:v>7.3456400000000004</c:v>
                </c:pt>
                <c:pt idx="9">
                  <c:v>7.345809999999999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6-C492-2D41-9075-880D7E964563}"/>
            </c:ext>
          </c:extLst>
        </c:ser>
        <c:ser>
          <c:idx val="23"/>
          <c:order val="23"/>
          <c:tx>
            <c:strRef>
              <c:f>Shannon!$B$25</c:f>
              <c:strCache>
                <c:ptCount val="1"/>
                <c:pt idx="0">
                  <c:v>24</c:v>
                </c:pt>
              </c:strCache>
            </c:strRef>
          </c:tx>
          <c:spPr>
            <a:ln w="28575" cap="rnd">
              <a:solidFill>
                <a:schemeClr val="accent6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Shannon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Shannon!$C$25:$L$25</c:f>
              <c:numCache>
                <c:formatCode>General</c:formatCode>
                <c:ptCount val="10"/>
                <c:pt idx="0">
                  <c:v>0</c:v>
                </c:pt>
                <c:pt idx="1">
                  <c:v>7.4325900000000003</c:v>
                </c:pt>
                <c:pt idx="2">
                  <c:v>7.4852400000000001</c:v>
                </c:pt>
                <c:pt idx="3">
                  <c:v>7.494159999999999</c:v>
                </c:pt>
                <c:pt idx="4">
                  <c:v>7.5061400000000003</c:v>
                </c:pt>
                <c:pt idx="5">
                  <c:v>7.5090000000000003</c:v>
                </c:pt>
                <c:pt idx="6">
                  <c:v>7.5156299999999998</c:v>
                </c:pt>
                <c:pt idx="7">
                  <c:v>7.5218400000000001</c:v>
                </c:pt>
                <c:pt idx="8">
                  <c:v>7.5229599999999994</c:v>
                </c:pt>
                <c:pt idx="9">
                  <c:v>7.522999999999998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7-C492-2D41-9075-880D7E964563}"/>
            </c:ext>
          </c:extLst>
        </c:ser>
        <c:ser>
          <c:idx val="24"/>
          <c:order val="24"/>
          <c:tx>
            <c:strRef>
              <c:f>Shannon!$B$26</c:f>
              <c:strCache>
                <c:ptCount val="1"/>
                <c:pt idx="0">
                  <c:v>25</c:v>
                </c:pt>
              </c:strCache>
            </c:strRef>
          </c:tx>
          <c:spPr>
            <a:ln w="28575" cap="rnd">
              <a:solidFill>
                <a:schemeClr val="accent1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Shannon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Shannon!$C$26:$L$26</c:f>
              <c:numCache>
                <c:formatCode>General</c:formatCode>
                <c:ptCount val="10"/>
                <c:pt idx="0">
                  <c:v>0</c:v>
                </c:pt>
                <c:pt idx="1">
                  <c:v>7.2503599999999997</c:v>
                </c:pt>
                <c:pt idx="2">
                  <c:v>7.3097700000000003</c:v>
                </c:pt>
                <c:pt idx="3">
                  <c:v>7.3212999999999999</c:v>
                </c:pt>
                <c:pt idx="4">
                  <c:v>7.3383200000000004</c:v>
                </c:pt>
                <c:pt idx="5">
                  <c:v>7.3314199999999996</c:v>
                </c:pt>
                <c:pt idx="6">
                  <c:v>7.3410799999999998</c:v>
                </c:pt>
                <c:pt idx="7">
                  <c:v>7.3399400000000004</c:v>
                </c:pt>
                <c:pt idx="8">
                  <c:v>7.3422799999999997</c:v>
                </c:pt>
                <c:pt idx="9">
                  <c:v>7.34565999999999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8-C492-2D41-9075-880D7E964563}"/>
            </c:ext>
          </c:extLst>
        </c:ser>
        <c:ser>
          <c:idx val="25"/>
          <c:order val="25"/>
          <c:tx>
            <c:strRef>
              <c:f>Shannon!$B$27</c:f>
              <c:strCache>
                <c:ptCount val="1"/>
                <c:pt idx="0">
                  <c:v>26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Shannon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Shannon!$C$27:$L$27</c:f>
              <c:numCache>
                <c:formatCode>General</c:formatCode>
                <c:ptCount val="10"/>
                <c:pt idx="0">
                  <c:v>0</c:v>
                </c:pt>
                <c:pt idx="1">
                  <c:v>7.2330699999999997</c:v>
                </c:pt>
                <c:pt idx="2">
                  <c:v>7.2934700000000001</c:v>
                </c:pt>
                <c:pt idx="3">
                  <c:v>7.3146599999999991</c:v>
                </c:pt>
                <c:pt idx="4">
                  <c:v>7.3221899999999991</c:v>
                </c:pt>
                <c:pt idx="5">
                  <c:v>7.3274499999999989</c:v>
                </c:pt>
                <c:pt idx="6">
                  <c:v>7.3288999999999991</c:v>
                </c:pt>
                <c:pt idx="7">
                  <c:v>7.3285799999999988</c:v>
                </c:pt>
                <c:pt idx="8">
                  <c:v>7.3313300000000003</c:v>
                </c:pt>
                <c:pt idx="9">
                  <c:v>7.33223999999999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9-C492-2D41-9075-880D7E964563}"/>
            </c:ext>
          </c:extLst>
        </c:ser>
        <c:ser>
          <c:idx val="26"/>
          <c:order val="26"/>
          <c:tx>
            <c:strRef>
              <c:f>Shannon!$B$28</c:f>
              <c:strCache>
                <c:ptCount val="1"/>
                <c:pt idx="0">
                  <c:v>27</c:v>
                </c:pt>
              </c:strCache>
            </c:strRef>
          </c:tx>
          <c:spPr>
            <a:ln w="28575" cap="rnd">
              <a:solidFill>
                <a:schemeClr val="accent3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Shannon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Shannon!$C$28:$L$28</c:f>
              <c:numCache>
                <c:formatCode>General</c:formatCode>
                <c:ptCount val="10"/>
                <c:pt idx="0">
                  <c:v>0</c:v>
                </c:pt>
                <c:pt idx="1">
                  <c:v>5.7188999999999997</c:v>
                </c:pt>
                <c:pt idx="2">
                  <c:v>5.7481299999999997</c:v>
                </c:pt>
                <c:pt idx="3">
                  <c:v>5.7716099999999999</c:v>
                </c:pt>
                <c:pt idx="4">
                  <c:v>5.7610900000000003</c:v>
                </c:pt>
                <c:pt idx="5">
                  <c:v>5.7777000000000003</c:v>
                </c:pt>
                <c:pt idx="6">
                  <c:v>5.7922900000000004</c:v>
                </c:pt>
                <c:pt idx="7">
                  <c:v>5.7892200000000003</c:v>
                </c:pt>
                <c:pt idx="8">
                  <c:v>5.7895000000000003</c:v>
                </c:pt>
                <c:pt idx="9">
                  <c:v>5.787809999999998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A-C492-2D41-9075-880D7E964563}"/>
            </c:ext>
          </c:extLst>
        </c:ser>
        <c:ser>
          <c:idx val="27"/>
          <c:order val="27"/>
          <c:tx>
            <c:strRef>
              <c:f>Shannon!$B$29</c:f>
              <c:strCache>
                <c:ptCount val="1"/>
                <c:pt idx="0">
                  <c:v>28</c:v>
                </c:pt>
              </c:strCache>
            </c:strRef>
          </c:tx>
          <c:spPr>
            <a:ln w="28575" cap="rnd">
              <a:solidFill>
                <a:schemeClr val="accent4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Shannon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Shannon!$C$29:$L$29</c:f>
              <c:numCache>
                <c:formatCode>General</c:formatCode>
                <c:ptCount val="10"/>
                <c:pt idx="0">
                  <c:v>0</c:v>
                </c:pt>
                <c:pt idx="1">
                  <c:v>7.187759999999999</c:v>
                </c:pt>
                <c:pt idx="2">
                  <c:v>7.23529</c:v>
                </c:pt>
                <c:pt idx="3">
                  <c:v>7.2411000000000003</c:v>
                </c:pt>
                <c:pt idx="4">
                  <c:v>7.2541199999999986</c:v>
                </c:pt>
                <c:pt idx="5">
                  <c:v>7.2577600000000002</c:v>
                </c:pt>
                <c:pt idx="6">
                  <c:v>7.2597699999999996</c:v>
                </c:pt>
                <c:pt idx="7">
                  <c:v>7.2620799999999992</c:v>
                </c:pt>
                <c:pt idx="8">
                  <c:v>7.2683900000000001</c:v>
                </c:pt>
                <c:pt idx="9">
                  <c:v>7.27116999999999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B-C492-2D41-9075-880D7E964563}"/>
            </c:ext>
          </c:extLst>
        </c:ser>
        <c:ser>
          <c:idx val="28"/>
          <c:order val="28"/>
          <c:tx>
            <c:strRef>
              <c:f>Shannon!$B$30</c:f>
              <c:strCache>
                <c:ptCount val="1"/>
                <c:pt idx="0">
                  <c:v>29</c:v>
                </c:pt>
              </c:strCache>
            </c:strRef>
          </c:tx>
          <c:spPr>
            <a:ln w="28575" cap="rnd">
              <a:solidFill>
                <a:schemeClr val="accent5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Shannon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Shannon!$C$30:$L$30</c:f>
              <c:numCache>
                <c:formatCode>General</c:formatCode>
                <c:ptCount val="10"/>
                <c:pt idx="0">
                  <c:v>0</c:v>
                </c:pt>
                <c:pt idx="1">
                  <c:v>7.3602299999999996</c:v>
                </c:pt>
                <c:pt idx="2">
                  <c:v>7.4138599999999997</c:v>
                </c:pt>
                <c:pt idx="3">
                  <c:v>7.4428099999999997</c:v>
                </c:pt>
                <c:pt idx="4">
                  <c:v>7.4560399999999998</c:v>
                </c:pt>
                <c:pt idx="5">
                  <c:v>7.4578999999999986</c:v>
                </c:pt>
                <c:pt idx="6">
                  <c:v>7.4642900000000001</c:v>
                </c:pt>
                <c:pt idx="7">
                  <c:v>7.4709300000000001</c:v>
                </c:pt>
                <c:pt idx="8">
                  <c:v>7.4697199999999997</c:v>
                </c:pt>
                <c:pt idx="9">
                  <c:v>7.472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C-C492-2D41-9075-880D7E964563}"/>
            </c:ext>
          </c:extLst>
        </c:ser>
        <c:ser>
          <c:idx val="29"/>
          <c:order val="29"/>
          <c:tx>
            <c:strRef>
              <c:f>Shannon!$B$31</c:f>
              <c:strCache>
                <c:ptCount val="1"/>
                <c:pt idx="0">
                  <c:v>30</c:v>
                </c:pt>
              </c:strCache>
            </c:strRef>
          </c:tx>
          <c:spPr>
            <a:ln w="28575" cap="rnd">
              <a:solidFill>
                <a:schemeClr val="accent6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Shannon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Shannon!$C$31:$L$31</c:f>
              <c:numCache>
                <c:formatCode>General</c:formatCode>
                <c:ptCount val="10"/>
                <c:pt idx="0">
                  <c:v>0</c:v>
                </c:pt>
                <c:pt idx="1">
                  <c:v>6.54941</c:v>
                </c:pt>
                <c:pt idx="2">
                  <c:v>6.5642699999999996</c:v>
                </c:pt>
                <c:pt idx="3">
                  <c:v>6.5771699999999997</c:v>
                </c:pt>
                <c:pt idx="4">
                  <c:v>6.5836300000000003</c:v>
                </c:pt>
                <c:pt idx="5">
                  <c:v>6.58609000000000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D-C492-2D41-9075-880D7E964563}"/>
            </c:ext>
          </c:extLst>
        </c:ser>
        <c:ser>
          <c:idx val="30"/>
          <c:order val="30"/>
          <c:tx>
            <c:strRef>
              <c:f>Shannon!$B$32</c:f>
              <c:strCache>
                <c:ptCount val="1"/>
                <c:pt idx="0">
                  <c:v>31</c:v>
                </c:pt>
              </c:strCache>
            </c:strRef>
          </c:tx>
          <c:spPr>
            <a:ln w="28575" cap="rnd">
              <a:solidFill>
                <a:schemeClr val="accent1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Shannon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Shannon!$C$32:$L$32</c:f>
              <c:numCache>
                <c:formatCode>General</c:formatCode>
                <c:ptCount val="10"/>
                <c:pt idx="0">
                  <c:v>0</c:v>
                </c:pt>
                <c:pt idx="1">
                  <c:v>7.1890099999999997</c:v>
                </c:pt>
                <c:pt idx="2">
                  <c:v>7.2294600000000004</c:v>
                </c:pt>
                <c:pt idx="3">
                  <c:v>7.2445799999999991</c:v>
                </c:pt>
                <c:pt idx="4">
                  <c:v>7.2545400000000004</c:v>
                </c:pt>
                <c:pt idx="5">
                  <c:v>7.2511900000000002</c:v>
                </c:pt>
                <c:pt idx="6">
                  <c:v>7.2611999999999997</c:v>
                </c:pt>
                <c:pt idx="7">
                  <c:v>7.2640199999999986</c:v>
                </c:pt>
                <c:pt idx="8">
                  <c:v>7.26302999999999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E-C492-2D41-9075-880D7E964563}"/>
            </c:ext>
          </c:extLst>
        </c:ser>
        <c:ser>
          <c:idx val="31"/>
          <c:order val="31"/>
          <c:tx>
            <c:strRef>
              <c:f>Shannon!$B$33</c:f>
              <c:strCache>
                <c:ptCount val="1"/>
                <c:pt idx="0">
                  <c:v>32</c:v>
                </c:pt>
              </c:strCache>
            </c:strRef>
          </c:tx>
          <c:spPr>
            <a:ln w="28575" cap="rnd">
              <a:solidFill>
                <a:schemeClr val="accent2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Shannon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Shannon!$C$33:$L$33</c:f>
              <c:numCache>
                <c:formatCode>General</c:formatCode>
                <c:ptCount val="10"/>
                <c:pt idx="0">
                  <c:v>0</c:v>
                </c:pt>
                <c:pt idx="1">
                  <c:v>6.6327499999999997</c:v>
                </c:pt>
                <c:pt idx="2">
                  <c:v>6.6728299999999994</c:v>
                </c:pt>
                <c:pt idx="3">
                  <c:v>6.6925199999999991</c:v>
                </c:pt>
                <c:pt idx="4">
                  <c:v>6.7002600000000001</c:v>
                </c:pt>
                <c:pt idx="5">
                  <c:v>6.6986600000000003</c:v>
                </c:pt>
                <c:pt idx="6">
                  <c:v>6.7064399999999997</c:v>
                </c:pt>
                <c:pt idx="7">
                  <c:v>6.7033399999999999</c:v>
                </c:pt>
                <c:pt idx="8">
                  <c:v>6.70568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F-C492-2D41-9075-880D7E964563}"/>
            </c:ext>
          </c:extLst>
        </c:ser>
        <c:ser>
          <c:idx val="32"/>
          <c:order val="32"/>
          <c:tx>
            <c:strRef>
              <c:f>Shannon!$B$34</c:f>
              <c:strCache>
                <c:ptCount val="1"/>
                <c:pt idx="0">
                  <c:v>33</c:v>
                </c:pt>
              </c:strCache>
            </c:strRef>
          </c:tx>
          <c:spPr>
            <a:ln w="28575" cap="rnd">
              <a:solidFill>
                <a:schemeClr val="accent3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Shannon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Shannon!$C$34:$L$34</c:f>
              <c:numCache>
                <c:formatCode>General</c:formatCode>
                <c:ptCount val="10"/>
                <c:pt idx="0">
                  <c:v>0</c:v>
                </c:pt>
                <c:pt idx="1">
                  <c:v>7.0864200000000004</c:v>
                </c:pt>
                <c:pt idx="2">
                  <c:v>7.1394700000000002</c:v>
                </c:pt>
                <c:pt idx="3">
                  <c:v>7.1547199999999993</c:v>
                </c:pt>
                <c:pt idx="4">
                  <c:v>7.1579999999999986</c:v>
                </c:pt>
                <c:pt idx="5">
                  <c:v>7.1688999999999989</c:v>
                </c:pt>
                <c:pt idx="6">
                  <c:v>7.166149999999999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0-C492-2D41-9075-880D7E964563}"/>
            </c:ext>
          </c:extLst>
        </c:ser>
        <c:ser>
          <c:idx val="33"/>
          <c:order val="33"/>
          <c:tx>
            <c:strRef>
              <c:f>Shannon!$B$35</c:f>
              <c:strCache>
                <c:ptCount val="1"/>
                <c:pt idx="0">
                  <c:v>34</c:v>
                </c:pt>
              </c:strCache>
            </c:strRef>
          </c:tx>
          <c:spPr>
            <a:ln w="28575" cap="rnd">
              <a:solidFill>
                <a:schemeClr val="accent4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Shannon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Shannon!$C$35:$L$35</c:f>
              <c:numCache>
                <c:formatCode>General</c:formatCode>
                <c:ptCount val="10"/>
                <c:pt idx="0">
                  <c:v>0</c:v>
                </c:pt>
                <c:pt idx="1">
                  <c:v>7.4522899999999996</c:v>
                </c:pt>
                <c:pt idx="2">
                  <c:v>7.5050600000000003</c:v>
                </c:pt>
                <c:pt idx="3">
                  <c:v>7.5195400000000001</c:v>
                </c:pt>
                <c:pt idx="4">
                  <c:v>7.5289199999999994</c:v>
                </c:pt>
                <c:pt idx="5">
                  <c:v>7.5401699999999998</c:v>
                </c:pt>
                <c:pt idx="6">
                  <c:v>7.5462199999999999</c:v>
                </c:pt>
                <c:pt idx="7">
                  <c:v>7.5437799999999999</c:v>
                </c:pt>
                <c:pt idx="8">
                  <c:v>7.5472900000000003</c:v>
                </c:pt>
                <c:pt idx="9">
                  <c:v>7.54738000000000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1-C492-2D41-9075-880D7E964563}"/>
            </c:ext>
          </c:extLst>
        </c:ser>
        <c:ser>
          <c:idx val="34"/>
          <c:order val="34"/>
          <c:tx>
            <c:strRef>
              <c:f>Shannon!#REF!</c:f>
              <c:strCache>
                <c:ptCount val="1"/>
                <c:pt idx="0">
                  <c:v>#REF!</c:v>
                </c:pt>
              </c:strCache>
            </c:strRef>
          </c:tx>
          <c:spPr>
            <a:ln w="28575" cap="rnd">
              <a:solidFill>
                <a:schemeClr val="accent5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Shannon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Shannon!#REF!</c:f>
              <c:numCache>
                <c:formatCode>General</c:formatCode>
                <c:ptCount val="1"/>
                <c:pt idx="0">
                  <c:v>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2-C492-2D41-9075-880D7E96456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-1845158688"/>
        <c:axId val="-1845156480"/>
      </c:lineChart>
      <c:catAx>
        <c:axId val="-18451586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it-IT"/>
          </a:p>
        </c:txPr>
        <c:crossAx val="-1845156480"/>
        <c:crosses val="autoZero"/>
        <c:auto val="1"/>
        <c:lblAlgn val="ctr"/>
        <c:lblOffset val="100"/>
        <c:noMultiLvlLbl val="0"/>
      </c:catAx>
      <c:valAx>
        <c:axId val="-1845156480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extTo"/>
        <c:crossAx val="-184515868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egendEntry>
        <c:idx val="34"/>
        <c:delete val="1"/>
      </c:legendEntry>
      <c:layout>
        <c:manualLayout>
          <c:xMode val="edge"/>
          <c:yMode val="edge"/>
          <c:x val="8.2552126477467395E-3"/>
          <c:y val="0.81318264370328464"/>
          <c:w val="0.97207548119456266"/>
          <c:h val="0.1868173562967153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it-IT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it-IT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599677450736776"/>
          <c:y val="2.2078586594051604E-2"/>
          <c:w val="0.87406948998058587"/>
          <c:h val="0.49942864417938404"/>
        </c:manualLayout>
      </c:layout>
      <c:lineChart>
        <c:grouping val="standard"/>
        <c:varyColors val="0"/>
        <c:ser>
          <c:idx val="0"/>
          <c:order val="0"/>
          <c:tx>
            <c:strRef>
              <c:f>Chao1!$B$2</c:f>
              <c:strCache>
                <c:ptCount val="1"/>
                <c:pt idx="0">
                  <c:v>1C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numRef>
              <c:f>Chao1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Chao1!$C$2:$L$2</c:f>
              <c:numCache>
                <c:formatCode>General</c:formatCode>
                <c:ptCount val="10"/>
                <c:pt idx="0">
                  <c:v>1</c:v>
                </c:pt>
                <c:pt idx="1">
                  <c:v>565.16899999999998</c:v>
                </c:pt>
                <c:pt idx="2">
                  <c:v>600.21</c:v>
                </c:pt>
                <c:pt idx="3">
                  <c:v>618.57799999999997</c:v>
                </c:pt>
                <c:pt idx="4">
                  <c:v>618.23299999999983</c:v>
                </c:pt>
                <c:pt idx="5">
                  <c:v>618.75199999999984</c:v>
                </c:pt>
                <c:pt idx="6">
                  <c:v>619.0619999999999</c:v>
                </c:pt>
                <c:pt idx="7">
                  <c:v>621.28599999999994</c:v>
                </c:pt>
                <c:pt idx="8">
                  <c:v>621.32699999999988</c:v>
                </c:pt>
                <c:pt idx="9">
                  <c:v>620.183999999999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6E0-454B-9B66-54C094B8C331}"/>
            </c:ext>
          </c:extLst>
        </c:ser>
        <c:ser>
          <c:idx val="1"/>
          <c:order val="1"/>
          <c:tx>
            <c:strRef>
              <c:f>Chao1!$B$3</c:f>
              <c:strCache>
                <c:ptCount val="1"/>
                <c:pt idx="0">
                  <c:v>2C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numRef>
              <c:f>Chao1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Chao1!$C$3:$L$3</c:f>
              <c:numCache>
                <c:formatCode>General</c:formatCode>
                <c:ptCount val="10"/>
                <c:pt idx="0">
                  <c:v>1</c:v>
                </c:pt>
                <c:pt idx="1">
                  <c:v>647.68200000000002</c:v>
                </c:pt>
                <c:pt idx="2">
                  <c:v>683.32499999999993</c:v>
                </c:pt>
                <c:pt idx="3">
                  <c:v>709.76099999999997</c:v>
                </c:pt>
                <c:pt idx="4">
                  <c:v>718.95199999999988</c:v>
                </c:pt>
                <c:pt idx="5">
                  <c:v>730.87199999999996</c:v>
                </c:pt>
                <c:pt idx="6">
                  <c:v>731.17499999999995</c:v>
                </c:pt>
                <c:pt idx="7">
                  <c:v>731.70100000000002</c:v>
                </c:pt>
                <c:pt idx="8">
                  <c:v>726.35599999999988</c:v>
                </c:pt>
                <c:pt idx="9">
                  <c:v>727.597999999999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C6E0-454B-9B66-54C094B8C331}"/>
            </c:ext>
          </c:extLst>
        </c:ser>
        <c:ser>
          <c:idx val="2"/>
          <c:order val="2"/>
          <c:tx>
            <c:strRef>
              <c:f>Chao1!$B$4</c:f>
              <c:strCache>
                <c:ptCount val="1"/>
                <c:pt idx="0">
                  <c:v>3C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cat>
            <c:numRef>
              <c:f>Chao1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Chao1!$C$4:$L$4</c:f>
              <c:numCache>
                <c:formatCode>General</c:formatCode>
                <c:ptCount val="10"/>
                <c:pt idx="0">
                  <c:v>1</c:v>
                </c:pt>
                <c:pt idx="1">
                  <c:v>325.84199999999993</c:v>
                </c:pt>
                <c:pt idx="2">
                  <c:v>339.62299999999999</c:v>
                </c:pt>
                <c:pt idx="3">
                  <c:v>352.09599999999989</c:v>
                </c:pt>
                <c:pt idx="4">
                  <c:v>354.31900000000002</c:v>
                </c:pt>
                <c:pt idx="5">
                  <c:v>357.464</c:v>
                </c:pt>
                <c:pt idx="6">
                  <c:v>355.80099999999999</c:v>
                </c:pt>
                <c:pt idx="7">
                  <c:v>356.35599999999999</c:v>
                </c:pt>
                <c:pt idx="8">
                  <c:v>357.21199999999988</c:v>
                </c:pt>
                <c:pt idx="9">
                  <c:v>358.877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C6E0-454B-9B66-54C094B8C331}"/>
            </c:ext>
          </c:extLst>
        </c:ser>
        <c:ser>
          <c:idx val="3"/>
          <c:order val="3"/>
          <c:tx>
            <c:strRef>
              <c:f>Chao1!$B$5</c:f>
              <c:strCache>
                <c:ptCount val="1"/>
                <c:pt idx="0">
                  <c:v>4C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cat>
            <c:numRef>
              <c:f>Chao1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Chao1!$C$5:$L$5</c:f>
              <c:numCache>
                <c:formatCode>General</c:formatCode>
                <c:ptCount val="10"/>
                <c:pt idx="0">
                  <c:v>1</c:v>
                </c:pt>
                <c:pt idx="1">
                  <c:v>301.37799999999999</c:v>
                </c:pt>
                <c:pt idx="2">
                  <c:v>319.45999999999992</c:v>
                </c:pt>
                <c:pt idx="3">
                  <c:v>325.17500000000001</c:v>
                </c:pt>
                <c:pt idx="4">
                  <c:v>325.77199999999988</c:v>
                </c:pt>
                <c:pt idx="5">
                  <c:v>327.84300000000002</c:v>
                </c:pt>
                <c:pt idx="6">
                  <c:v>328.45</c:v>
                </c:pt>
                <c:pt idx="7">
                  <c:v>328.24700000000001</c:v>
                </c:pt>
                <c:pt idx="8">
                  <c:v>330.28199999999993</c:v>
                </c:pt>
                <c:pt idx="9">
                  <c:v>329.1840000000000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C6E0-454B-9B66-54C094B8C331}"/>
            </c:ext>
          </c:extLst>
        </c:ser>
        <c:ser>
          <c:idx val="4"/>
          <c:order val="4"/>
          <c:tx>
            <c:strRef>
              <c:f>Chao1!$B$6</c:f>
              <c:strCache>
                <c:ptCount val="1"/>
                <c:pt idx="0">
                  <c:v>5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none"/>
          </c:marker>
          <c:cat>
            <c:numRef>
              <c:f>Chao1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Chao1!$C$6:$L$6</c:f>
              <c:numCache>
                <c:formatCode>General</c:formatCode>
                <c:ptCount val="10"/>
                <c:pt idx="0">
                  <c:v>1</c:v>
                </c:pt>
                <c:pt idx="1">
                  <c:v>344.53800000000001</c:v>
                </c:pt>
                <c:pt idx="2">
                  <c:v>368.04</c:v>
                </c:pt>
                <c:pt idx="3">
                  <c:v>367.512</c:v>
                </c:pt>
                <c:pt idx="4">
                  <c:v>367.69799999999992</c:v>
                </c:pt>
                <c:pt idx="5">
                  <c:v>364.70600000000002</c:v>
                </c:pt>
                <c:pt idx="6">
                  <c:v>364.9429999999999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C6E0-454B-9B66-54C094B8C331}"/>
            </c:ext>
          </c:extLst>
        </c:ser>
        <c:ser>
          <c:idx val="5"/>
          <c:order val="5"/>
          <c:tx>
            <c:strRef>
              <c:f>Chao1!$B$7</c:f>
              <c:strCache>
                <c:ptCount val="1"/>
                <c:pt idx="0">
                  <c:v>6</c:v>
                </c:pt>
              </c:strCache>
            </c:strRef>
          </c:tx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none"/>
          </c:marker>
          <c:cat>
            <c:numRef>
              <c:f>Chao1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Chao1!$C$7:$L$7</c:f>
              <c:numCache>
                <c:formatCode>General</c:formatCode>
                <c:ptCount val="10"/>
                <c:pt idx="0">
                  <c:v>1</c:v>
                </c:pt>
                <c:pt idx="1">
                  <c:v>371.01499999999999</c:v>
                </c:pt>
                <c:pt idx="2">
                  <c:v>385.87900000000002</c:v>
                </c:pt>
                <c:pt idx="3">
                  <c:v>390.38799999999992</c:v>
                </c:pt>
                <c:pt idx="4">
                  <c:v>390.80599999999993</c:v>
                </c:pt>
                <c:pt idx="5">
                  <c:v>396.19600000000003</c:v>
                </c:pt>
                <c:pt idx="6">
                  <c:v>393.81</c:v>
                </c:pt>
                <c:pt idx="7">
                  <c:v>392.68599999999992</c:v>
                </c:pt>
                <c:pt idx="8">
                  <c:v>39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C6E0-454B-9B66-54C094B8C331}"/>
            </c:ext>
          </c:extLst>
        </c:ser>
        <c:ser>
          <c:idx val="6"/>
          <c:order val="6"/>
          <c:tx>
            <c:strRef>
              <c:f>Chao1!$B$8</c:f>
              <c:strCache>
                <c:ptCount val="1"/>
                <c:pt idx="0">
                  <c:v>7</c:v>
                </c:pt>
              </c:strCache>
            </c:strRef>
          </c:tx>
          <c:spPr>
            <a:ln w="28575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Chao1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Chao1!$C$8:$L$8</c:f>
              <c:numCache>
                <c:formatCode>General</c:formatCode>
                <c:ptCount val="10"/>
                <c:pt idx="0">
                  <c:v>1</c:v>
                </c:pt>
                <c:pt idx="1">
                  <c:v>396.69499999999999</c:v>
                </c:pt>
                <c:pt idx="2">
                  <c:v>418.572</c:v>
                </c:pt>
                <c:pt idx="3">
                  <c:v>425.58</c:v>
                </c:pt>
                <c:pt idx="4">
                  <c:v>427.822</c:v>
                </c:pt>
                <c:pt idx="5">
                  <c:v>427.05799999999999</c:v>
                </c:pt>
                <c:pt idx="6">
                  <c:v>424.19299999999993</c:v>
                </c:pt>
                <c:pt idx="7">
                  <c:v>426.10599999999999</c:v>
                </c:pt>
                <c:pt idx="8">
                  <c:v>425.29199999999992</c:v>
                </c:pt>
                <c:pt idx="9">
                  <c:v>426.285000000000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C6E0-454B-9B66-54C094B8C331}"/>
            </c:ext>
          </c:extLst>
        </c:ser>
        <c:ser>
          <c:idx val="7"/>
          <c:order val="7"/>
          <c:tx>
            <c:strRef>
              <c:f>Chao1!$B$9</c:f>
              <c:strCache>
                <c:ptCount val="1"/>
                <c:pt idx="0">
                  <c:v>8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Chao1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Chao1!$C$9:$L$9</c:f>
              <c:numCache>
                <c:formatCode>General</c:formatCode>
                <c:ptCount val="10"/>
                <c:pt idx="0">
                  <c:v>1</c:v>
                </c:pt>
                <c:pt idx="1">
                  <c:v>320.67200000000008</c:v>
                </c:pt>
                <c:pt idx="2">
                  <c:v>328.69799999999992</c:v>
                </c:pt>
                <c:pt idx="3">
                  <c:v>331.18599999999992</c:v>
                </c:pt>
                <c:pt idx="4">
                  <c:v>329.79199999999992</c:v>
                </c:pt>
                <c:pt idx="5">
                  <c:v>329.49900000000002</c:v>
                </c:pt>
                <c:pt idx="6">
                  <c:v>329.0779999999999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C6E0-454B-9B66-54C094B8C331}"/>
            </c:ext>
          </c:extLst>
        </c:ser>
        <c:ser>
          <c:idx val="8"/>
          <c:order val="8"/>
          <c:tx>
            <c:strRef>
              <c:f>Chao1!$B$10</c:f>
              <c:strCache>
                <c:ptCount val="1"/>
                <c:pt idx="0">
                  <c:v>9</c:v>
                </c:pt>
              </c:strCache>
            </c:strRef>
          </c:tx>
          <c:spPr>
            <a:ln w="28575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Chao1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Chao1!$C$10:$L$10</c:f>
              <c:numCache>
                <c:formatCode>General</c:formatCode>
                <c:ptCount val="10"/>
                <c:pt idx="0">
                  <c:v>1</c:v>
                </c:pt>
                <c:pt idx="1">
                  <c:v>396.72</c:v>
                </c:pt>
                <c:pt idx="2">
                  <c:v>410.399</c:v>
                </c:pt>
                <c:pt idx="3">
                  <c:v>418.97699999999992</c:v>
                </c:pt>
                <c:pt idx="4">
                  <c:v>417.767</c:v>
                </c:pt>
                <c:pt idx="5">
                  <c:v>417.673</c:v>
                </c:pt>
                <c:pt idx="6">
                  <c:v>417.62200000000001</c:v>
                </c:pt>
                <c:pt idx="7">
                  <c:v>417.22</c:v>
                </c:pt>
                <c:pt idx="8">
                  <c:v>41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C6E0-454B-9B66-54C094B8C331}"/>
            </c:ext>
          </c:extLst>
        </c:ser>
        <c:ser>
          <c:idx val="9"/>
          <c:order val="9"/>
          <c:tx>
            <c:strRef>
              <c:f>Chao1!$B$11</c:f>
              <c:strCache>
                <c:ptCount val="1"/>
                <c:pt idx="0">
                  <c:v>10</c:v>
                </c:pt>
              </c:strCache>
            </c:strRef>
          </c:tx>
          <c:spPr>
            <a:ln w="28575" cap="rnd">
              <a:solidFill>
                <a:schemeClr val="accent4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Chao1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Chao1!$C$11:$L$11</c:f>
              <c:numCache>
                <c:formatCode>General</c:formatCode>
                <c:ptCount val="10"/>
                <c:pt idx="0">
                  <c:v>1</c:v>
                </c:pt>
                <c:pt idx="1">
                  <c:v>437.99</c:v>
                </c:pt>
                <c:pt idx="2">
                  <c:v>453.28300000000002</c:v>
                </c:pt>
                <c:pt idx="3">
                  <c:v>452.98399999999992</c:v>
                </c:pt>
                <c:pt idx="4">
                  <c:v>457.71499999999992</c:v>
                </c:pt>
                <c:pt idx="5">
                  <c:v>457.91599999999988</c:v>
                </c:pt>
                <c:pt idx="6">
                  <c:v>458.12900000000002</c:v>
                </c:pt>
                <c:pt idx="7">
                  <c:v>456.70600000000002</c:v>
                </c:pt>
                <c:pt idx="8">
                  <c:v>456.65699999999993</c:v>
                </c:pt>
                <c:pt idx="9">
                  <c:v>456.08100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C6E0-454B-9B66-54C094B8C331}"/>
            </c:ext>
          </c:extLst>
        </c:ser>
        <c:ser>
          <c:idx val="10"/>
          <c:order val="10"/>
          <c:tx>
            <c:strRef>
              <c:f>Chao1!$B$12</c:f>
              <c:strCache>
                <c:ptCount val="1"/>
                <c:pt idx="0">
                  <c:v>11</c:v>
                </c:pt>
              </c:strCache>
            </c:strRef>
          </c:tx>
          <c:spPr>
            <a:ln w="28575" cap="rnd">
              <a:solidFill>
                <a:schemeClr val="accent5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Chao1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Chao1!$C$12:$L$12</c:f>
              <c:numCache>
                <c:formatCode>General</c:formatCode>
                <c:ptCount val="10"/>
                <c:pt idx="0">
                  <c:v>1</c:v>
                </c:pt>
                <c:pt idx="1">
                  <c:v>330.31299999999999</c:v>
                </c:pt>
                <c:pt idx="2">
                  <c:v>342.08</c:v>
                </c:pt>
                <c:pt idx="3">
                  <c:v>350.01100000000002</c:v>
                </c:pt>
                <c:pt idx="4">
                  <c:v>351.10899999999992</c:v>
                </c:pt>
                <c:pt idx="5">
                  <c:v>351.09100000000001</c:v>
                </c:pt>
                <c:pt idx="6">
                  <c:v>350.74099999999999</c:v>
                </c:pt>
                <c:pt idx="7">
                  <c:v>350.93299999999988</c:v>
                </c:pt>
                <c:pt idx="8">
                  <c:v>351.62599999999992</c:v>
                </c:pt>
                <c:pt idx="9">
                  <c:v>351.384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A-C6E0-454B-9B66-54C094B8C331}"/>
            </c:ext>
          </c:extLst>
        </c:ser>
        <c:ser>
          <c:idx val="11"/>
          <c:order val="11"/>
          <c:tx>
            <c:strRef>
              <c:f>Chao1!$B$13</c:f>
              <c:strCache>
                <c:ptCount val="1"/>
                <c:pt idx="0">
                  <c:v>12</c:v>
                </c:pt>
              </c:strCache>
            </c:strRef>
          </c:tx>
          <c:spPr>
            <a:ln w="28575" cap="rnd">
              <a:solidFill>
                <a:schemeClr val="accent6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Chao1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Chao1!$C$13:$L$13</c:f>
              <c:numCache>
                <c:formatCode>General</c:formatCode>
                <c:ptCount val="10"/>
                <c:pt idx="0">
                  <c:v>1</c:v>
                </c:pt>
                <c:pt idx="1">
                  <c:v>466.584</c:v>
                </c:pt>
                <c:pt idx="2">
                  <c:v>487.88499999999999</c:v>
                </c:pt>
                <c:pt idx="3">
                  <c:v>491.06099999999992</c:v>
                </c:pt>
                <c:pt idx="4">
                  <c:v>490.27300000000002</c:v>
                </c:pt>
                <c:pt idx="5">
                  <c:v>489.72800000000001</c:v>
                </c:pt>
                <c:pt idx="6">
                  <c:v>489.303</c:v>
                </c:pt>
                <c:pt idx="7">
                  <c:v>48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B-C6E0-454B-9B66-54C094B8C331}"/>
            </c:ext>
          </c:extLst>
        </c:ser>
        <c:ser>
          <c:idx val="12"/>
          <c:order val="12"/>
          <c:tx>
            <c:strRef>
              <c:f>Chao1!$B$14</c:f>
              <c:strCache>
                <c:ptCount val="1"/>
                <c:pt idx="0">
                  <c:v>13</c:v>
                </c:pt>
              </c:strCache>
            </c:strRef>
          </c:tx>
          <c:spPr>
            <a:ln w="28575" cap="rnd">
              <a:solidFill>
                <a:schemeClr val="accent1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Chao1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Chao1!$C$14:$L$14</c:f>
              <c:numCache>
                <c:formatCode>General</c:formatCode>
                <c:ptCount val="10"/>
                <c:pt idx="0">
                  <c:v>1</c:v>
                </c:pt>
                <c:pt idx="1">
                  <c:v>432.75299999999999</c:v>
                </c:pt>
                <c:pt idx="2">
                  <c:v>460.79700000000003</c:v>
                </c:pt>
                <c:pt idx="3">
                  <c:v>464.34199999999993</c:v>
                </c:pt>
                <c:pt idx="4">
                  <c:v>462.63400000000001</c:v>
                </c:pt>
                <c:pt idx="5">
                  <c:v>463.78199999999993</c:v>
                </c:pt>
                <c:pt idx="6">
                  <c:v>462.25700000000001</c:v>
                </c:pt>
                <c:pt idx="7">
                  <c:v>461.64499999999998</c:v>
                </c:pt>
                <c:pt idx="8">
                  <c:v>46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C-C6E0-454B-9B66-54C094B8C331}"/>
            </c:ext>
          </c:extLst>
        </c:ser>
        <c:ser>
          <c:idx val="13"/>
          <c:order val="13"/>
          <c:tx>
            <c:strRef>
              <c:f>Chao1!$B$15</c:f>
              <c:strCache>
                <c:ptCount val="1"/>
                <c:pt idx="0">
                  <c:v>14</c:v>
                </c:pt>
              </c:strCache>
            </c:strRef>
          </c:tx>
          <c:spPr>
            <a:ln w="28575" cap="rnd">
              <a:solidFill>
                <a:schemeClr val="accent2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Chao1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Chao1!$C$15:$L$15</c:f>
              <c:numCache>
                <c:formatCode>General</c:formatCode>
                <c:ptCount val="10"/>
                <c:pt idx="0">
                  <c:v>1</c:v>
                </c:pt>
                <c:pt idx="1">
                  <c:v>384.1</c:v>
                </c:pt>
                <c:pt idx="2">
                  <c:v>412.00299999999999</c:v>
                </c:pt>
                <c:pt idx="3">
                  <c:v>413.92599999999987</c:v>
                </c:pt>
                <c:pt idx="4">
                  <c:v>414.59699999999992</c:v>
                </c:pt>
                <c:pt idx="5">
                  <c:v>414.50799999999992</c:v>
                </c:pt>
                <c:pt idx="6">
                  <c:v>413.57299999999992</c:v>
                </c:pt>
                <c:pt idx="7">
                  <c:v>412.99200000000002</c:v>
                </c:pt>
                <c:pt idx="8">
                  <c:v>413.11200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D-C6E0-454B-9B66-54C094B8C331}"/>
            </c:ext>
          </c:extLst>
        </c:ser>
        <c:ser>
          <c:idx val="14"/>
          <c:order val="14"/>
          <c:tx>
            <c:strRef>
              <c:f>Chao1!$B$16</c:f>
              <c:strCache>
                <c:ptCount val="1"/>
                <c:pt idx="0">
                  <c:v>15</c:v>
                </c:pt>
              </c:strCache>
            </c:strRef>
          </c:tx>
          <c:spPr>
            <a:ln w="28575" cap="rnd">
              <a:solidFill>
                <a:schemeClr val="accent3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Chao1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Chao1!$C$16:$L$16</c:f>
              <c:numCache>
                <c:formatCode>General</c:formatCode>
                <c:ptCount val="10"/>
                <c:pt idx="0">
                  <c:v>1</c:v>
                </c:pt>
                <c:pt idx="1">
                  <c:v>438.07299999999992</c:v>
                </c:pt>
                <c:pt idx="2">
                  <c:v>450.69200000000001</c:v>
                </c:pt>
                <c:pt idx="3">
                  <c:v>461.80700000000002</c:v>
                </c:pt>
                <c:pt idx="4">
                  <c:v>466.58</c:v>
                </c:pt>
                <c:pt idx="5">
                  <c:v>464.45600000000002</c:v>
                </c:pt>
                <c:pt idx="6">
                  <c:v>465.41799999999989</c:v>
                </c:pt>
                <c:pt idx="7">
                  <c:v>465.27800000000002</c:v>
                </c:pt>
                <c:pt idx="8">
                  <c:v>464.96300000000002</c:v>
                </c:pt>
                <c:pt idx="9">
                  <c:v>465.03300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E-C6E0-454B-9B66-54C094B8C331}"/>
            </c:ext>
          </c:extLst>
        </c:ser>
        <c:ser>
          <c:idx val="15"/>
          <c:order val="15"/>
          <c:tx>
            <c:strRef>
              <c:f>Chao1!$B$17</c:f>
              <c:strCache>
                <c:ptCount val="1"/>
                <c:pt idx="0">
                  <c:v>16</c:v>
                </c:pt>
              </c:strCache>
            </c:strRef>
          </c:tx>
          <c:spPr>
            <a:ln w="28575" cap="rnd">
              <a:solidFill>
                <a:schemeClr val="accent4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Chao1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Chao1!$C$17:$L$17</c:f>
              <c:numCache>
                <c:formatCode>General</c:formatCode>
                <c:ptCount val="10"/>
                <c:pt idx="0">
                  <c:v>1</c:v>
                </c:pt>
                <c:pt idx="1">
                  <c:v>321.21199999999988</c:v>
                </c:pt>
                <c:pt idx="2">
                  <c:v>335.30200000000002</c:v>
                </c:pt>
                <c:pt idx="3">
                  <c:v>339.11200000000002</c:v>
                </c:pt>
                <c:pt idx="4">
                  <c:v>344.322</c:v>
                </c:pt>
                <c:pt idx="5">
                  <c:v>347.49299999999988</c:v>
                </c:pt>
                <c:pt idx="6">
                  <c:v>349.42299999999989</c:v>
                </c:pt>
                <c:pt idx="7">
                  <c:v>347.92999999999989</c:v>
                </c:pt>
                <c:pt idx="8">
                  <c:v>349.09100000000001</c:v>
                </c:pt>
                <c:pt idx="9">
                  <c:v>348.557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F-C6E0-454B-9B66-54C094B8C331}"/>
            </c:ext>
          </c:extLst>
        </c:ser>
        <c:ser>
          <c:idx val="16"/>
          <c:order val="16"/>
          <c:tx>
            <c:strRef>
              <c:f>Chao1!$B$18</c:f>
              <c:strCache>
                <c:ptCount val="1"/>
                <c:pt idx="0">
                  <c:v>17</c:v>
                </c:pt>
              </c:strCache>
            </c:strRef>
          </c:tx>
          <c:spPr>
            <a:ln w="28575" cap="rnd">
              <a:solidFill>
                <a:schemeClr val="accent5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Chao1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Chao1!$C$18:$L$18</c:f>
              <c:numCache>
                <c:formatCode>General</c:formatCode>
                <c:ptCount val="10"/>
                <c:pt idx="0">
                  <c:v>1</c:v>
                </c:pt>
                <c:pt idx="1">
                  <c:v>347.42700000000002</c:v>
                </c:pt>
                <c:pt idx="2">
                  <c:v>357.42399999999992</c:v>
                </c:pt>
                <c:pt idx="3">
                  <c:v>364.23200000000003</c:v>
                </c:pt>
                <c:pt idx="4">
                  <c:v>365.44099999999992</c:v>
                </c:pt>
                <c:pt idx="5">
                  <c:v>363.73599999999988</c:v>
                </c:pt>
                <c:pt idx="6">
                  <c:v>366.17899999999992</c:v>
                </c:pt>
                <c:pt idx="7">
                  <c:v>365.21600000000001</c:v>
                </c:pt>
                <c:pt idx="8">
                  <c:v>365.07</c:v>
                </c:pt>
                <c:pt idx="9">
                  <c:v>365.0339999999998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0-C6E0-454B-9B66-54C094B8C331}"/>
            </c:ext>
          </c:extLst>
        </c:ser>
        <c:ser>
          <c:idx val="17"/>
          <c:order val="17"/>
          <c:tx>
            <c:strRef>
              <c:f>Chao1!$B$19</c:f>
              <c:strCache>
                <c:ptCount val="1"/>
                <c:pt idx="0">
                  <c:v>18</c:v>
                </c:pt>
              </c:strCache>
            </c:strRef>
          </c:tx>
          <c:spPr>
            <a:ln w="28575" cap="rnd">
              <a:solidFill>
                <a:schemeClr val="accent6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Chao1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Chao1!$C$19:$L$19</c:f>
              <c:numCache>
                <c:formatCode>General</c:formatCode>
                <c:ptCount val="10"/>
                <c:pt idx="0">
                  <c:v>1</c:v>
                </c:pt>
                <c:pt idx="1">
                  <c:v>414.66500000000002</c:v>
                </c:pt>
                <c:pt idx="2">
                  <c:v>437.05599999999993</c:v>
                </c:pt>
                <c:pt idx="3">
                  <c:v>439.245</c:v>
                </c:pt>
                <c:pt idx="4">
                  <c:v>442.70299999999992</c:v>
                </c:pt>
                <c:pt idx="5">
                  <c:v>441.06400000000002</c:v>
                </c:pt>
                <c:pt idx="6">
                  <c:v>441.19200000000001</c:v>
                </c:pt>
                <c:pt idx="7">
                  <c:v>442.42</c:v>
                </c:pt>
                <c:pt idx="8">
                  <c:v>442.32400000000001</c:v>
                </c:pt>
                <c:pt idx="9">
                  <c:v>441.7209999999998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1-C6E0-454B-9B66-54C094B8C331}"/>
            </c:ext>
          </c:extLst>
        </c:ser>
        <c:ser>
          <c:idx val="18"/>
          <c:order val="18"/>
          <c:tx>
            <c:strRef>
              <c:f>Chao1!$B$20</c:f>
              <c:strCache>
                <c:ptCount val="1"/>
                <c:pt idx="0">
                  <c:v>19</c:v>
                </c:pt>
              </c:strCache>
            </c:strRef>
          </c:tx>
          <c:spPr>
            <a:ln w="28575" cap="rnd">
              <a:solidFill>
                <a:schemeClr val="accent1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Chao1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Chao1!$C$20:$L$20</c:f>
              <c:numCache>
                <c:formatCode>General</c:formatCode>
                <c:ptCount val="10"/>
                <c:pt idx="0">
                  <c:v>1</c:v>
                </c:pt>
                <c:pt idx="1">
                  <c:v>424.34399999999999</c:v>
                </c:pt>
                <c:pt idx="2">
                  <c:v>445.75799999999992</c:v>
                </c:pt>
                <c:pt idx="3">
                  <c:v>453.97599999999989</c:v>
                </c:pt>
                <c:pt idx="4">
                  <c:v>458.529</c:v>
                </c:pt>
                <c:pt idx="5">
                  <c:v>459.29099999999988</c:v>
                </c:pt>
                <c:pt idx="6">
                  <c:v>459.61099999999999</c:v>
                </c:pt>
                <c:pt idx="7">
                  <c:v>458.57299999999992</c:v>
                </c:pt>
                <c:pt idx="8">
                  <c:v>458.32400000000001</c:v>
                </c:pt>
                <c:pt idx="9">
                  <c:v>45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2-C6E0-454B-9B66-54C094B8C331}"/>
            </c:ext>
          </c:extLst>
        </c:ser>
        <c:ser>
          <c:idx val="19"/>
          <c:order val="19"/>
          <c:tx>
            <c:strRef>
              <c:f>Chao1!$B$21</c:f>
              <c:strCache>
                <c:ptCount val="1"/>
                <c:pt idx="0">
                  <c:v>20</c:v>
                </c:pt>
              </c:strCache>
            </c:strRef>
          </c:tx>
          <c:spPr>
            <a:ln w="28575" cap="rnd">
              <a:solidFill>
                <a:schemeClr val="accent2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Chao1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Chao1!$C$21:$L$21</c:f>
              <c:numCache>
                <c:formatCode>General</c:formatCode>
                <c:ptCount val="10"/>
                <c:pt idx="0">
                  <c:v>1</c:v>
                </c:pt>
                <c:pt idx="1">
                  <c:v>364.32799999999992</c:v>
                </c:pt>
                <c:pt idx="2">
                  <c:v>381.38200000000001</c:v>
                </c:pt>
                <c:pt idx="3">
                  <c:v>391.46300000000002</c:v>
                </c:pt>
                <c:pt idx="4">
                  <c:v>392.40899999999988</c:v>
                </c:pt>
                <c:pt idx="5">
                  <c:v>393.41799999999989</c:v>
                </c:pt>
                <c:pt idx="6">
                  <c:v>397.32600000000002</c:v>
                </c:pt>
                <c:pt idx="7">
                  <c:v>396.00400000000002</c:v>
                </c:pt>
                <c:pt idx="8">
                  <c:v>396.52199999999988</c:v>
                </c:pt>
                <c:pt idx="9">
                  <c:v>397.259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3-C6E0-454B-9B66-54C094B8C331}"/>
            </c:ext>
          </c:extLst>
        </c:ser>
        <c:ser>
          <c:idx val="20"/>
          <c:order val="20"/>
          <c:tx>
            <c:strRef>
              <c:f>Chao1!$B$22</c:f>
              <c:strCache>
                <c:ptCount val="1"/>
                <c:pt idx="0">
                  <c:v>21</c:v>
                </c:pt>
              </c:strCache>
            </c:strRef>
          </c:tx>
          <c:spPr>
            <a:ln w="28575" cap="rnd">
              <a:solidFill>
                <a:schemeClr val="accent3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Chao1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Chao1!$C$22:$L$22</c:f>
              <c:numCache>
                <c:formatCode>General</c:formatCode>
                <c:ptCount val="10"/>
                <c:pt idx="0">
                  <c:v>1</c:v>
                </c:pt>
                <c:pt idx="1">
                  <c:v>423.51900000000001</c:v>
                </c:pt>
                <c:pt idx="2">
                  <c:v>447.25099999999992</c:v>
                </c:pt>
                <c:pt idx="3">
                  <c:v>456.85899999999992</c:v>
                </c:pt>
                <c:pt idx="4">
                  <c:v>458.74200000000002</c:v>
                </c:pt>
                <c:pt idx="5">
                  <c:v>461.48599999999988</c:v>
                </c:pt>
                <c:pt idx="6">
                  <c:v>460.13099999999991</c:v>
                </c:pt>
                <c:pt idx="7">
                  <c:v>458.82799999999992</c:v>
                </c:pt>
                <c:pt idx="8">
                  <c:v>460.71300000000002</c:v>
                </c:pt>
                <c:pt idx="9">
                  <c:v>459.675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4-C6E0-454B-9B66-54C094B8C331}"/>
            </c:ext>
          </c:extLst>
        </c:ser>
        <c:ser>
          <c:idx val="21"/>
          <c:order val="21"/>
          <c:tx>
            <c:strRef>
              <c:f>Chao1!$B$23</c:f>
              <c:strCache>
                <c:ptCount val="1"/>
                <c:pt idx="0">
                  <c:v>22</c:v>
                </c:pt>
              </c:strCache>
            </c:strRef>
          </c:tx>
          <c:spPr>
            <a:ln w="28575" cap="rnd">
              <a:solidFill>
                <a:schemeClr val="accent4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Chao1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Chao1!$C$23:$L$23</c:f>
              <c:numCache>
                <c:formatCode>General</c:formatCode>
                <c:ptCount val="10"/>
                <c:pt idx="0">
                  <c:v>1</c:v>
                </c:pt>
                <c:pt idx="1">
                  <c:v>349.23</c:v>
                </c:pt>
                <c:pt idx="2">
                  <c:v>368.8</c:v>
                </c:pt>
                <c:pt idx="3">
                  <c:v>381.13200000000001</c:v>
                </c:pt>
                <c:pt idx="4">
                  <c:v>379.37099999999992</c:v>
                </c:pt>
                <c:pt idx="5">
                  <c:v>379.55399999999992</c:v>
                </c:pt>
                <c:pt idx="6">
                  <c:v>380.42599999999987</c:v>
                </c:pt>
                <c:pt idx="7">
                  <c:v>379.613</c:v>
                </c:pt>
                <c:pt idx="8">
                  <c:v>379.22599999999989</c:v>
                </c:pt>
                <c:pt idx="9">
                  <c:v>379.043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5-C6E0-454B-9B66-54C094B8C331}"/>
            </c:ext>
          </c:extLst>
        </c:ser>
        <c:ser>
          <c:idx val="22"/>
          <c:order val="22"/>
          <c:tx>
            <c:strRef>
              <c:f>Chao1!$B$24</c:f>
              <c:strCache>
                <c:ptCount val="1"/>
                <c:pt idx="0">
                  <c:v>23</c:v>
                </c:pt>
              </c:strCache>
            </c:strRef>
          </c:tx>
          <c:spPr>
            <a:ln w="28575" cap="rnd">
              <a:solidFill>
                <a:schemeClr val="accent5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Chao1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Chao1!$C$24:$L$24</c:f>
              <c:numCache>
                <c:formatCode>General</c:formatCode>
                <c:ptCount val="10"/>
                <c:pt idx="0">
                  <c:v>1</c:v>
                </c:pt>
                <c:pt idx="1">
                  <c:v>361.94400000000002</c:v>
                </c:pt>
                <c:pt idx="2">
                  <c:v>379.09800000000001</c:v>
                </c:pt>
                <c:pt idx="3">
                  <c:v>376.17099999999999</c:v>
                </c:pt>
                <c:pt idx="4">
                  <c:v>378.70600000000002</c:v>
                </c:pt>
                <c:pt idx="5">
                  <c:v>379.73899999999992</c:v>
                </c:pt>
                <c:pt idx="6">
                  <c:v>379.18299999999999</c:v>
                </c:pt>
                <c:pt idx="7">
                  <c:v>379.82</c:v>
                </c:pt>
                <c:pt idx="8">
                  <c:v>379.964</c:v>
                </c:pt>
                <c:pt idx="9">
                  <c:v>379.0989999999998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6-C6E0-454B-9B66-54C094B8C331}"/>
            </c:ext>
          </c:extLst>
        </c:ser>
        <c:ser>
          <c:idx val="23"/>
          <c:order val="23"/>
          <c:tx>
            <c:strRef>
              <c:f>Chao1!$B$25</c:f>
              <c:strCache>
                <c:ptCount val="1"/>
                <c:pt idx="0">
                  <c:v>24</c:v>
                </c:pt>
              </c:strCache>
            </c:strRef>
          </c:tx>
          <c:spPr>
            <a:ln w="28575" cap="rnd">
              <a:solidFill>
                <a:schemeClr val="accent6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Chao1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Chao1!$C$25:$L$25</c:f>
              <c:numCache>
                <c:formatCode>General</c:formatCode>
                <c:ptCount val="10"/>
                <c:pt idx="0">
                  <c:v>1</c:v>
                </c:pt>
                <c:pt idx="1">
                  <c:v>445.50799999999992</c:v>
                </c:pt>
                <c:pt idx="2">
                  <c:v>465.57499999999999</c:v>
                </c:pt>
                <c:pt idx="3">
                  <c:v>468.43599999999992</c:v>
                </c:pt>
                <c:pt idx="4">
                  <c:v>467.80799999999999</c:v>
                </c:pt>
                <c:pt idx="5">
                  <c:v>468.47099999999989</c:v>
                </c:pt>
                <c:pt idx="6">
                  <c:v>468.26900000000001</c:v>
                </c:pt>
                <c:pt idx="7">
                  <c:v>468.02100000000002</c:v>
                </c:pt>
                <c:pt idx="8">
                  <c:v>468.08699999999988</c:v>
                </c:pt>
                <c:pt idx="9">
                  <c:v>468.0369999999999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7-C6E0-454B-9B66-54C094B8C331}"/>
            </c:ext>
          </c:extLst>
        </c:ser>
        <c:ser>
          <c:idx val="24"/>
          <c:order val="24"/>
          <c:tx>
            <c:strRef>
              <c:f>Chao1!$B$26</c:f>
              <c:strCache>
                <c:ptCount val="1"/>
                <c:pt idx="0">
                  <c:v>25</c:v>
                </c:pt>
              </c:strCache>
            </c:strRef>
          </c:tx>
          <c:spPr>
            <a:ln w="28575" cap="rnd">
              <a:solidFill>
                <a:schemeClr val="accent1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Chao1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Chao1!$C$26:$L$26</c:f>
              <c:numCache>
                <c:formatCode>General</c:formatCode>
                <c:ptCount val="10"/>
                <c:pt idx="0">
                  <c:v>1</c:v>
                </c:pt>
                <c:pt idx="1">
                  <c:v>424.40199999999987</c:v>
                </c:pt>
                <c:pt idx="2">
                  <c:v>438.40699999999993</c:v>
                </c:pt>
                <c:pt idx="3">
                  <c:v>447.339</c:v>
                </c:pt>
                <c:pt idx="4">
                  <c:v>447.54500000000002</c:v>
                </c:pt>
                <c:pt idx="5">
                  <c:v>447.73200000000003</c:v>
                </c:pt>
                <c:pt idx="6">
                  <c:v>447.625</c:v>
                </c:pt>
                <c:pt idx="7">
                  <c:v>447.70699999999988</c:v>
                </c:pt>
                <c:pt idx="8">
                  <c:v>447.154</c:v>
                </c:pt>
                <c:pt idx="9">
                  <c:v>447.2389999999999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8-C6E0-454B-9B66-54C094B8C331}"/>
            </c:ext>
          </c:extLst>
        </c:ser>
        <c:ser>
          <c:idx val="25"/>
          <c:order val="25"/>
          <c:tx>
            <c:strRef>
              <c:f>Chao1!$B$27</c:f>
              <c:strCache>
                <c:ptCount val="1"/>
                <c:pt idx="0">
                  <c:v>26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Chao1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Chao1!$C$27:$L$27</c:f>
              <c:numCache>
                <c:formatCode>General</c:formatCode>
                <c:ptCount val="10"/>
                <c:pt idx="0">
                  <c:v>1</c:v>
                </c:pt>
                <c:pt idx="1">
                  <c:v>448.74200000000002</c:v>
                </c:pt>
                <c:pt idx="2">
                  <c:v>471.41300000000001</c:v>
                </c:pt>
                <c:pt idx="3">
                  <c:v>473.654</c:v>
                </c:pt>
                <c:pt idx="4">
                  <c:v>476.06</c:v>
                </c:pt>
                <c:pt idx="5">
                  <c:v>478.88900000000001</c:v>
                </c:pt>
                <c:pt idx="6">
                  <c:v>477.44600000000003</c:v>
                </c:pt>
                <c:pt idx="7">
                  <c:v>475.97500000000002</c:v>
                </c:pt>
                <c:pt idx="8">
                  <c:v>476.14699999999999</c:v>
                </c:pt>
                <c:pt idx="9">
                  <c:v>476.0919999999999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9-C6E0-454B-9B66-54C094B8C331}"/>
            </c:ext>
          </c:extLst>
        </c:ser>
        <c:ser>
          <c:idx val="26"/>
          <c:order val="26"/>
          <c:tx>
            <c:strRef>
              <c:f>Chao1!$B$28</c:f>
              <c:strCache>
                <c:ptCount val="1"/>
                <c:pt idx="0">
                  <c:v>27</c:v>
                </c:pt>
              </c:strCache>
            </c:strRef>
          </c:tx>
          <c:spPr>
            <a:ln w="28575" cap="rnd">
              <a:solidFill>
                <a:schemeClr val="accent3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Chao1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Chao1!$C$28:$L$28</c:f>
              <c:numCache>
                <c:formatCode>General</c:formatCode>
                <c:ptCount val="10"/>
                <c:pt idx="0">
                  <c:v>1</c:v>
                </c:pt>
                <c:pt idx="1">
                  <c:v>371.577</c:v>
                </c:pt>
                <c:pt idx="2">
                  <c:v>409.37200000000001</c:v>
                </c:pt>
                <c:pt idx="3">
                  <c:v>413.77600000000001</c:v>
                </c:pt>
                <c:pt idx="4">
                  <c:v>411.67899999999992</c:v>
                </c:pt>
                <c:pt idx="5">
                  <c:v>414.28300000000002</c:v>
                </c:pt>
                <c:pt idx="6">
                  <c:v>417.01600000000002</c:v>
                </c:pt>
                <c:pt idx="7">
                  <c:v>416.10899999999992</c:v>
                </c:pt>
                <c:pt idx="8">
                  <c:v>415.834</c:v>
                </c:pt>
                <c:pt idx="9">
                  <c:v>416.3109999999999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A-C6E0-454B-9B66-54C094B8C331}"/>
            </c:ext>
          </c:extLst>
        </c:ser>
        <c:ser>
          <c:idx val="27"/>
          <c:order val="27"/>
          <c:tx>
            <c:strRef>
              <c:f>Chao1!$B$29</c:f>
              <c:strCache>
                <c:ptCount val="1"/>
                <c:pt idx="0">
                  <c:v>28</c:v>
                </c:pt>
              </c:strCache>
            </c:strRef>
          </c:tx>
          <c:spPr>
            <a:ln w="28575" cap="rnd">
              <a:solidFill>
                <a:schemeClr val="accent4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Chao1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Chao1!$C$29:$L$29</c:f>
              <c:numCache>
                <c:formatCode>General</c:formatCode>
                <c:ptCount val="10"/>
                <c:pt idx="0">
                  <c:v>1</c:v>
                </c:pt>
                <c:pt idx="1">
                  <c:v>387.154</c:v>
                </c:pt>
                <c:pt idx="2">
                  <c:v>405.666</c:v>
                </c:pt>
                <c:pt idx="3">
                  <c:v>408.09399999999988</c:v>
                </c:pt>
                <c:pt idx="4">
                  <c:v>412.82100000000003</c:v>
                </c:pt>
                <c:pt idx="5">
                  <c:v>415.99400000000003</c:v>
                </c:pt>
                <c:pt idx="6">
                  <c:v>417.00099999999992</c:v>
                </c:pt>
                <c:pt idx="7">
                  <c:v>416.28399999999988</c:v>
                </c:pt>
                <c:pt idx="8">
                  <c:v>417.10300000000001</c:v>
                </c:pt>
                <c:pt idx="9">
                  <c:v>415.9649999999999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B-C6E0-454B-9B66-54C094B8C331}"/>
            </c:ext>
          </c:extLst>
        </c:ser>
        <c:ser>
          <c:idx val="28"/>
          <c:order val="28"/>
          <c:tx>
            <c:strRef>
              <c:f>Chao1!$B$30</c:f>
              <c:strCache>
                <c:ptCount val="1"/>
                <c:pt idx="0">
                  <c:v>29</c:v>
                </c:pt>
              </c:strCache>
            </c:strRef>
          </c:tx>
          <c:spPr>
            <a:ln w="28575" cap="rnd">
              <a:solidFill>
                <a:schemeClr val="accent5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Chao1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Chao1!$C$30:$L$30</c:f>
              <c:numCache>
                <c:formatCode>General</c:formatCode>
                <c:ptCount val="10"/>
                <c:pt idx="0">
                  <c:v>1</c:v>
                </c:pt>
                <c:pt idx="1">
                  <c:v>458.697</c:v>
                </c:pt>
                <c:pt idx="2">
                  <c:v>480.15</c:v>
                </c:pt>
                <c:pt idx="3">
                  <c:v>491.03800000000001</c:v>
                </c:pt>
                <c:pt idx="4">
                  <c:v>495.26299999999992</c:v>
                </c:pt>
                <c:pt idx="5">
                  <c:v>489.94600000000003</c:v>
                </c:pt>
                <c:pt idx="6">
                  <c:v>493.767</c:v>
                </c:pt>
                <c:pt idx="7">
                  <c:v>493.185</c:v>
                </c:pt>
                <c:pt idx="8">
                  <c:v>493.82299999999992</c:v>
                </c:pt>
                <c:pt idx="9">
                  <c:v>492.550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C-C6E0-454B-9B66-54C094B8C331}"/>
            </c:ext>
          </c:extLst>
        </c:ser>
        <c:ser>
          <c:idx val="29"/>
          <c:order val="29"/>
          <c:tx>
            <c:strRef>
              <c:f>Chao1!$B$31</c:f>
              <c:strCache>
                <c:ptCount val="1"/>
                <c:pt idx="0">
                  <c:v>30</c:v>
                </c:pt>
              </c:strCache>
            </c:strRef>
          </c:tx>
          <c:spPr>
            <a:ln w="28575" cap="rnd">
              <a:solidFill>
                <a:schemeClr val="accent6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Chao1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Chao1!$C$31:$L$31</c:f>
              <c:numCache>
                <c:formatCode>General</c:formatCode>
                <c:ptCount val="10"/>
                <c:pt idx="0">
                  <c:v>1</c:v>
                </c:pt>
                <c:pt idx="1">
                  <c:v>345.92999999999989</c:v>
                </c:pt>
                <c:pt idx="2">
                  <c:v>358.24599999999992</c:v>
                </c:pt>
                <c:pt idx="3">
                  <c:v>356.822</c:v>
                </c:pt>
                <c:pt idx="4">
                  <c:v>357.351</c:v>
                </c:pt>
                <c:pt idx="5">
                  <c:v>357.146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D-C6E0-454B-9B66-54C094B8C331}"/>
            </c:ext>
          </c:extLst>
        </c:ser>
        <c:ser>
          <c:idx val="30"/>
          <c:order val="30"/>
          <c:tx>
            <c:strRef>
              <c:f>Chao1!$B$32</c:f>
              <c:strCache>
                <c:ptCount val="1"/>
                <c:pt idx="0">
                  <c:v>31</c:v>
                </c:pt>
              </c:strCache>
            </c:strRef>
          </c:tx>
          <c:spPr>
            <a:ln w="28575" cap="rnd">
              <a:solidFill>
                <a:schemeClr val="accent1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Chao1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Chao1!$C$32:$L$32</c:f>
              <c:numCache>
                <c:formatCode>General</c:formatCode>
                <c:ptCount val="10"/>
                <c:pt idx="0">
                  <c:v>1</c:v>
                </c:pt>
                <c:pt idx="1">
                  <c:v>376.452</c:v>
                </c:pt>
                <c:pt idx="2">
                  <c:v>401.07499999999999</c:v>
                </c:pt>
                <c:pt idx="3">
                  <c:v>401.85</c:v>
                </c:pt>
                <c:pt idx="4">
                  <c:v>405.39</c:v>
                </c:pt>
                <c:pt idx="5">
                  <c:v>405.34699999999992</c:v>
                </c:pt>
                <c:pt idx="6">
                  <c:v>402.84100000000001</c:v>
                </c:pt>
                <c:pt idx="7">
                  <c:v>403.77800000000002</c:v>
                </c:pt>
                <c:pt idx="8">
                  <c:v>403.071000000000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E-C6E0-454B-9B66-54C094B8C331}"/>
            </c:ext>
          </c:extLst>
        </c:ser>
        <c:ser>
          <c:idx val="31"/>
          <c:order val="31"/>
          <c:tx>
            <c:strRef>
              <c:f>Chao1!$B$33</c:f>
              <c:strCache>
                <c:ptCount val="1"/>
                <c:pt idx="0">
                  <c:v>32</c:v>
                </c:pt>
              </c:strCache>
            </c:strRef>
          </c:tx>
          <c:spPr>
            <a:ln w="28575" cap="rnd">
              <a:solidFill>
                <a:schemeClr val="accent2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Chao1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Chao1!$C$33:$L$33</c:f>
              <c:numCache>
                <c:formatCode>General</c:formatCode>
                <c:ptCount val="10"/>
                <c:pt idx="0">
                  <c:v>1</c:v>
                </c:pt>
                <c:pt idx="1">
                  <c:v>373.27699999999987</c:v>
                </c:pt>
                <c:pt idx="2">
                  <c:v>386.05700000000002</c:v>
                </c:pt>
                <c:pt idx="3">
                  <c:v>385.25099999999992</c:v>
                </c:pt>
                <c:pt idx="4">
                  <c:v>390.83199999999988</c:v>
                </c:pt>
                <c:pt idx="5">
                  <c:v>389.12900000000002</c:v>
                </c:pt>
                <c:pt idx="6">
                  <c:v>390.93099999999993</c:v>
                </c:pt>
                <c:pt idx="7">
                  <c:v>390.41899999999993</c:v>
                </c:pt>
                <c:pt idx="8">
                  <c:v>390.08100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F-C6E0-454B-9B66-54C094B8C331}"/>
            </c:ext>
          </c:extLst>
        </c:ser>
        <c:ser>
          <c:idx val="32"/>
          <c:order val="32"/>
          <c:tx>
            <c:strRef>
              <c:f>Chao1!$B$34</c:f>
              <c:strCache>
                <c:ptCount val="1"/>
                <c:pt idx="0">
                  <c:v>33</c:v>
                </c:pt>
              </c:strCache>
            </c:strRef>
          </c:tx>
          <c:spPr>
            <a:ln w="28575" cap="rnd">
              <a:solidFill>
                <a:schemeClr val="accent3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Chao1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Chao1!$C$34:$L$34</c:f>
              <c:numCache>
                <c:formatCode>General</c:formatCode>
                <c:ptCount val="10"/>
                <c:pt idx="0">
                  <c:v>1</c:v>
                </c:pt>
                <c:pt idx="1">
                  <c:v>379.75099999999992</c:v>
                </c:pt>
                <c:pt idx="2">
                  <c:v>379.97</c:v>
                </c:pt>
                <c:pt idx="3">
                  <c:v>380.15699999999993</c:v>
                </c:pt>
                <c:pt idx="4">
                  <c:v>381.58800000000002</c:v>
                </c:pt>
                <c:pt idx="5">
                  <c:v>382.47399999999988</c:v>
                </c:pt>
                <c:pt idx="6">
                  <c:v>381.9049999999999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0-C6E0-454B-9B66-54C094B8C331}"/>
            </c:ext>
          </c:extLst>
        </c:ser>
        <c:ser>
          <c:idx val="33"/>
          <c:order val="33"/>
          <c:tx>
            <c:strRef>
              <c:f>Chao1!$B$35</c:f>
              <c:strCache>
                <c:ptCount val="1"/>
                <c:pt idx="0">
                  <c:v>34</c:v>
                </c:pt>
              </c:strCache>
            </c:strRef>
          </c:tx>
          <c:spPr>
            <a:ln w="28575" cap="rnd">
              <a:solidFill>
                <a:schemeClr val="accent4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Chao1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Chao1!$C$35:$L$35</c:f>
              <c:numCache>
                <c:formatCode>General</c:formatCode>
                <c:ptCount val="10"/>
                <c:pt idx="0">
                  <c:v>1</c:v>
                </c:pt>
                <c:pt idx="1">
                  <c:v>418.85399999999993</c:v>
                </c:pt>
                <c:pt idx="2">
                  <c:v>445.43499999999989</c:v>
                </c:pt>
                <c:pt idx="3">
                  <c:v>449.048</c:v>
                </c:pt>
                <c:pt idx="4">
                  <c:v>448.12099999999992</c:v>
                </c:pt>
                <c:pt idx="5">
                  <c:v>449.01600000000002</c:v>
                </c:pt>
                <c:pt idx="6">
                  <c:v>449.56099999999992</c:v>
                </c:pt>
                <c:pt idx="7">
                  <c:v>448.71499999999992</c:v>
                </c:pt>
                <c:pt idx="8">
                  <c:v>449.16800000000001</c:v>
                </c:pt>
                <c:pt idx="9">
                  <c:v>449.02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1-C6E0-454B-9B66-54C094B8C331}"/>
            </c:ext>
          </c:extLst>
        </c:ser>
        <c:ser>
          <c:idx val="34"/>
          <c:order val="34"/>
          <c:tx>
            <c:strRef>
              <c:f>Chao1!#REF!</c:f>
              <c:strCache>
                <c:ptCount val="1"/>
                <c:pt idx="0">
                  <c:v>#REF!</c:v>
                </c:pt>
              </c:strCache>
            </c:strRef>
          </c:tx>
          <c:spPr>
            <a:ln w="28575" cap="rnd">
              <a:solidFill>
                <a:schemeClr val="accent5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Chao1!$C$1:$L$1</c:f>
              <c:numCache>
                <c:formatCode>General</c:formatCode>
                <c:ptCount val="10"/>
                <c:pt idx="0">
                  <c:v>1</c:v>
                </c:pt>
                <c:pt idx="1">
                  <c:v>3334</c:v>
                </c:pt>
                <c:pt idx="2">
                  <c:v>6667</c:v>
                </c:pt>
                <c:pt idx="3">
                  <c:v>10000</c:v>
                </c:pt>
                <c:pt idx="4">
                  <c:v>13333</c:v>
                </c:pt>
                <c:pt idx="5">
                  <c:v>16667</c:v>
                </c:pt>
                <c:pt idx="6">
                  <c:v>20000</c:v>
                </c:pt>
                <c:pt idx="7">
                  <c:v>23333</c:v>
                </c:pt>
                <c:pt idx="8">
                  <c:v>26666</c:v>
                </c:pt>
                <c:pt idx="9">
                  <c:v>30000</c:v>
                </c:pt>
              </c:numCache>
            </c:numRef>
          </c:cat>
          <c:val>
            <c:numRef>
              <c:f>Chao1!#REF!</c:f>
              <c:numCache>
                <c:formatCode>General</c:formatCode>
                <c:ptCount val="1"/>
                <c:pt idx="0">
                  <c:v>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2-C6E0-454B-9B66-54C094B8C33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-1845022816"/>
        <c:axId val="-1845020336"/>
      </c:lineChart>
      <c:catAx>
        <c:axId val="-18450228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it-IT"/>
          </a:p>
        </c:txPr>
        <c:crossAx val="-1845020336"/>
        <c:crosses val="autoZero"/>
        <c:auto val="1"/>
        <c:lblAlgn val="ctr"/>
        <c:lblOffset val="100"/>
        <c:noMultiLvlLbl val="0"/>
      </c:catAx>
      <c:valAx>
        <c:axId val="-1845020336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extTo"/>
        <c:crossAx val="-184502281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egendEntry>
        <c:idx val="34"/>
        <c:delete val="1"/>
      </c:legendEntry>
      <c:layout>
        <c:manualLayout>
          <c:xMode val="edge"/>
          <c:yMode val="edge"/>
          <c:x val="2.7811500125087232E-2"/>
          <c:y val="0.74869200513545608"/>
          <c:w val="0.93653423882705711"/>
          <c:h val="0.1810085684345196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it-IT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it-IT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18D6053-0D07-DE45-B240-BAE3C403D9F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37BA3220-9289-C64B-AA96-6ADC99E6409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A02B6CF-FFE4-B04D-BE11-BE16FC9284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4C83F-409D-9141-AB5C-A710C66E773A}" type="datetimeFigureOut">
              <a:rPr lang="it-IT" smtClean="0"/>
              <a:t>19/11/19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3B60476C-B70F-FA45-92B2-B1F2FCC96A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278B9C5-003A-D447-8CF7-9BEEE4C074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28F77-7750-2647-9B80-87336980F63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277191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EB7E5BE-AE9F-B34C-8E38-27025093E4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BBB07CC3-7AAC-C84A-B423-B6D7A10F084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1DEAE15-B3C1-3D4D-BE66-94D370BC47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4C83F-409D-9141-AB5C-A710C66E773A}" type="datetimeFigureOut">
              <a:rPr lang="it-IT" smtClean="0"/>
              <a:t>19/11/19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6B4F291-944E-624A-A6DF-BE6A614935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A553467-4405-D646-8B1D-DE221533A9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28F77-7750-2647-9B80-87336980F63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183528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9B54EDCE-A9EE-7F45-A5FA-AE90F0E81D3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1B381677-5054-DF4C-86DC-724545D50A1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80A46C3-24E8-3444-B95C-7F0D6FD9FD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4C83F-409D-9141-AB5C-A710C66E773A}" type="datetimeFigureOut">
              <a:rPr lang="it-IT" smtClean="0"/>
              <a:t>19/11/19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0325EE5-106C-1C48-9CD8-C9EFDE141A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1414FB3-74CD-B641-BCE7-5CA267301C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28F77-7750-2647-9B80-87336980F63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902224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8503E6A-9ACF-2E40-9CAF-6BAC1344A9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6AE2A592-0861-1844-8456-06820DAF33A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31D046B-9AC8-0D4E-8C7B-0EF54BE564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4C83F-409D-9141-AB5C-A710C66E773A}" type="datetimeFigureOut">
              <a:rPr lang="it-IT" smtClean="0"/>
              <a:t>19/11/19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9818814-B582-F648-A851-CD451ED154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5E36EC8-0C95-B54F-8173-1AB0E37989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28F77-7750-2647-9B80-87336980F63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179978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D1D6A94-23B7-7246-9AC9-9AB4578D30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426CA931-F91E-5943-A5F5-BCEA88572D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67A37DC-36C2-8541-A0F6-CD2320739F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4C83F-409D-9141-AB5C-A710C66E773A}" type="datetimeFigureOut">
              <a:rPr lang="it-IT" smtClean="0"/>
              <a:t>19/11/19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361FE30A-E3DF-594A-8E8C-FBB9093D3A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F7C5E2E-8524-0649-BB64-B945701F90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28F77-7750-2647-9B80-87336980F63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377473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62B4147-DAC1-4D48-9DDA-738717EC13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E62C1DCB-917B-D24A-B403-6171BA9874F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34A4F7C4-37E4-874C-87F4-514ED00684A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FDD97DD9-05AB-4345-ABD0-76415662D4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4C83F-409D-9141-AB5C-A710C66E773A}" type="datetimeFigureOut">
              <a:rPr lang="it-IT" smtClean="0"/>
              <a:t>19/11/19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ADAFA36B-6755-9C4D-A86D-6D07EAE1B2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22AEA905-6F20-5D4C-8C53-FBDC16D325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28F77-7750-2647-9B80-87336980F63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215566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0704D44-C093-FF40-869D-027D36F14B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B4390C69-D8AD-AD42-9906-2C282CA1A0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633B1F56-6106-0847-903C-62619138F0A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5AD5CF90-1355-E244-A655-D36527E4DBE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C1A17132-A019-1240-93D8-6AB84B4ADBA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E5718A93-0F8F-5D49-B764-F61AFF72D3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4C83F-409D-9141-AB5C-A710C66E773A}" type="datetimeFigureOut">
              <a:rPr lang="it-IT" smtClean="0"/>
              <a:t>19/11/19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8865515D-A6A9-EB4C-A0C3-222517CC93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CBD34CE6-ACCB-9646-BA2F-F1C942BB0A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28F77-7750-2647-9B80-87336980F63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153476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4FB6DBD-109A-DF49-91EE-C6707F79F1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E8F03C19-1E23-5446-A403-EC5704D8E8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4C83F-409D-9141-AB5C-A710C66E773A}" type="datetimeFigureOut">
              <a:rPr lang="it-IT" smtClean="0"/>
              <a:t>19/11/19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239493B9-1720-2146-AAE8-4E198E80CA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F21C2029-E6A0-8C49-A8CA-8950E79DAD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28F77-7750-2647-9B80-87336980F63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676161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8260A498-6949-FE41-A373-27069A9503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4C83F-409D-9141-AB5C-A710C66E773A}" type="datetimeFigureOut">
              <a:rPr lang="it-IT" smtClean="0"/>
              <a:t>19/11/19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A33B3EE9-0DBA-314B-8A52-56756D1047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16757321-53E9-F946-A55E-EEE2700F09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28F77-7750-2647-9B80-87336980F63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999892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B596E13-D437-0445-8D51-141E530EC3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928F279B-4270-A840-A28A-9F0608CB3D0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212DF167-BE7F-C249-8D67-8509E2B1CB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D30660BB-9BEF-0046-AE43-08AC82081C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4C83F-409D-9141-AB5C-A710C66E773A}" type="datetimeFigureOut">
              <a:rPr lang="it-IT" smtClean="0"/>
              <a:t>19/11/19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C04ABAA1-4245-A644-BD21-5AAFDA6565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845487E1-8EC0-B742-BE53-31A47E6636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28F77-7750-2647-9B80-87336980F63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691088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D1737B3-7DBF-F04F-805C-5CAA136EDF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B91F0CE9-AE0D-A147-AA0E-AA78C2F3E50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9DE8C0E8-F83E-A24D-BC07-B0189D1EEDA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71C9B35D-516B-3E47-B3DF-8F193D1463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4C83F-409D-9141-AB5C-A710C66E773A}" type="datetimeFigureOut">
              <a:rPr lang="it-IT" smtClean="0"/>
              <a:t>19/11/19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4288815F-13F0-D34C-B85E-57EB02135F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8092B49B-8D12-F343-AD29-3525B3F9D9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28F77-7750-2647-9B80-87336980F63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80542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1D7FF4C6-C492-484A-947B-15068857BE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3E2032B0-BF3D-8A4F-ACCB-DCE28CA8A5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CFB8E36-A161-0E4F-9D88-872201952F3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B4C83F-409D-9141-AB5C-A710C66E773A}" type="datetimeFigureOut">
              <a:rPr lang="it-IT" smtClean="0"/>
              <a:t>19/11/19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7F695B7-DDBE-644C-AE46-BC075291F30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CCBD37E-6704-334D-A9D0-65BF7A4DBA2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828F77-7750-2647-9B80-87336980F63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74209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2" name="Gruppo 41">
            <a:extLst>
              <a:ext uri="{FF2B5EF4-FFF2-40B4-BE49-F238E27FC236}">
                <a16:creationId xmlns:a16="http://schemas.microsoft.com/office/drawing/2014/main" id="{F6D9AAA6-F2C5-324C-9048-DEBD04483D49}"/>
              </a:ext>
            </a:extLst>
          </p:cNvPr>
          <p:cNvGrpSpPr/>
          <p:nvPr/>
        </p:nvGrpSpPr>
        <p:grpSpPr>
          <a:xfrm>
            <a:off x="7865560" y="330137"/>
            <a:ext cx="4198163" cy="4105378"/>
            <a:chOff x="7865560" y="330137"/>
            <a:chExt cx="4198163" cy="4105378"/>
          </a:xfrm>
        </p:grpSpPr>
        <p:sp>
          <p:nvSpPr>
            <p:cNvPr id="77" name="CasellaDiTesto 76">
              <a:extLst>
                <a:ext uri="{FF2B5EF4-FFF2-40B4-BE49-F238E27FC236}">
                  <a16:creationId xmlns:a16="http://schemas.microsoft.com/office/drawing/2014/main" id="{C8771029-C494-934E-8A21-57850CFB3DA5}"/>
                </a:ext>
              </a:extLst>
            </p:cNvPr>
            <p:cNvSpPr txBox="1"/>
            <p:nvPr/>
          </p:nvSpPr>
          <p:spPr>
            <a:xfrm rot="16200000">
              <a:off x="7339975" y="1702400"/>
              <a:ext cx="128200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umber</a:t>
              </a:r>
              <a:r>
                <a:rPr lang="it-IT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of </a:t>
              </a:r>
              <a:r>
                <a:rPr lang="it-IT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OTUs</a:t>
              </a:r>
              <a:endParaRPr lang="it-IT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CasellaDiTesto 55">
              <a:extLst>
                <a:ext uri="{FF2B5EF4-FFF2-40B4-BE49-F238E27FC236}">
                  <a16:creationId xmlns:a16="http://schemas.microsoft.com/office/drawing/2014/main" id="{CEF8B7B6-DCC7-574F-8073-56C3E581ECD9}"/>
                </a:ext>
              </a:extLst>
            </p:cNvPr>
            <p:cNvSpPr txBox="1"/>
            <p:nvPr/>
          </p:nvSpPr>
          <p:spPr>
            <a:xfrm>
              <a:off x="9269103" y="2938051"/>
              <a:ext cx="1886755" cy="2583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umber</a:t>
              </a:r>
              <a:r>
                <a:rPr lang="it-IT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of </a:t>
              </a:r>
              <a:r>
                <a:rPr lang="it-IT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equence</a:t>
              </a:r>
              <a:r>
                <a:rPr lang="it-IT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it-IT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amples</a:t>
              </a:r>
              <a:endParaRPr lang="it-IT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7" name="Gruppo 26">
              <a:extLst>
                <a:ext uri="{FF2B5EF4-FFF2-40B4-BE49-F238E27FC236}">
                  <a16:creationId xmlns:a16="http://schemas.microsoft.com/office/drawing/2014/main" id="{B4239B8A-A523-204C-987E-5FB65FF3AE31}"/>
                </a:ext>
              </a:extLst>
            </p:cNvPr>
            <p:cNvGrpSpPr/>
            <p:nvPr/>
          </p:nvGrpSpPr>
          <p:grpSpPr>
            <a:xfrm>
              <a:off x="8005395" y="937182"/>
              <a:ext cx="404534" cy="1744151"/>
              <a:chOff x="3820932" y="4393703"/>
              <a:chExt cx="435621" cy="1558222"/>
            </a:xfrm>
            <a:noFill/>
          </p:grpSpPr>
          <p:sp>
            <p:nvSpPr>
              <p:cNvPr id="14" name="CasellaDiTesto 13">
                <a:extLst>
                  <a:ext uri="{FF2B5EF4-FFF2-40B4-BE49-F238E27FC236}">
                    <a16:creationId xmlns:a16="http://schemas.microsoft.com/office/drawing/2014/main" id="{D1DE6C00-D830-A84F-97F0-49C890BF3D35}"/>
                  </a:ext>
                </a:extLst>
              </p:cNvPr>
              <p:cNvSpPr txBox="1"/>
              <p:nvPr/>
            </p:nvSpPr>
            <p:spPr>
              <a:xfrm>
                <a:off x="3820932" y="5104460"/>
                <a:ext cx="435621" cy="230832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r>
                  <a:rPr lang="it-IT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400</a:t>
                </a:r>
              </a:p>
            </p:txBody>
          </p:sp>
          <p:sp>
            <p:nvSpPr>
              <p:cNvPr id="15" name="CasellaDiTesto 14">
                <a:extLst>
                  <a:ext uri="{FF2B5EF4-FFF2-40B4-BE49-F238E27FC236}">
                    <a16:creationId xmlns:a16="http://schemas.microsoft.com/office/drawing/2014/main" id="{9A993985-9D2E-D74E-A039-DE79F83E475F}"/>
                  </a:ext>
                </a:extLst>
              </p:cNvPr>
              <p:cNvSpPr txBox="1"/>
              <p:nvPr/>
            </p:nvSpPr>
            <p:spPr>
              <a:xfrm>
                <a:off x="3820932" y="5472120"/>
                <a:ext cx="435621" cy="230832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r>
                  <a:rPr lang="it-IT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200</a:t>
                </a:r>
              </a:p>
            </p:txBody>
          </p:sp>
          <p:sp>
            <p:nvSpPr>
              <p:cNvPr id="17" name="CasellaDiTesto 16">
                <a:extLst>
                  <a:ext uri="{FF2B5EF4-FFF2-40B4-BE49-F238E27FC236}">
                    <a16:creationId xmlns:a16="http://schemas.microsoft.com/office/drawing/2014/main" id="{6CB46E17-5836-6B49-853F-326E20204392}"/>
                  </a:ext>
                </a:extLst>
              </p:cNvPr>
              <p:cNvSpPr txBox="1"/>
              <p:nvPr/>
            </p:nvSpPr>
            <p:spPr>
              <a:xfrm>
                <a:off x="3820932" y="4756094"/>
                <a:ext cx="435621" cy="230832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r>
                  <a:rPr lang="it-IT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600</a:t>
                </a:r>
              </a:p>
            </p:txBody>
          </p:sp>
          <p:sp>
            <p:nvSpPr>
              <p:cNvPr id="18" name="CasellaDiTesto 17">
                <a:extLst>
                  <a:ext uri="{FF2B5EF4-FFF2-40B4-BE49-F238E27FC236}">
                    <a16:creationId xmlns:a16="http://schemas.microsoft.com/office/drawing/2014/main" id="{78A06500-CCDA-2740-A31C-71B01B177FB5}"/>
                  </a:ext>
                </a:extLst>
              </p:cNvPr>
              <p:cNvSpPr txBox="1"/>
              <p:nvPr/>
            </p:nvSpPr>
            <p:spPr>
              <a:xfrm>
                <a:off x="3820932" y="4393703"/>
                <a:ext cx="435621" cy="230832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r>
                  <a:rPr lang="it-IT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800</a:t>
                </a:r>
              </a:p>
            </p:txBody>
          </p:sp>
          <p:cxnSp>
            <p:nvCxnSpPr>
              <p:cNvPr id="20" name="Connettore 1 19">
                <a:extLst>
                  <a:ext uri="{FF2B5EF4-FFF2-40B4-BE49-F238E27FC236}">
                    <a16:creationId xmlns:a16="http://schemas.microsoft.com/office/drawing/2014/main" id="{0AE874E1-4F1E-DB44-BD81-54BB04BEC47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49309" y="4521819"/>
                <a:ext cx="0" cy="1430106"/>
              </a:xfrm>
              <a:prstGeom prst="line">
                <a:avLst/>
              </a:prstGeom>
              <a:grp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Connettore 1 20">
                <a:extLst>
                  <a:ext uri="{FF2B5EF4-FFF2-40B4-BE49-F238E27FC236}">
                    <a16:creationId xmlns:a16="http://schemas.microsoft.com/office/drawing/2014/main" id="{004735C9-017B-4541-B75A-CF531658484C}"/>
                  </a:ext>
                </a:extLst>
              </p:cNvPr>
              <p:cNvCxnSpPr/>
              <p:nvPr/>
            </p:nvCxnSpPr>
            <p:spPr>
              <a:xfrm>
                <a:off x="4164603" y="4520521"/>
                <a:ext cx="89453" cy="0"/>
              </a:xfrm>
              <a:prstGeom prst="line">
                <a:avLst/>
              </a:prstGeom>
              <a:grp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Connettore 1 22">
                <a:extLst>
                  <a:ext uri="{FF2B5EF4-FFF2-40B4-BE49-F238E27FC236}">
                    <a16:creationId xmlns:a16="http://schemas.microsoft.com/office/drawing/2014/main" id="{F1826159-513F-4B43-8743-F1E38D89D5C3}"/>
                  </a:ext>
                </a:extLst>
              </p:cNvPr>
              <p:cNvCxnSpPr/>
              <p:nvPr/>
            </p:nvCxnSpPr>
            <p:spPr>
              <a:xfrm>
                <a:off x="4145720" y="4865305"/>
                <a:ext cx="89453" cy="0"/>
              </a:xfrm>
              <a:prstGeom prst="line">
                <a:avLst/>
              </a:prstGeom>
              <a:grp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Connettore 1 23">
                <a:extLst>
                  <a:ext uri="{FF2B5EF4-FFF2-40B4-BE49-F238E27FC236}">
                    <a16:creationId xmlns:a16="http://schemas.microsoft.com/office/drawing/2014/main" id="{3B7ADE1C-6D94-2D43-8C04-D1916F76A1C9}"/>
                  </a:ext>
                </a:extLst>
              </p:cNvPr>
              <p:cNvCxnSpPr/>
              <p:nvPr/>
            </p:nvCxnSpPr>
            <p:spPr>
              <a:xfrm>
                <a:off x="4145720" y="5219876"/>
                <a:ext cx="89453" cy="0"/>
              </a:xfrm>
              <a:prstGeom prst="line">
                <a:avLst/>
              </a:prstGeom>
              <a:grp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Connettore 1 24">
                <a:extLst>
                  <a:ext uri="{FF2B5EF4-FFF2-40B4-BE49-F238E27FC236}">
                    <a16:creationId xmlns:a16="http://schemas.microsoft.com/office/drawing/2014/main" id="{EFAD5C96-C562-734D-947C-35EFE831D6AB}"/>
                  </a:ext>
                </a:extLst>
              </p:cNvPr>
              <p:cNvCxnSpPr/>
              <p:nvPr/>
            </p:nvCxnSpPr>
            <p:spPr>
              <a:xfrm>
                <a:off x="4145720" y="5583983"/>
                <a:ext cx="89453" cy="0"/>
              </a:xfrm>
              <a:prstGeom prst="line">
                <a:avLst/>
              </a:prstGeom>
              <a:grp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0" name="CaixaDeTexto 21">
              <a:extLst>
                <a:ext uri="{FF2B5EF4-FFF2-40B4-BE49-F238E27FC236}">
                  <a16:creationId xmlns:a16="http://schemas.microsoft.com/office/drawing/2014/main" id="{0B7C83F8-3F5D-B841-8123-611915626CE2}"/>
                </a:ext>
              </a:extLst>
            </p:cNvPr>
            <p:cNvSpPr txBox="1"/>
            <p:nvPr/>
          </p:nvSpPr>
          <p:spPr>
            <a:xfrm>
              <a:off x="8260596" y="330137"/>
              <a:ext cx="281258" cy="37895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pt-BR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graphicFrame>
          <p:nvGraphicFramePr>
            <p:cNvPr id="81" name="Chart 3">
              <a:extLst>
                <a:ext uri="{FF2B5EF4-FFF2-40B4-BE49-F238E27FC236}">
                  <a16:creationId xmlns:a16="http://schemas.microsoft.com/office/drawing/2014/main" id="{1D97FAC7-4D25-4180-BC98-87165901BA4B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8269126" y="1116699"/>
            <a:ext cx="3794597" cy="331881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</p:grpSp>
      <p:sp>
        <p:nvSpPr>
          <p:cNvPr id="54" name="CasellaDiTesto 53">
            <a:extLst>
              <a:ext uri="{FF2B5EF4-FFF2-40B4-BE49-F238E27FC236}">
                <a16:creationId xmlns:a16="http://schemas.microsoft.com/office/drawing/2014/main" id="{B308F7A3-1FCB-5041-A116-9BEFB986B658}"/>
              </a:ext>
            </a:extLst>
          </p:cNvPr>
          <p:cNvSpPr txBox="1"/>
          <p:nvPr/>
        </p:nvSpPr>
        <p:spPr>
          <a:xfrm>
            <a:off x="591353" y="4442595"/>
            <a:ext cx="1105019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2. Alpha </a:t>
            </a:r>
            <a:r>
              <a:rPr lang="it-IT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diversity</a:t>
            </a:r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rarefaction</a:t>
            </a:r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 plots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Estimation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of the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microbial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taxa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richness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diversity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fecal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samples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based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on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Chao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1 (A) and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Shannon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(B)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indexes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. The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observed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OTUs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each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sample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also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reported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(C)</a:t>
            </a:r>
          </a:p>
        </p:txBody>
      </p:sp>
      <p:grpSp>
        <p:nvGrpSpPr>
          <p:cNvPr id="26" name="Gruppo 25">
            <a:extLst>
              <a:ext uri="{FF2B5EF4-FFF2-40B4-BE49-F238E27FC236}">
                <a16:creationId xmlns:a16="http://schemas.microsoft.com/office/drawing/2014/main" id="{94AAD7F9-1F01-C84D-9B24-8CE0D767080A}"/>
              </a:ext>
            </a:extLst>
          </p:cNvPr>
          <p:cNvGrpSpPr/>
          <p:nvPr/>
        </p:nvGrpSpPr>
        <p:grpSpPr>
          <a:xfrm>
            <a:off x="4074323" y="293516"/>
            <a:ext cx="3655296" cy="3539798"/>
            <a:chOff x="8337981" y="443781"/>
            <a:chExt cx="3655296" cy="3539798"/>
          </a:xfrm>
        </p:grpSpPr>
        <p:sp>
          <p:nvSpPr>
            <p:cNvPr id="61" name="CasellaDiTesto 60">
              <a:extLst>
                <a:ext uri="{FF2B5EF4-FFF2-40B4-BE49-F238E27FC236}">
                  <a16:creationId xmlns:a16="http://schemas.microsoft.com/office/drawing/2014/main" id="{9169B182-2A5B-A648-96AB-2969745A6E60}"/>
                </a:ext>
              </a:extLst>
            </p:cNvPr>
            <p:cNvSpPr txBox="1"/>
            <p:nvPr/>
          </p:nvSpPr>
          <p:spPr>
            <a:xfrm>
              <a:off x="9558012" y="3001915"/>
              <a:ext cx="188675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umber</a:t>
              </a:r>
              <a:r>
                <a:rPr lang="it-IT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of </a:t>
              </a:r>
              <a:r>
                <a:rPr lang="it-IT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equences</a:t>
              </a:r>
              <a:r>
                <a:rPr lang="it-IT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/sample</a:t>
              </a:r>
            </a:p>
          </p:txBody>
        </p:sp>
        <p:grpSp>
          <p:nvGrpSpPr>
            <p:cNvPr id="9" name="Gruppo 8">
              <a:extLst>
                <a:ext uri="{FF2B5EF4-FFF2-40B4-BE49-F238E27FC236}">
                  <a16:creationId xmlns:a16="http://schemas.microsoft.com/office/drawing/2014/main" id="{E288153A-AE40-4C4B-ADDE-A41F898A6DCB}"/>
                </a:ext>
              </a:extLst>
            </p:cNvPr>
            <p:cNvGrpSpPr/>
            <p:nvPr/>
          </p:nvGrpSpPr>
          <p:grpSpPr>
            <a:xfrm>
              <a:off x="8518362" y="443781"/>
              <a:ext cx="3474915" cy="3539798"/>
              <a:chOff x="8518362" y="443781"/>
              <a:chExt cx="3474915" cy="3539798"/>
            </a:xfrm>
          </p:grpSpPr>
          <p:grpSp>
            <p:nvGrpSpPr>
              <p:cNvPr id="75" name="Gruppo 74">
                <a:extLst>
                  <a:ext uri="{FF2B5EF4-FFF2-40B4-BE49-F238E27FC236}">
                    <a16:creationId xmlns:a16="http://schemas.microsoft.com/office/drawing/2014/main" id="{7B94A67D-0CA7-6B4B-A5A0-7932AB0A14AD}"/>
                  </a:ext>
                </a:extLst>
              </p:cNvPr>
              <p:cNvGrpSpPr/>
              <p:nvPr/>
            </p:nvGrpSpPr>
            <p:grpSpPr>
              <a:xfrm>
                <a:off x="8554916" y="1190851"/>
                <a:ext cx="3438361" cy="2792728"/>
                <a:chOff x="7768566" y="879700"/>
                <a:chExt cx="3740561" cy="3303799"/>
              </a:xfrm>
            </p:grpSpPr>
            <p:grpSp>
              <p:nvGrpSpPr>
                <p:cNvPr id="69" name="Gruppo 68">
                  <a:extLst>
                    <a:ext uri="{FF2B5EF4-FFF2-40B4-BE49-F238E27FC236}">
                      <a16:creationId xmlns:a16="http://schemas.microsoft.com/office/drawing/2014/main" id="{2B166E89-24B8-2A46-B046-FFDB91CACD6A}"/>
                    </a:ext>
                  </a:extLst>
                </p:cNvPr>
                <p:cNvGrpSpPr/>
                <p:nvPr/>
              </p:nvGrpSpPr>
              <p:grpSpPr>
                <a:xfrm>
                  <a:off x="7768566" y="879700"/>
                  <a:ext cx="3740561" cy="3303799"/>
                  <a:chOff x="7776968" y="1066387"/>
                  <a:chExt cx="4262397" cy="3003311"/>
                </a:xfrm>
              </p:grpSpPr>
              <p:graphicFrame>
                <p:nvGraphicFramePr>
                  <p:cNvPr id="4" name="Chart 1">
                    <a:extLst>
                      <a:ext uri="{FF2B5EF4-FFF2-40B4-BE49-F238E27FC236}">
                        <a16:creationId xmlns:a16="http://schemas.microsoft.com/office/drawing/2014/main" id="{FFC60106-41BC-B049-A20D-B1B2AF93C14D}"/>
                      </a:ext>
                    </a:extLst>
                  </p:cNvPr>
                  <p:cNvGraphicFramePr>
                    <a:graphicFrameLocks/>
                  </p:cNvGraphicFramePr>
                  <p:nvPr/>
                </p:nvGraphicFramePr>
                <p:xfrm>
                  <a:off x="7901518" y="1107840"/>
                  <a:ext cx="4137847" cy="2961858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3"/>
                  </a:graphicData>
                </a:graphic>
              </p:graphicFrame>
              <p:grpSp>
                <p:nvGrpSpPr>
                  <p:cNvPr id="68" name="Gruppo 67">
                    <a:extLst>
                      <a:ext uri="{FF2B5EF4-FFF2-40B4-BE49-F238E27FC236}">
                        <a16:creationId xmlns:a16="http://schemas.microsoft.com/office/drawing/2014/main" id="{186B50CB-5E31-E444-AA0D-2210CEE0C941}"/>
                      </a:ext>
                    </a:extLst>
                  </p:cNvPr>
                  <p:cNvGrpSpPr/>
                  <p:nvPr/>
                </p:nvGrpSpPr>
                <p:grpSpPr>
                  <a:xfrm>
                    <a:off x="7776968" y="1066387"/>
                    <a:ext cx="435621" cy="1720622"/>
                    <a:chOff x="7375487" y="1056448"/>
                    <a:chExt cx="435621" cy="1720622"/>
                  </a:xfrm>
                </p:grpSpPr>
                <p:sp>
                  <p:nvSpPr>
                    <p:cNvPr id="46" name="CasellaDiTesto 45">
                      <a:extLst>
                        <a:ext uri="{FF2B5EF4-FFF2-40B4-BE49-F238E27FC236}">
                          <a16:creationId xmlns:a16="http://schemas.microsoft.com/office/drawing/2014/main" id="{6FF66FAF-1B7B-1E40-AC6E-C39A1C54326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375487" y="1241487"/>
                      <a:ext cx="435621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it-IT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</a:p>
                  </p:txBody>
                </p:sp>
                <p:cxnSp>
                  <p:nvCxnSpPr>
                    <p:cNvPr id="47" name="Connettore 1 46">
                      <a:extLst>
                        <a:ext uri="{FF2B5EF4-FFF2-40B4-BE49-F238E27FC236}">
                          <a16:creationId xmlns:a16="http://schemas.microsoft.com/office/drawing/2014/main" id="{2DFA89E9-0F38-8A4B-A8A8-55294388F89B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7660768" y="1168197"/>
                      <a:ext cx="18065" cy="1608873"/>
                    </a:xfrm>
                    <a:prstGeom prst="line">
                      <a:avLst/>
                    </a:prstGeom>
                    <a:noFill/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8" name="Connettore 1 47">
                      <a:extLst>
                        <a:ext uri="{FF2B5EF4-FFF2-40B4-BE49-F238E27FC236}">
                          <a16:creationId xmlns:a16="http://schemas.microsoft.com/office/drawing/2014/main" id="{0BE0BD9D-C23A-6F4E-8904-0320161BF809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7574875" y="1358343"/>
                      <a:ext cx="89453" cy="0"/>
                    </a:xfrm>
                    <a:prstGeom prst="line">
                      <a:avLst/>
                    </a:prstGeom>
                    <a:noFill/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9" name="Connettore 1 48">
                      <a:extLst>
                        <a:ext uri="{FF2B5EF4-FFF2-40B4-BE49-F238E27FC236}">
                          <a16:creationId xmlns:a16="http://schemas.microsoft.com/office/drawing/2014/main" id="{67D0CFCC-B799-8F41-9FF3-09FD143DBD53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7577245" y="1713089"/>
                      <a:ext cx="89453" cy="0"/>
                    </a:xfrm>
                    <a:prstGeom prst="line">
                      <a:avLst/>
                    </a:prstGeom>
                    <a:noFill/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0" name="Connettore 1 49">
                      <a:extLst>
                        <a:ext uri="{FF2B5EF4-FFF2-40B4-BE49-F238E27FC236}">
                          <a16:creationId xmlns:a16="http://schemas.microsoft.com/office/drawing/2014/main" id="{9CD07A99-2200-5E43-8B8B-322E53E6A942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7577245" y="2067660"/>
                      <a:ext cx="89453" cy="0"/>
                    </a:xfrm>
                    <a:prstGeom prst="line">
                      <a:avLst/>
                    </a:prstGeom>
                    <a:noFill/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1" name="Connettore 1 50">
                      <a:extLst>
                        <a:ext uri="{FF2B5EF4-FFF2-40B4-BE49-F238E27FC236}">
                          <a16:creationId xmlns:a16="http://schemas.microsoft.com/office/drawing/2014/main" id="{FC483436-7665-2640-99CB-377FE37F365E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7573487" y="2431767"/>
                      <a:ext cx="89453" cy="0"/>
                    </a:xfrm>
                    <a:prstGeom prst="line">
                      <a:avLst/>
                    </a:prstGeom>
                    <a:noFill/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5" name="Connettore 1 54">
                      <a:extLst>
                        <a:ext uri="{FF2B5EF4-FFF2-40B4-BE49-F238E27FC236}">
                          <a16:creationId xmlns:a16="http://schemas.microsoft.com/office/drawing/2014/main" id="{3BCE7D55-B0AE-0544-B8D6-162C07334453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7571315" y="2256180"/>
                      <a:ext cx="89453" cy="0"/>
                    </a:xfrm>
                    <a:prstGeom prst="line">
                      <a:avLst/>
                    </a:prstGeom>
                    <a:noFill/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7" name="Connettore 1 56">
                      <a:extLst>
                        <a:ext uri="{FF2B5EF4-FFF2-40B4-BE49-F238E27FC236}">
                          <a16:creationId xmlns:a16="http://schemas.microsoft.com/office/drawing/2014/main" id="{6C0A8A44-A254-B443-82E8-2FE27074CEC7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7581254" y="1895306"/>
                      <a:ext cx="89453" cy="0"/>
                    </a:xfrm>
                    <a:prstGeom prst="line">
                      <a:avLst/>
                    </a:prstGeom>
                    <a:noFill/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8" name="Connettore 1 57">
                      <a:extLst>
                        <a:ext uri="{FF2B5EF4-FFF2-40B4-BE49-F238E27FC236}">
                          <a16:creationId xmlns:a16="http://schemas.microsoft.com/office/drawing/2014/main" id="{83B58EC0-18EE-6543-89B6-01E9253411E6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7584569" y="1530878"/>
                      <a:ext cx="89453" cy="0"/>
                    </a:xfrm>
                    <a:prstGeom prst="line">
                      <a:avLst/>
                    </a:prstGeom>
                    <a:noFill/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60" name="Connettore 1 59">
                      <a:extLst>
                        <a:ext uri="{FF2B5EF4-FFF2-40B4-BE49-F238E27FC236}">
                          <a16:creationId xmlns:a16="http://schemas.microsoft.com/office/drawing/2014/main" id="{080F98A4-AB16-9648-A607-E9F8D985F5E3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7578190" y="1172817"/>
                      <a:ext cx="89453" cy="0"/>
                    </a:xfrm>
                    <a:prstGeom prst="line">
                      <a:avLst/>
                    </a:prstGeom>
                    <a:noFill/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62" name="Connettore 1 61">
                      <a:extLst>
                        <a:ext uri="{FF2B5EF4-FFF2-40B4-BE49-F238E27FC236}">
                          <a16:creationId xmlns:a16="http://schemas.microsoft.com/office/drawing/2014/main" id="{AFE2B1C7-0E30-CB4C-89D2-B0E2B4F7A664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7581254" y="2613984"/>
                      <a:ext cx="89453" cy="0"/>
                    </a:xfrm>
                    <a:prstGeom prst="line">
                      <a:avLst/>
                    </a:prstGeom>
                    <a:noFill/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63" name="CasellaDiTesto 62">
                      <a:extLst>
                        <a:ext uri="{FF2B5EF4-FFF2-40B4-BE49-F238E27FC236}">
                          <a16:creationId xmlns:a16="http://schemas.microsoft.com/office/drawing/2014/main" id="{08A11307-FB1B-DA42-9C6C-6ADC61857EB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375487" y="2501391"/>
                      <a:ext cx="435621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it-IT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p:txBody>
                </p:sp>
                <p:sp>
                  <p:nvSpPr>
                    <p:cNvPr id="64" name="CasellaDiTesto 63">
                      <a:extLst>
                        <a:ext uri="{FF2B5EF4-FFF2-40B4-BE49-F238E27FC236}">
                          <a16:creationId xmlns:a16="http://schemas.microsoft.com/office/drawing/2014/main" id="{BC1C6BD5-3F67-6C45-9695-09DAD733E75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375487" y="2145165"/>
                      <a:ext cx="435621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it-IT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p:txBody>
                </p:sp>
                <p:sp>
                  <p:nvSpPr>
                    <p:cNvPr id="65" name="CasellaDiTesto 64">
                      <a:extLst>
                        <a:ext uri="{FF2B5EF4-FFF2-40B4-BE49-F238E27FC236}">
                          <a16:creationId xmlns:a16="http://schemas.microsoft.com/office/drawing/2014/main" id="{7CFE7B1F-49D8-2E4A-88B6-3742A5BB947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375487" y="1786039"/>
                      <a:ext cx="435621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it-IT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</p:txBody>
                </p:sp>
                <p:sp>
                  <p:nvSpPr>
                    <p:cNvPr id="66" name="CasellaDiTesto 65">
                      <a:extLst>
                        <a:ext uri="{FF2B5EF4-FFF2-40B4-BE49-F238E27FC236}">
                          <a16:creationId xmlns:a16="http://schemas.microsoft.com/office/drawing/2014/main" id="{6C24A026-93B6-8548-8245-08D81256163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375487" y="1421349"/>
                      <a:ext cx="435621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it-IT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</a:p>
                  </p:txBody>
                </p:sp>
                <p:sp>
                  <p:nvSpPr>
                    <p:cNvPr id="67" name="CasellaDiTesto 66">
                      <a:extLst>
                        <a:ext uri="{FF2B5EF4-FFF2-40B4-BE49-F238E27FC236}">
                          <a16:creationId xmlns:a16="http://schemas.microsoft.com/office/drawing/2014/main" id="{967225FA-6C22-674F-ABB1-8CA307387F4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375487" y="1056448"/>
                      <a:ext cx="435621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it-IT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</a:p>
                  </p:txBody>
                </p:sp>
              </p:grpSp>
            </p:grpSp>
            <p:sp>
              <p:nvSpPr>
                <p:cNvPr id="70" name="CasellaDiTesto 69">
                  <a:extLst>
                    <a:ext uri="{FF2B5EF4-FFF2-40B4-BE49-F238E27FC236}">
                      <a16:creationId xmlns:a16="http://schemas.microsoft.com/office/drawing/2014/main" id="{5CA761CD-CA11-0E43-9768-E8719A2A73D9}"/>
                    </a:ext>
                  </a:extLst>
                </p:cNvPr>
                <p:cNvSpPr txBox="1"/>
                <p:nvPr/>
              </p:nvSpPr>
              <p:spPr>
                <a:xfrm>
                  <a:off x="7768567" y="1865122"/>
                  <a:ext cx="435621" cy="25392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</a:p>
              </p:txBody>
            </p:sp>
            <p:sp>
              <p:nvSpPr>
                <p:cNvPr id="71" name="CasellaDiTesto 70">
                  <a:extLst>
                    <a:ext uri="{FF2B5EF4-FFF2-40B4-BE49-F238E27FC236}">
                      <a16:creationId xmlns:a16="http://schemas.microsoft.com/office/drawing/2014/main" id="{28ECAC24-F3DA-B144-821E-21AB3ABE7DBA}"/>
                    </a:ext>
                  </a:extLst>
                </p:cNvPr>
                <p:cNvSpPr txBox="1"/>
                <p:nvPr/>
              </p:nvSpPr>
              <p:spPr>
                <a:xfrm>
                  <a:off x="7768567" y="1481902"/>
                  <a:ext cx="435621" cy="25392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</a:t>
                  </a:r>
                </a:p>
              </p:txBody>
            </p:sp>
            <p:sp>
              <p:nvSpPr>
                <p:cNvPr id="73" name="CasellaDiTesto 72">
                  <a:extLst>
                    <a:ext uri="{FF2B5EF4-FFF2-40B4-BE49-F238E27FC236}">
                      <a16:creationId xmlns:a16="http://schemas.microsoft.com/office/drawing/2014/main" id="{63558D06-3889-9C44-8B82-AAA0DE8A7D74}"/>
                    </a:ext>
                  </a:extLst>
                </p:cNvPr>
                <p:cNvSpPr txBox="1"/>
                <p:nvPr/>
              </p:nvSpPr>
              <p:spPr>
                <a:xfrm>
                  <a:off x="7768567" y="2269568"/>
                  <a:ext cx="435621" cy="25392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</a:p>
              </p:txBody>
            </p:sp>
          </p:grpSp>
          <p:sp>
            <p:nvSpPr>
              <p:cNvPr id="79" name="CaixaDeTexto 21">
                <a:extLst>
                  <a:ext uri="{FF2B5EF4-FFF2-40B4-BE49-F238E27FC236}">
                    <a16:creationId xmlns:a16="http://schemas.microsoft.com/office/drawing/2014/main" id="{24ABBC67-4E4D-754A-85C6-68A2CD0B9C01}"/>
                  </a:ext>
                </a:extLst>
              </p:cNvPr>
              <p:cNvSpPr txBox="1"/>
              <p:nvPr/>
            </p:nvSpPr>
            <p:spPr>
              <a:xfrm>
                <a:off x="8518362" y="443781"/>
                <a:ext cx="281258" cy="338554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pt-BR" sz="16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pt-BR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6" name="CasellaDiTesto 75">
              <a:extLst>
                <a:ext uri="{FF2B5EF4-FFF2-40B4-BE49-F238E27FC236}">
                  <a16:creationId xmlns:a16="http://schemas.microsoft.com/office/drawing/2014/main" id="{02F19DC9-1F3F-5E4D-9664-4BD2693F2F0F}"/>
                </a:ext>
              </a:extLst>
            </p:cNvPr>
            <p:cNvSpPr txBox="1"/>
            <p:nvPr/>
          </p:nvSpPr>
          <p:spPr>
            <a:xfrm rot="16200000">
              <a:off x="7510019" y="1832375"/>
              <a:ext cx="188675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Rarefaction</a:t>
              </a:r>
              <a:r>
                <a:rPr lang="it-IT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it-IT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index</a:t>
              </a:r>
              <a:r>
                <a:rPr lang="it-IT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: </a:t>
              </a:r>
              <a:r>
                <a:rPr lang="it-IT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hannon</a:t>
              </a:r>
              <a:endParaRPr lang="it-IT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2" name="Gruppo 21">
            <a:extLst>
              <a:ext uri="{FF2B5EF4-FFF2-40B4-BE49-F238E27FC236}">
                <a16:creationId xmlns:a16="http://schemas.microsoft.com/office/drawing/2014/main" id="{323F2E67-7127-7644-B1C3-F875995CE459}"/>
              </a:ext>
            </a:extLst>
          </p:cNvPr>
          <p:cNvGrpSpPr/>
          <p:nvPr/>
        </p:nvGrpSpPr>
        <p:grpSpPr>
          <a:xfrm>
            <a:off x="279032" y="336661"/>
            <a:ext cx="3648017" cy="3724083"/>
            <a:chOff x="4384525" y="454932"/>
            <a:chExt cx="3648017" cy="3724083"/>
          </a:xfrm>
        </p:grpSpPr>
        <p:sp>
          <p:nvSpPr>
            <p:cNvPr id="59" name="CasellaDiTesto 58">
              <a:extLst>
                <a:ext uri="{FF2B5EF4-FFF2-40B4-BE49-F238E27FC236}">
                  <a16:creationId xmlns:a16="http://schemas.microsoft.com/office/drawing/2014/main" id="{BA825FF0-F47C-6544-BF1C-3BAE88D1CFA1}"/>
                </a:ext>
              </a:extLst>
            </p:cNvPr>
            <p:cNvSpPr txBox="1"/>
            <p:nvPr/>
          </p:nvSpPr>
          <p:spPr>
            <a:xfrm>
              <a:off x="5690002" y="3001915"/>
              <a:ext cx="188675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umber</a:t>
              </a:r>
              <a:r>
                <a:rPr lang="it-IT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of </a:t>
              </a:r>
              <a:r>
                <a:rPr lang="it-IT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equences</a:t>
              </a:r>
              <a:r>
                <a:rPr lang="it-IT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/sample</a:t>
              </a:r>
            </a:p>
          </p:txBody>
        </p:sp>
        <p:grpSp>
          <p:nvGrpSpPr>
            <p:cNvPr id="8" name="Gruppo 7">
              <a:extLst>
                <a:ext uri="{FF2B5EF4-FFF2-40B4-BE49-F238E27FC236}">
                  <a16:creationId xmlns:a16="http://schemas.microsoft.com/office/drawing/2014/main" id="{4B98DF64-A545-AF41-AF84-39E0EDB8F613}"/>
                </a:ext>
              </a:extLst>
            </p:cNvPr>
            <p:cNvGrpSpPr/>
            <p:nvPr/>
          </p:nvGrpSpPr>
          <p:grpSpPr>
            <a:xfrm>
              <a:off x="4589616" y="454932"/>
              <a:ext cx="3442926" cy="3724083"/>
              <a:chOff x="4567760" y="454932"/>
              <a:chExt cx="3442926" cy="3724083"/>
            </a:xfrm>
          </p:grpSpPr>
          <p:grpSp>
            <p:nvGrpSpPr>
              <p:cNvPr id="52" name="Gruppo 51">
                <a:extLst>
                  <a:ext uri="{FF2B5EF4-FFF2-40B4-BE49-F238E27FC236}">
                    <a16:creationId xmlns:a16="http://schemas.microsoft.com/office/drawing/2014/main" id="{8E1B6F78-92A9-9040-8557-3452A57F4AB6}"/>
                  </a:ext>
                </a:extLst>
              </p:cNvPr>
              <p:cNvGrpSpPr/>
              <p:nvPr/>
            </p:nvGrpSpPr>
            <p:grpSpPr>
              <a:xfrm>
                <a:off x="4567760" y="1237035"/>
                <a:ext cx="3442926" cy="2941980"/>
                <a:chOff x="3873522" y="1172817"/>
                <a:chExt cx="3726006" cy="2941980"/>
              </a:xfrm>
            </p:grpSpPr>
            <p:graphicFrame>
              <p:nvGraphicFramePr>
                <p:cNvPr id="5" name="Chart 2">
                  <a:extLst>
                    <a:ext uri="{FF2B5EF4-FFF2-40B4-BE49-F238E27FC236}">
                      <a16:creationId xmlns:a16="http://schemas.microsoft.com/office/drawing/2014/main" id="{77BC1EA1-5117-F54E-9F9E-4C66D65BD091}"/>
                    </a:ext>
                  </a:extLst>
                </p:cNvPr>
                <p:cNvGraphicFramePr>
                  <a:graphicFrameLocks/>
                </p:cNvGraphicFramePr>
                <p:nvPr/>
              </p:nvGraphicFramePr>
              <p:xfrm>
                <a:off x="3900914" y="1224304"/>
                <a:ext cx="3698614" cy="2890493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4"/>
                </a:graphicData>
              </a:graphic>
            </p:graphicFrame>
            <p:grpSp>
              <p:nvGrpSpPr>
                <p:cNvPr id="30" name="Gruppo 29">
                  <a:extLst>
                    <a:ext uri="{FF2B5EF4-FFF2-40B4-BE49-F238E27FC236}">
                      <a16:creationId xmlns:a16="http://schemas.microsoft.com/office/drawing/2014/main" id="{67FAF866-176A-DE44-A0EC-16EC46E62171}"/>
                    </a:ext>
                  </a:extLst>
                </p:cNvPr>
                <p:cNvGrpSpPr/>
                <p:nvPr/>
              </p:nvGrpSpPr>
              <p:grpSpPr>
                <a:xfrm>
                  <a:off x="3873522" y="1172817"/>
                  <a:ext cx="435621" cy="1545522"/>
                  <a:chOff x="3794186" y="4393703"/>
                  <a:chExt cx="435621" cy="1545522"/>
                </a:xfrm>
                <a:noFill/>
              </p:grpSpPr>
              <p:sp>
                <p:nvSpPr>
                  <p:cNvPr id="31" name="CasellaDiTesto 30">
                    <a:extLst>
                      <a:ext uri="{FF2B5EF4-FFF2-40B4-BE49-F238E27FC236}">
                        <a16:creationId xmlns:a16="http://schemas.microsoft.com/office/drawing/2014/main" id="{1ED04746-D712-E44A-A1D9-71AC78D6F61E}"/>
                      </a:ext>
                    </a:extLst>
                  </p:cNvPr>
                  <p:cNvSpPr txBox="1"/>
                  <p:nvPr/>
                </p:nvSpPr>
                <p:spPr>
                  <a:xfrm>
                    <a:off x="3794186" y="5104460"/>
                    <a:ext cx="435621" cy="230832"/>
                  </a:xfrm>
                  <a:prstGeom prst="rect">
                    <a:avLst/>
                  </a:prstGeom>
                  <a:grp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it-IT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00</a:t>
                    </a:r>
                  </a:p>
                </p:txBody>
              </p:sp>
              <p:sp>
                <p:nvSpPr>
                  <p:cNvPr id="32" name="CasellaDiTesto 31">
                    <a:extLst>
                      <a:ext uri="{FF2B5EF4-FFF2-40B4-BE49-F238E27FC236}">
                        <a16:creationId xmlns:a16="http://schemas.microsoft.com/office/drawing/2014/main" id="{C310BBB7-8B20-6447-A0DC-C406F5E91CA4}"/>
                      </a:ext>
                    </a:extLst>
                  </p:cNvPr>
                  <p:cNvSpPr txBox="1"/>
                  <p:nvPr/>
                </p:nvSpPr>
                <p:spPr>
                  <a:xfrm>
                    <a:off x="3794186" y="5472120"/>
                    <a:ext cx="435621" cy="230832"/>
                  </a:xfrm>
                  <a:prstGeom prst="rect">
                    <a:avLst/>
                  </a:prstGeom>
                  <a:grp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it-IT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00</a:t>
                    </a:r>
                  </a:p>
                </p:txBody>
              </p:sp>
              <p:sp>
                <p:nvSpPr>
                  <p:cNvPr id="33" name="CasellaDiTesto 32">
                    <a:extLst>
                      <a:ext uri="{FF2B5EF4-FFF2-40B4-BE49-F238E27FC236}">
                        <a16:creationId xmlns:a16="http://schemas.microsoft.com/office/drawing/2014/main" id="{C0BCF51C-7166-0542-A526-599D0384C88F}"/>
                      </a:ext>
                    </a:extLst>
                  </p:cNvPr>
                  <p:cNvSpPr txBox="1"/>
                  <p:nvPr/>
                </p:nvSpPr>
                <p:spPr>
                  <a:xfrm>
                    <a:off x="3794186" y="4756094"/>
                    <a:ext cx="435621" cy="230832"/>
                  </a:xfrm>
                  <a:prstGeom prst="rect">
                    <a:avLst/>
                  </a:prstGeom>
                  <a:grp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it-IT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00</a:t>
                    </a:r>
                  </a:p>
                </p:txBody>
              </p:sp>
              <p:sp>
                <p:nvSpPr>
                  <p:cNvPr id="34" name="CasellaDiTesto 33">
                    <a:extLst>
                      <a:ext uri="{FF2B5EF4-FFF2-40B4-BE49-F238E27FC236}">
                        <a16:creationId xmlns:a16="http://schemas.microsoft.com/office/drawing/2014/main" id="{058677DF-7393-004B-8DE4-658F44FE9466}"/>
                      </a:ext>
                    </a:extLst>
                  </p:cNvPr>
                  <p:cNvSpPr txBox="1"/>
                  <p:nvPr/>
                </p:nvSpPr>
                <p:spPr>
                  <a:xfrm>
                    <a:off x="3794186" y="4393703"/>
                    <a:ext cx="435621" cy="230832"/>
                  </a:xfrm>
                  <a:prstGeom prst="rect">
                    <a:avLst/>
                  </a:prstGeom>
                  <a:grp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it-IT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800</a:t>
                    </a:r>
                  </a:p>
                </p:txBody>
              </p:sp>
              <p:cxnSp>
                <p:nvCxnSpPr>
                  <p:cNvPr id="35" name="Connettore 1 34">
                    <a:extLst>
                      <a:ext uri="{FF2B5EF4-FFF2-40B4-BE49-F238E27FC236}">
                        <a16:creationId xmlns:a16="http://schemas.microsoft.com/office/drawing/2014/main" id="{92B32EC5-A0A3-8F48-A5D3-AF9A2ADCF53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209929" y="4509119"/>
                    <a:ext cx="0" cy="1430106"/>
                  </a:xfrm>
                  <a:prstGeom prst="line">
                    <a:avLst/>
                  </a:prstGeom>
                  <a:grpFill/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6" name="Connettore 1 35">
                    <a:extLst>
                      <a:ext uri="{FF2B5EF4-FFF2-40B4-BE49-F238E27FC236}">
                        <a16:creationId xmlns:a16="http://schemas.microsoft.com/office/drawing/2014/main" id="{E9919F53-DB9C-4A44-A4A6-BC2CFA9949F4}"/>
                      </a:ext>
                    </a:extLst>
                  </p:cNvPr>
                  <p:cNvCxnSpPr/>
                  <p:nvPr/>
                </p:nvCxnSpPr>
                <p:spPr>
                  <a:xfrm>
                    <a:off x="4125849" y="4510559"/>
                    <a:ext cx="89453" cy="0"/>
                  </a:xfrm>
                  <a:prstGeom prst="line">
                    <a:avLst/>
                  </a:prstGeom>
                  <a:grpFill/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7" name="Connettore 1 36">
                    <a:extLst>
                      <a:ext uri="{FF2B5EF4-FFF2-40B4-BE49-F238E27FC236}">
                        <a16:creationId xmlns:a16="http://schemas.microsoft.com/office/drawing/2014/main" id="{4ED7E185-950C-8C4C-9E83-33A6016CEAF2}"/>
                      </a:ext>
                    </a:extLst>
                  </p:cNvPr>
                  <p:cNvCxnSpPr/>
                  <p:nvPr/>
                </p:nvCxnSpPr>
                <p:spPr>
                  <a:xfrm>
                    <a:off x="4118973" y="4865305"/>
                    <a:ext cx="89453" cy="0"/>
                  </a:xfrm>
                  <a:prstGeom prst="line">
                    <a:avLst/>
                  </a:prstGeom>
                  <a:grpFill/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8" name="Connettore 1 37">
                    <a:extLst>
                      <a:ext uri="{FF2B5EF4-FFF2-40B4-BE49-F238E27FC236}">
                        <a16:creationId xmlns:a16="http://schemas.microsoft.com/office/drawing/2014/main" id="{2294389E-8782-5B4A-A932-84E20C5A5CDA}"/>
                      </a:ext>
                    </a:extLst>
                  </p:cNvPr>
                  <p:cNvCxnSpPr/>
                  <p:nvPr/>
                </p:nvCxnSpPr>
                <p:spPr>
                  <a:xfrm>
                    <a:off x="4118973" y="5219876"/>
                    <a:ext cx="89453" cy="0"/>
                  </a:xfrm>
                  <a:prstGeom prst="line">
                    <a:avLst/>
                  </a:prstGeom>
                  <a:grpFill/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9" name="Connettore 1 38">
                    <a:extLst>
                      <a:ext uri="{FF2B5EF4-FFF2-40B4-BE49-F238E27FC236}">
                        <a16:creationId xmlns:a16="http://schemas.microsoft.com/office/drawing/2014/main" id="{6084E18F-364A-6247-96C6-FFC25307006A}"/>
                      </a:ext>
                    </a:extLst>
                  </p:cNvPr>
                  <p:cNvCxnSpPr/>
                  <p:nvPr/>
                </p:nvCxnSpPr>
                <p:spPr>
                  <a:xfrm>
                    <a:off x="4118973" y="5583983"/>
                    <a:ext cx="89453" cy="0"/>
                  </a:xfrm>
                  <a:prstGeom prst="line">
                    <a:avLst/>
                  </a:prstGeom>
                  <a:grpFill/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78" name="CaixaDeTexto 21">
                <a:extLst>
                  <a:ext uri="{FF2B5EF4-FFF2-40B4-BE49-F238E27FC236}">
                    <a16:creationId xmlns:a16="http://schemas.microsoft.com/office/drawing/2014/main" id="{4D408CD4-4E03-4646-9DA3-2F6937DD32EF}"/>
                  </a:ext>
                </a:extLst>
              </p:cNvPr>
              <p:cNvSpPr txBox="1"/>
              <p:nvPr/>
            </p:nvSpPr>
            <p:spPr>
              <a:xfrm>
                <a:off x="4692324" y="454932"/>
                <a:ext cx="281258" cy="338554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pt-BR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</p:grpSp>
        <p:sp>
          <p:nvSpPr>
            <p:cNvPr id="74" name="CasellaDiTesto 73">
              <a:extLst>
                <a:ext uri="{FF2B5EF4-FFF2-40B4-BE49-F238E27FC236}">
                  <a16:creationId xmlns:a16="http://schemas.microsoft.com/office/drawing/2014/main" id="{6AD5B75A-E764-C942-8BCA-5A937DC2F587}"/>
                </a:ext>
              </a:extLst>
            </p:cNvPr>
            <p:cNvSpPr txBox="1"/>
            <p:nvPr/>
          </p:nvSpPr>
          <p:spPr>
            <a:xfrm rot="16200000">
              <a:off x="3556563" y="1753868"/>
              <a:ext cx="188675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Rarefaction</a:t>
              </a:r>
              <a:r>
                <a:rPr lang="it-IT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it-IT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index</a:t>
              </a:r>
              <a:r>
                <a:rPr lang="it-IT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: </a:t>
              </a:r>
              <a:r>
                <a:rPr lang="it-IT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hao</a:t>
              </a:r>
              <a:r>
                <a:rPr lang="it-IT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1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23942258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5</Words>
  <Application>Microsoft Macintosh PowerPoint</Application>
  <PresentationFormat>Widescreen</PresentationFormat>
  <Paragraphs>27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RACHELE ISTICATO</dc:creator>
  <cp:lastModifiedBy>RACHELE ISTICATO</cp:lastModifiedBy>
  <cp:revision>1</cp:revision>
  <dcterms:created xsi:type="dcterms:W3CDTF">2019-11-19T12:27:41Z</dcterms:created>
  <dcterms:modified xsi:type="dcterms:W3CDTF">2019-11-19T12:27:56Z</dcterms:modified>
</cp:coreProperties>
</file>